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6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9" r:id="rId35"/>
    <p:sldId id="288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33" autoAdjust="0"/>
    <p:restoredTop sz="94660"/>
  </p:normalViewPr>
  <p:slideViewPr>
    <p:cSldViewPr snapToGrid="0" showGuides="1">
      <p:cViewPr varScale="1">
        <p:scale>
          <a:sx n="54" d="100"/>
          <a:sy n="54" d="100"/>
        </p:scale>
        <p:origin x="102" y="11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presProps" Target="presProps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tableStyles" Target="tableStyle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microsoft.com/office/2016/11/relationships/changesInfo" Target="changesInfos/changesInfo1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iam Schreiber" userId="5a452ff8-f189-44a9-9767-da59f69398bf" providerId="ADAL" clId="{C8A5F010-3663-4476-BC58-B0A281E6D435}"/>
    <pc:docChg chg="undo custSel modSld">
      <pc:chgData name="Miriam Schreiber" userId="5a452ff8-f189-44a9-9767-da59f69398bf" providerId="ADAL" clId="{C8A5F010-3663-4476-BC58-B0A281E6D435}" dt="2022-07-27T10:33:07.396" v="3963" actId="1076"/>
      <pc:docMkLst>
        <pc:docMk/>
      </pc:docMkLst>
      <pc:sldChg chg="addSp delSp modSp mod">
        <pc:chgData name="Miriam Schreiber" userId="5a452ff8-f189-44a9-9767-da59f69398bf" providerId="ADAL" clId="{C8A5F010-3663-4476-BC58-B0A281E6D435}" dt="2022-07-14T09:35:29.880" v="211" actId="1038"/>
        <pc:sldMkLst>
          <pc:docMk/>
          <pc:sldMk cId="3354761709" sldId="256"/>
        </pc:sldMkLst>
        <pc:spChg chg="mod">
          <ac:chgData name="Miriam Schreiber" userId="5a452ff8-f189-44a9-9767-da59f69398bf" providerId="ADAL" clId="{C8A5F010-3663-4476-BC58-B0A281E6D435}" dt="2022-07-14T09:35:29.880" v="211" actId="1038"/>
          <ac:spMkLst>
            <pc:docMk/>
            <pc:sldMk cId="3354761709" sldId="256"/>
            <ac:spMk id="4" creationId="{4D194A9A-FA82-4B66-899B-251F60ACC329}"/>
          </ac:spMkLst>
        </pc:spChg>
        <pc:picChg chg="mod">
          <ac:chgData name="Miriam Schreiber" userId="5a452ff8-f189-44a9-9767-da59f69398bf" providerId="ADAL" clId="{C8A5F010-3663-4476-BC58-B0A281E6D435}" dt="2022-07-14T09:28:32.295" v="56" actId="1038"/>
          <ac:picMkLst>
            <pc:docMk/>
            <pc:sldMk cId="3354761709" sldId="256"/>
            <ac:picMk id="3" creationId="{AAD292AC-1304-C761-3809-8153F8067CDA}"/>
          </ac:picMkLst>
        </pc:picChg>
        <pc:picChg chg="add del mod">
          <ac:chgData name="Miriam Schreiber" userId="5a452ff8-f189-44a9-9767-da59f69398bf" providerId="ADAL" clId="{C8A5F010-3663-4476-BC58-B0A281E6D435}" dt="2022-07-14T09:29:42.202" v="86" actId="478"/>
          <ac:picMkLst>
            <pc:docMk/>
            <pc:sldMk cId="3354761709" sldId="256"/>
            <ac:picMk id="5" creationId="{C7E58614-23CE-58BD-BA1A-BD7E7ED2E388}"/>
          </ac:picMkLst>
        </pc:picChg>
        <pc:picChg chg="add mod">
          <ac:chgData name="Miriam Schreiber" userId="5a452ff8-f189-44a9-9767-da59f69398bf" providerId="ADAL" clId="{C8A5F010-3663-4476-BC58-B0A281E6D435}" dt="2022-07-14T09:30:07.867" v="119" actId="1038"/>
          <ac:picMkLst>
            <pc:docMk/>
            <pc:sldMk cId="3354761709" sldId="256"/>
            <ac:picMk id="7" creationId="{EEAEA06E-9BB1-3136-D8CD-F7735D0D6989}"/>
          </ac:picMkLst>
        </pc:picChg>
        <pc:picChg chg="mod">
          <ac:chgData name="Miriam Schreiber" userId="5a452ff8-f189-44a9-9767-da59f69398bf" providerId="ADAL" clId="{C8A5F010-3663-4476-BC58-B0A281E6D435}" dt="2022-07-14T09:28:38.134" v="57" actId="1076"/>
          <ac:picMkLst>
            <pc:docMk/>
            <pc:sldMk cId="3354761709" sldId="256"/>
            <ac:picMk id="11" creationId="{E63DF66E-63FE-0C0C-712D-C030E5B468B9}"/>
          </ac:picMkLst>
        </pc:picChg>
        <pc:picChg chg="mod">
          <ac:chgData name="Miriam Schreiber" userId="5a452ff8-f189-44a9-9767-da59f69398bf" providerId="ADAL" clId="{C8A5F010-3663-4476-BC58-B0A281E6D435}" dt="2022-07-14T09:28:00.633" v="37" actId="1038"/>
          <ac:picMkLst>
            <pc:docMk/>
            <pc:sldMk cId="3354761709" sldId="256"/>
            <ac:picMk id="13" creationId="{E8CE7C86-8F6F-7521-AD30-9C69ABC0269C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09:35:39.793" v="217" actId="1038"/>
        <pc:sldMkLst>
          <pc:docMk/>
          <pc:sldMk cId="601455446" sldId="257"/>
        </pc:sldMkLst>
        <pc:spChg chg="mod">
          <ac:chgData name="Miriam Schreiber" userId="5a452ff8-f189-44a9-9767-da59f69398bf" providerId="ADAL" clId="{C8A5F010-3663-4476-BC58-B0A281E6D435}" dt="2022-07-14T09:35:39.793" v="217" actId="1038"/>
          <ac:spMkLst>
            <pc:docMk/>
            <pc:sldMk cId="601455446" sldId="257"/>
            <ac:spMk id="6" creationId="{59660C4D-04F0-4B70-98AD-637D01BD6EBA}"/>
          </ac:spMkLst>
        </pc:spChg>
        <pc:spChg chg="mod">
          <ac:chgData name="Miriam Schreiber" userId="5a452ff8-f189-44a9-9767-da59f69398bf" providerId="ADAL" clId="{C8A5F010-3663-4476-BC58-B0A281E6D435}" dt="2022-07-14T09:35:20.063" v="209" actId="207"/>
          <ac:spMkLst>
            <pc:docMk/>
            <pc:sldMk cId="601455446" sldId="257"/>
            <ac:spMk id="8" creationId="{C5709267-CBE0-48CD-B55E-E4927E1AE97E}"/>
          </ac:spMkLst>
        </pc:spChg>
        <pc:picChg chg="del">
          <ac:chgData name="Miriam Schreiber" userId="5a452ff8-f189-44a9-9767-da59f69398bf" providerId="ADAL" clId="{C8A5F010-3663-4476-BC58-B0A281E6D435}" dt="2022-07-14T09:33:33.560" v="120" actId="478"/>
          <ac:picMkLst>
            <pc:docMk/>
            <pc:sldMk cId="601455446" sldId="257"/>
            <ac:picMk id="3" creationId="{F074A306-E6D4-06DF-5DAF-F40F4F862165}"/>
          </ac:picMkLst>
        </pc:picChg>
        <pc:picChg chg="add mod">
          <ac:chgData name="Miriam Schreiber" userId="5a452ff8-f189-44a9-9767-da59f69398bf" providerId="ADAL" clId="{C8A5F010-3663-4476-BC58-B0A281E6D435}" dt="2022-07-14T09:34:00.867" v="130" actId="1036"/>
          <ac:picMkLst>
            <pc:docMk/>
            <pc:sldMk cId="601455446" sldId="257"/>
            <ac:picMk id="4" creationId="{04CB3325-C02C-23E9-32F4-C2A62C3F067F}"/>
          </ac:picMkLst>
        </pc:picChg>
        <pc:picChg chg="add mod">
          <ac:chgData name="Miriam Schreiber" userId="5a452ff8-f189-44a9-9767-da59f69398bf" providerId="ADAL" clId="{C8A5F010-3663-4476-BC58-B0A281E6D435}" dt="2022-07-14T09:35:08.166" v="208" actId="1038"/>
          <ac:picMkLst>
            <pc:docMk/>
            <pc:sldMk cId="601455446" sldId="257"/>
            <ac:picMk id="7" creationId="{E6B4F072-91DD-7E3A-F378-F673B3F8F66D}"/>
          </ac:picMkLst>
        </pc:picChg>
        <pc:picChg chg="mod">
          <ac:chgData name="Miriam Schreiber" userId="5a452ff8-f189-44a9-9767-da59f69398bf" providerId="ADAL" clId="{C8A5F010-3663-4476-BC58-B0A281E6D435}" dt="2022-07-14T09:34:11.055" v="161" actId="1036"/>
          <ac:picMkLst>
            <pc:docMk/>
            <pc:sldMk cId="601455446" sldId="257"/>
            <ac:picMk id="11" creationId="{479F336C-4868-56AC-922D-33071CF2D7FF}"/>
          </ac:picMkLst>
        </pc:picChg>
        <pc:picChg chg="mod">
          <ac:chgData name="Miriam Schreiber" userId="5a452ff8-f189-44a9-9767-da59f69398bf" providerId="ADAL" clId="{C8A5F010-3663-4476-BC58-B0A281E6D435}" dt="2022-07-14T09:34:18.554" v="177" actId="1036"/>
          <ac:picMkLst>
            <pc:docMk/>
            <pc:sldMk cId="601455446" sldId="257"/>
            <ac:picMk id="13" creationId="{43E23A1C-B00F-3B08-EBC3-4D1FF7609471}"/>
          </ac:picMkLst>
        </pc:picChg>
      </pc:sldChg>
      <pc:sldChg chg="modSp mod">
        <pc:chgData name="Miriam Schreiber" userId="5a452ff8-f189-44a9-9767-da59f69398bf" providerId="ADAL" clId="{C8A5F010-3663-4476-BC58-B0A281E6D435}" dt="2022-07-14T09:36:13.078" v="250" actId="1076"/>
        <pc:sldMkLst>
          <pc:docMk/>
          <pc:sldMk cId="1596869533" sldId="258"/>
        </pc:sldMkLst>
        <pc:spChg chg="mod">
          <ac:chgData name="Miriam Schreiber" userId="5a452ff8-f189-44a9-9767-da59f69398bf" providerId="ADAL" clId="{C8A5F010-3663-4476-BC58-B0A281E6D435}" dt="2022-07-14T09:35:48.675" v="221" actId="1038"/>
          <ac:spMkLst>
            <pc:docMk/>
            <pc:sldMk cId="1596869533" sldId="258"/>
            <ac:spMk id="6" creationId="{C717718C-ADA6-41D1-B66A-614BFD5ACEE9}"/>
          </ac:spMkLst>
        </pc:spChg>
        <pc:picChg chg="mod">
          <ac:chgData name="Miriam Schreiber" userId="5a452ff8-f189-44a9-9767-da59f69398bf" providerId="ADAL" clId="{C8A5F010-3663-4476-BC58-B0A281E6D435}" dt="2022-07-14T09:36:00.280" v="237" actId="1036"/>
          <ac:picMkLst>
            <pc:docMk/>
            <pc:sldMk cId="1596869533" sldId="258"/>
            <ac:picMk id="3" creationId="{783899FB-EBCD-4B03-92B5-F03CA18FE695}"/>
          </ac:picMkLst>
        </pc:picChg>
        <pc:picChg chg="mod">
          <ac:chgData name="Miriam Schreiber" userId="5a452ff8-f189-44a9-9767-da59f69398bf" providerId="ADAL" clId="{C8A5F010-3663-4476-BC58-B0A281E6D435}" dt="2022-07-14T09:36:13.078" v="250" actId="1076"/>
          <ac:picMkLst>
            <pc:docMk/>
            <pc:sldMk cId="1596869533" sldId="258"/>
            <ac:picMk id="11" creationId="{43607D3A-971D-640A-F13E-8B0D6FF63C42}"/>
          </ac:picMkLst>
        </pc:picChg>
        <pc:picChg chg="mod">
          <ac:chgData name="Miriam Schreiber" userId="5a452ff8-f189-44a9-9767-da59f69398bf" providerId="ADAL" clId="{C8A5F010-3663-4476-BC58-B0A281E6D435}" dt="2022-07-14T09:36:09.187" v="249" actId="1036"/>
          <ac:picMkLst>
            <pc:docMk/>
            <pc:sldMk cId="1596869533" sldId="258"/>
            <ac:picMk id="13" creationId="{37BDC7D9-15DA-7E9B-94E3-B4DDEF9B8F3A}"/>
          </ac:picMkLst>
        </pc:picChg>
      </pc:sldChg>
      <pc:sldChg chg="modSp mod">
        <pc:chgData name="Miriam Schreiber" userId="5a452ff8-f189-44a9-9767-da59f69398bf" providerId="ADAL" clId="{C8A5F010-3663-4476-BC58-B0A281E6D435}" dt="2022-07-14T09:36:51.709" v="295" actId="1076"/>
        <pc:sldMkLst>
          <pc:docMk/>
          <pc:sldMk cId="2160225767" sldId="259"/>
        </pc:sldMkLst>
        <pc:spChg chg="mod">
          <ac:chgData name="Miriam Schreiber" userId="5a452ff8-f189-44a9-9767-da59f69398bf" providerId="ADAL" clId="{C8A5F010-3663-4476-BC58-B0A281E6D435}" dt="2022-07-14T09:36:30.164" v="257" actId="1035"/>
          <ac:spMkLst>
            <pc:docMk/>
            <pc:sldMk cId="2160225767" sldId="259"/>
            <ac:spMk id="6" creationId="{405C5AF2-E057-4892-AB31-3103FF06E14D}"/>
          </ac:spMkLst>
        </pc:spChg>
        <pc:picChg chg="mod">
          <ac:chgData name="Miriam Schreiber" userId="5a452ff8-f189-44a9-9767-da59f69398bf" providerId="ADAL" clId="{C8A5F010-3663-4476-BC58-B0A281E6D435}" dt="2022-07-14T09:36:44.198" v="291" actId="1035"/>
          <ac:picMkLst>
            <pc:docMk/>
            <pc:sldMk cId="2160225767" sldId="259"/>
            <ac:picMk id="3" creationId="{175C0ED7-A61E-E56F-854D-15A54DE1AA69}"/>
          </ac:picMkLst>
        </pc:picChg>
        <pc:picChg chg="mod">
          <ac:chgData name="Miriam Schreiber" userId="5a452ff8-f189-44a9-9767-da59f69398bf" providerId="ADAL" clId="{C8A5F010-3663-4476-BC58-B0A281E6D435}" dt="2022-07-14T09:36:38.675" v="271" actId="1037"/>
          <ac:picMkLst>
            <pc:docMk/>
            <pc:sldMk cId="2160225767" sldId="259"/>
            <ac:picMk id="11" creationId="{2E48AA15-FB91-578D-EB49-45D1C456BCEB}"/>
          </ac:picMkLst>
        </pc:picChg>
        <pc:picChg chg="mod">
          <ac:chgData name="Miriam Schreiber" userId="5a452ff8-f189-44a9-9767-da59f69398bf" providerId="ADAL" clId="{C8A5F010-3663-4476-BC58-B0A281E6D435}" dt="2022-07-14T09:36:51.709" v="295" actId="1076"/>
          <ac:picMkLst>
            <pc:docMk/>
            <pc:sldMk cId="2160225767" sldId="259"/>
            <ac:picMk id="13" creationId="{C937D33C-1BC2-87E1-41DB-DE01D9EB27D1}"/>
          </ac:picMkLst>
        </pc:picChg>
      </pc:sldChg>
      <pc:sldChg chg="modSp mod">
        <pc:chgData name="Miriam Schreiber" userId="5a452ff8-f189-44a9-9767-da59f69398bf" providerId="ADAL" clId="{C8A5F010-3663-4476-BC58-B0A281E6D435}" dt="2022-07-14T09:40:28.245" v="347" actId="948"/>
        <pc:sldMkLst>
          <pc:docMk/>
          <pc:sldMk cId="3673431481" sldId="260"/>
        </pc:sldMkLst>
        <pc:spChg chg="mod">
          <ac:chgData name="Miriam Schreiber" userId="5a452ff8-f189-44a9-9767-da59f69398bf" providerId="ADAL" clId="{C8A5F010-3663-4476-BC58-B0A281E6D435}" dt="2022-07-14T09:40:28.245" v="347" actId="948"/>
          <ac:spMkLst>
            <pc:docMk/>
            <pc:sldMk cId="3673431481" sldId="260"/>
            <ac:spMk id="6" creationId="{420FC7E7-BB26-418C-84D0-E1E4F725C995}"/>
          </ac:spMkLst>
        </pc:spChg>
        <pc:picChg chg="mod">
          <ac:chgData name="Miriam Schreiber" userId="5a452ff8-f189-44a9-9767-da59f69398bf" providerId="ADAL" clId="{C8A5F010-3663-4476-BC58-B0A281E6D435}" dt="2022-07-14T09:39:07.985" v="338" actId="1036"/>
          <ac:picMkLst>
            <pc:docMk/>
            <pc:sldMk cId="3673431481" sldId="260"/>
            <ac:picMk id="3" creationId="{40E2FF2D-D485-569D-B0BE-701128A5FA43}"/>
          </ac:picMkLst>
        </pc:picChg>
        <pc:picChg chg="mod">
          <ac:chgData name="Miriam Schreiber" userId="5a452ff8-f189-44a9-9767-da59f69398bf" providerId="ADAL" clId="{C8A5F010-3663-4476-BC58-B0A281E6D435}" dt="2022-07-14T09:39:15.604" v="343" actId="1036"/>
          <ac:picMkLst>
            <pc:docMk/>
            <pc:sldMk cId="3673431481" sldId="260"/>
            <ac:picMk id="11" creationId="{A20E4815-1BE5-832D-9AAD-585F8D7A8643}"/>
          </ac:picMkLst>
        </pc:picChg>
        <pc:picChg chg="mod">
          <ac:chgData name="Miriam Schreiber" userId="5a452ff8-f189-44a9-9767-da59f69398bf" providerId="ADAL" clId="{C8A5F010-3663-4476-BC58-B0A281E6D435}" dt="2022-07-14T09:39:01.924" v="319" actId="1035"/>
          <ac:picMkLst>
            <pc:docMk/>
            <pc:sldMk cId="3673431481" sldId="260"/>
            <ac:picMk id="13" creationId="{A3CC3509-C4EC-D37F-0496-F6264F3B9F64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09:51:38.839" v="477" actId="1035"/>
        <pc:sldMkLst>
          <pc:docMk/>
          <pc:sldMk cId="1550663886" sldId="261"/>
        </pc:sldMkLst>
        <pc:spChg chg="mod">
          <ac:chgData name="Miriam Schreiber" userId="5a452ff8-f189-44a9-9767-da59f69398bf" providerId="ADAL" clId="{C8A5F010-3663-4476-BC58-B0A281E6D435}" dt="2022-07-14T09:48:17.691" v="432" actId="20577"/>
          <ac:spMkLst>
            <pc:docMk/>
            <pc:sldMk cId="1550663886" sldId="261"/>
            <ac:spMk id="6" creationId="{830B0E41-FD67-4C9B-9ACB-95DDFD5DDF74}"/>
          </ac:spMkLst>
        </pc:spChg>
        <pc:spChg chg="mod">
          <ac:chgData name="Miriam Schreiber" userId="5a452ff8-f189-44a9-9767-da59f69398bf" providerId="ADAL" clId="{C8A5F010-3663-4476-BC58-B0A281E6D435}" dt="2022-07-14T09:50:14.157" v="454" actId="207"/>
          <ac:spMkLst>
            <pc:docMk/>
            <pc:sldMk cId="1550663886" sldId="261"/>
            <ac:spMk id="8" creationId="{F0F786A3-DA6E-475D-8F99-12073F0A9EE0}"/>
          </ac:spMkLst>
        </pc:spChg>
        <pc:picChg chg="del mod">
          <ac:chgData name="Miriam Schreiber" userId="5a452ff8-f189-44a9-9767-da59f69398bf" providerId="ADAL" clId="{C8A5F010-3663-4476-BC58-B0A281E6D435}" dt="2022-07-14T09:49:40.360" v="437" actId="478"/>
          <ac:picMkLst>
            <pc:docMk/>
            <pc:sldMk cId="1550663886" sldId="261"/>
            <ac:picMk id="3" creationId="{66782B4D-BB3E-4D16-87DB-0775AD4BFB0E}"/>
          </ac:picMkLst>
        </pc:picChg>
        <pc:picChg chg="add mod">
          <ac:chgData name="Miriam Schreiber" userId="5a452ff8-f189-44a9-9767-da59f69398bf" providerId="ADAL" clId="{C8A5F010-3663-4476-BC58-B0A281E6D435}" dt="2022-07-14T09:50:07.147" v="453" actId="1035"/>
          <ac:picMkLst>
            <pc:docMk/>
            <pc:sldMk cId="1550663886" sldId="261"/>
            <ac:picMk id="4" creationId="{F54F9BB4-B31E-2AEB-588F-B7465E4C8850}"/>
          </ac:picMkLst>
        </pc:picChg>
        <pc:picChg chg="add mod">
          <ac:chgData name="Miriam Schreiber" userId="5a452ff8-f189-44a9-9767-da59f69398bf" providerId="ADAL" clId="{C8A5F010-3663-4476-BC58-B0A281E6D435}" dt="2022-07-14T09:51:38.839" v="477" actId="1035"/>
          <ac:picMkLst>
            <pc:docMk/>
            <pc:sldMk cId="1550663886" sldId="261"/>
            <ac:picMk id="7" creationId="{D7B39163-E19E-88DE-9B0A-37A3B676DD91}"/>
          </ac:picMkLst>
        </pc:picChg>
        <pc:picChg chg="mod">
          <ac:chgData name="Miriam Schreiber" userId="5a452ff8-f189-44a9-9767-da59f69398bf" providerId="ADAL" clId="{C8A5F010-3663-4476-BC58-B0A281E6D435}" dt="2022-07-14T09:41:09.594" v="410" actId="1035"/>
          <ac:picMkLst>
            <pc:docMk/>
            <pc:sldMk cId="1550663886" sldId="261"/>
            <ac:picMk id="11" creationId="{43A6F7AD-3910-38F8-7274-61F2142702FF}"/>
          </ac:picMkLst>
        </pc:picChg>
        <pc:picChg chg="mod">
          <ac:chgData name="Miriam Schreiber" userId="5a452ff8-f189-44a9-9767-da59f69398bf" providerId="ADAL" clId="{C8A5F010-3663-4476-BC58-B0A281E6D435}" dt="2022-07-14T09:41:04.229" v="407" actId="1036"/>
          <ac:picMkLst>
            <pc:docMk/>
            <pc:sldMk cId="1550663886" sldId="261"/>
            <ac:picMk id="13" creationId="{074BE98A-079A-CDF2-A3E5-000BADE92DFE}"/>
          </ac:picMkLst>
        </pc:picChg>
      </pc:sldChg>
      <pc:sldChg chg="modSp mod">
        <pc:chgData name="Miriam Schreiber" userId="5a452ff8-f189-44a9-9767-da59f69398bf" providerId="ADAL" clId="{C8A5F010-3663-4476-BC58-B0A281E6D435}" dt="2022-07-14T09:52:43.922" v="553" actId="1035"/>
        <pc:sldMkLst>
          <pc:docMk/>
          <pc:sldMk cId="3784542068" sldId="262"/>
        </pc:sldMkLst>
        <pc:spChg chg="mod">
          <ac:chgData name="Miriam Schreiber" userId="5a452ff8-f189-44a9-9767-da59f69398bf" providerId="ADAL" clId="{C8A5F010-3663-4476-BC58-B0A281E6D435}" dt="2022-07-14T09:52:12.972" v="531" actId="1038"/>
          <ac:spMkLst>
            <pc:docMk/>
            <pc:sldMk cId="3784542068" sldId="262"/>
            <ac:spMk id="6" creationId="{7D51C715-249D-4DBC-91A3-68ED7BC4969A}"/>
          </ac:spMkLst>
        </pc:spChg>
        <pc:picChg chg="mod">
          <ac:chgData name="Miriam Schreiber" userId="5a452ff8-f189-44a9-9767-da59f69398bf" providerId="ADAL" clId="{C8A5F010-3663-4476-BC58-B0A281E6D435}" dt="2022-07-14T09:51:55.220" v="502" actId="1036"/>
          <ac:picMkLst>
            <pc:docMk/>
            <pc:sldMk cId="3784542068" sldId="262"/>
            <ac:picMk id="3" creationId="{3B0B89AD-C9C8-E23B-0FA4-755E2461A37D}"/>
          </ac:picMkLst>
        </pc:picChg>
        <pc:picChg chg="mod">
          <ac:chgData name="Miriam Schreiber" userId="5a452ff8-f189-44a9-9767-da59f69398bf" providerId="ADAL" clId="{C8A5F010-3663-4476-BC58-B0A281E6D435}" dt="2022-07-14T09:52:43.922" v="553" actId="1035"/>
          <ac:picMkLst>
            <pc:docMk/>
            <pc:sldMk cId="3784542068" sldId="262"/>
            <ac:picMk id="11" creationId="{3A30E51E-F78B-A884-E3A1-EBA9EAC34AD5}"/>
          </ac:picMkLst>
        </pc:picChg>
        <pc:picChg chg="mod">
          <ac:chgData name="Miriam Schreiber" userId="5a452ff8-f189-44a9-9767-da59f69398bf" providerId="ADAL" clId="{C8A5F010-3663-4476-BC58-B0A281E6D435}" dt="2022-07-14T09:52:01.986" v="525" actId="1036"/>
          <ac:picMkLst>
            <pc:docMk/>
            <pc:sldMk cId="3784542068" sldId="262"/>
            <ac:picMk id="13" creationId="{DBD1D215-1CFC-B861-3CCC-0B4491C917F5}"/>
          </ac:picMkLst>
        </pc:picChg>
      </pc:sldChg>
      <pc:sldChg chg="modSp mod">
        <pc:chgData name="Miriam Schreiber" userId="5a452ff8-f189-44a9-9767-da59f69398bf" providerId="ADAL" clId="{C8A5F010-3663-4476-BC58-B0A281E6D435}" dt="2022-07-14T09:53:40.929" v="640" actId="1036"/>
        <pc:sldMkLst>
          <pc:docMk/>
          <pc:sldMk cId="448169074" sldId="263"/>
        </pc:sldMkLst>
        <pc:spChg chg="mod">
          <ac:chgData name="Miriam Schreiber" userId="5a452ff8-f189-44a9-9767-da59f69398bf" providerId="ADAL" clId="{C8A5F010-3663-4476-BC58-B0A281E6D435}" dt="2022-07-14T09:53:16.151" v="570" actId="948"/>
          <ac:spMkLst>
            <pc:docMk/>
            <pc:sldMk cId="448169074" sldId="263"/>
            <ac:spMk id="6" creationId="{D74AA698-6A4D-4193-BAFB-9C7736439DE1}"/>
          </ac:spMkLst>
        </pc:spChg>
        <pc:picChg chg="mod">
          <ac:chgData name="Miriam Schreiber" userId="5a452ff8-f189-44a9-9767-da59f69398bf" providerId="ADAL" clId="{C8A5F010-3663-4476-BC58-B0A281E6D435}" dt="2022-07-14T09:53:34.351" v="632" actId="1036"/>
          <ac:picMkLst>
            <pc:docMk/>
            <pc:sldMk cId="448169074" sldId="263"/>
            <ac:picMk id="3" creationId="{FADCA1D8-6D90-9ACC-85FF-13613F128557}"/>
          </ac:picMkLst>
        </pc:picChg>
        <pc:picChg chg="mod">
          <ac:chgData name="Miriam Schreiber" userId="5a452ff8-f189-44a9-9767-da59f69398bf" providerId="ADAL" clId="{C8A5F010-3663-4476-BC58-B0A281E6D435}" dt="2022-07-14T09:53:28.640" v="610" actId="1036"/>
          <ac:picMkLst>
            <pc:docMk/>
            <pc:sldMk cId="448169074" sldId="263"/>
            <ac:picMk id="11" creationId="{3B24A02C-9EE4-6EE9-77F3-D20484AE5F8C}"/>
          </ac:picMkLst>
        </pc:picChg>
        <pc:picChg chg="mod">
          <ac:chgData name="Miriam Schreiber" userId="5a452ff8-f189-44a9-9767-da59f69398bf" providerId="ADAL" clId="{C8A5F010-3663-4476-BC58-B0A281E6D435}" dt="2022-07-14T09:53:40.929" v="640" actId="1036"/>
          <ac:picMkLst>
            <pc:docMk/>
            <pc:sldMk cId="448169074" sldId="263"/>
            <ac:picMk id="13" creationId="{6D393FDE-70AD-DD94-2CED-C057FB9E8956}"/>
          </ac:picMkLst>
        </pc:picChg>
      </pc:sldChg>
      <pc:sldChg chg="modSp mod">
        <pc:chgData name="Miriam Schreiber" userId="5a452ff8-f189-44a9-9767-da59f69398bf" providerId="ADAL" clId="{C8A5F010-3663-4476-BC58-B0A281E6D435}" dt="2022-07-14T09:55:17.783" v="702" actId="1036"/>
        <pc:sldMkLst>
          <pc:docMk/>
          <pc:sldMk cId="1362494773" sldId="264"/>
        </pc:sldMkLst>
        <pc:spChg chg="mod">
          <ac:chgData name="Miriam Schreiber" userId="5a452ff8-f189-44a9-9767-da59f69398bf" providerId="ADAL" clId="{C8A5F010-3663-4476-BC58-B0A281E6D435}" dt="2022-07-14T09:54:16.518" v="668" actId="1038"/>
          <ac:spMkLst>
            <pc:docMk/>
            <pc:sldMk cId="1362494773" sldId="264"/>
            <ac:spMk id="6" creationId="{267C9A00-8ADF-4ACC-A0AC-A18BD9FB106A}"/>
          </ac:spMkLst>
        </pc:spChg>
        <pc:picChg chg="mod">
          <ac:chgData name="Miriam Schreiber" userId="5a452ff8-f189-44a9-9767-da59f69398bf" providerId="ADAL" clId="{C8A5F010-3663-4476-BC58-B0A281E6D435}" dt="2022-07-14T09:55:09.758" v="693" actId="1036"/>
          <ac:picMkLst>
            <pc:docMk/>
            <pc:sldMk cId="1362494773" sldId="264"/>
            <ac:picMk id="3" creationId="{F7FC4585-CBCA-CD86-22BE-5B65EE85D44E}"/>
          </ac:picMkLst>
        </pc:picChg>
        <pc:picChg chg="mod">
          <ac:chgData name="Miriam Schreiber" userId="5a452ff8-f189-44a9-9767-da59f69398bf" providerId="ADAL" clId="{C8A5F010-3663-4476-BC58-B0A281E6D435}" dt="2022-07-14T09:54:10.641" v="665" actId="1036"/>
          <ac:picMkLst>
            <pc:docMk/>
            <pc:sldMk cId="1362494773" sldId="264"/>
            <ac:picMk id="11" creationId="{6DB5E4E4-1F89-0E87-08CB-013AF8E3B959}"/>
          </ac:picMkLst>
        </pc:picChg>
        <pc:picChg chg="mod">
          <ac:chgData name="Miriam Schreiber" userId="5a452ff8-f189-44a9-9767-da59f69398bf" providerId="ADAL" clId="{C8A5F010-3663-4476-BC58-B0A281E6D435}" dt="2022-07-14T09:55:17.783" v="702" actId="1036"/>
          <ac:picMkLst>
            <pc:docMk/>
            <pc:sldMk cId="1362494773" sldId="264"/>
            <ac:picMk id="13" creationId="{5F24FC46-AE4D-B458-5C87-8431F7110AB7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10:48:35.368" v="790" actId="207"/>
        <pc:sldMkLst>
          <pc:docMk/>
          <pc:sldMk cId="3799143060" sldId="265"/>
        </pc:sldMkLst>
        <pc:spChg chg="mod">
          <ac:chgData name="Miriam Schreiber" userId="5a452ff8-f189-44a9-9767-da59f69398bf" providerId="ADAL" clId="{C8A5F010-3663-4476-BC58-B0A281E6D435}" dt="2022-07-14T10:48:24.292" v="789" actId="1038"/>
          <ac:spMkLst>
            <pc:docMk/>
            <pc:sldMk cId="3799143060" sldId="265"/>
            <ac:spMk id="6" creationId="{17E67B85-8AFE-49ED-AFB1-205A848DFEF3}"/>
          </ac:spMkLst>
        </pc:spChg>
        <pc:spChg chg="mod">
          <ac:chgData name="Miriam Schreiber" userId="5a452ff8-f189-44a9-9767-da59f69398bf" providerId="ADAL" clId="{C8A5F010-3663-4476-BC58-B0A281E6D435}" dt="2022-07-14T10:48:35.368" v="790" actId="207"/>
          <ac:spMkLst>
            <pc:docMk/>
            <pc:sldMk cId="3799143060" sldId="265"/>
            <ac:spMk id="8" creationId="{41B74A1D-04CE-46D7-B1FB-216F04B1D975}"/>
          </ac:spMkLst>
        </pc:spChg>
        <pc:spChg chg="add del">
          <ac:chgData name="Miriam Schreiber" userId="5a452ff8-f189-44a9-9767-da59f69398bf" providerId="ADAL" clId="{C8A5F010-3663-4476-BC58-B0A281E6D435}" dt="2022-07-14T10:33:31.094" v="720" actId="478"/>
          <ac:spMkLst>
            <pc:docMk/>
            <pc:sldMk cId="3799143060" sldId="265"/>
            <ac:spMk id="9" creationId="{2082C779-F964-5E83-3C7C-A5B78BF91949}"/>
          </ac:spMkLst>
        </pc:spChg>
        <pc:picChg chg="del">
          <ac:chgData name="Miriam Schreiber" userId="5a452ff8-f189-44a9-9767-da59f69398bf" providerId="ADAL" clId="{C8A5F010-3663-4476-BC58-B0A281E6D435}" dt="2022-07-14T10:33:26.046" v="718" actId="478"/>
          <ac:picMkLst>
            <pc:docMk/>
            <pc:sldMk cId="3799143060" sldId="265"/>
            <ac:picMk id="3" creationId="{6BD1CD81-ADE8-B6AE-2FB8-50D9C5A51AE4}"/>
          </ac:picMkLst>
        </pc:picChg>
        <pc:picChg chg="add mod">
          <ac:chgData name="Miriam Schreiber" userId="5a452ff8-f189-44a9-9767-da59f69398bf" providerId="ADAL" clId="{C8A5F010-3663-4476-BC58-B0A281E6D435}" dt="2022-07-14T10:33:57.292" v="769" actId="1036"/>
          <ac:picMkLst>
            <pc:docMk/>
            <pc:sldMk cId="3799143060" sldId="265"/>
            <ac:picMk id="5" creationId="{12D513A0-AF9A-1D55-A387-2AAC1845199B}"/>
          </ac:picMkLst>
        </pc:picChg>
        <pc:picChg chg="mod">
          <ac:chgData name="Miriam Schreiber" userId="5a452ff8-f189-44a9-9767-da59f69398bf" providerId="ADAL" clId="{C8A5F010-3663-4476-BC58-B0A281E6D435}" dt="2022-07-14T10:48:06.770" v="784" actId="1076"/>
          <ac:picMkLst>
            <pc:docMk/>
            <pc:sldMk cId="3799143060" sldId="265"/>
            <ac:picMk id="11" creationId="{129E8DF7-51FD-96CF-A0E6-084E017A0041}"/>
          </ac:picMkLst>
        </pc:picChg>
        <pc:picChg chg="mod">
          <ac:chgData name="Miriam Schreiber" userId="5a452ff8-f189-44a9-9767-da59f69398bf" providerId="ADAL" clId="{C8A5F010-3663-4476-BC58-B0A281E6D435}" dt="2022-07-14T09:55:27.351" v="715" actId="1036"/>
          <ac:picMkLst>
            <pc:docMk/>
            <pc:sldMk cId="3799143060" sldId="265"/>
            <ac:picMk id="13" creationId="{6254F0A5-3782-185D-9F59-D17B5C3D1AA1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11:01:08.322" v="919" actId="1076"/>
        <pc:sldMkLst>
          <pc:docMk/>
          <pc:sldMk cId="3075301497" sldId="266"/>
        </pc:sldMkLst>
        <pc:spChg chg="mod">
          <ac:chgData name="Miriam Schreiber" userId="5a452ff8-f189-44a9-9767-da59f69398bf" providerId="ADAL" clId="{C8A5F010-3663-4476-BC58-B0A281E6D435}" dt="2022-07-14T11:01:08.322" v="919" actId="1076"/>
          <ac:spMkLst>
            <pc:docMk/>
            <pc:sldMk cId="3075301497" sldId="266"/>
            <ac:spMk id="6" creationId="{4136EF18-8B7E-44E9-BA63-04110F999032}"/>
          </ac:spMkLst>
        </pc:spChg>
        <pc:spChg chg="mod">
          <ac:chgData name="Miriam Schreiber" userId="5a452ff8-f189-44a9-9767-da59f69398bf" providerId="ADAL" clId="{C8A5F010-3663-4476-BC58-B0A281E6D435}" dt="2022-07-14T10:56:00.329" v="857" actId="207"/>
          <ac:spMkLst>
            <pc:docMk/>
            <pc:sldMk cId="3075301497" sldId="266"/>
            <ac:spMk id="8" creationId="{EA11709F-110E-47B6-AF2A-EBBB03506036}"/>
          </ac:spMkLst>
        </pc:spChg>
        <pc:picChg chg="del mod">
          <ac:chgData name="Miriam Schreiber" userId="5a452ff8-f189-44a9-9767-da59f69398bf" providerId="ADAL" clId="{C8A5F010-3663-4476-BC58-B0A281E6D435}" dt="2022-07-14T10:59:45.516" v="873" actId="478"/>
          <ac:picMkLst>
            <pc:docMk/>
            <pc:sldMk cId="3075301497" sldId="266"/>
            <ac:picMk id="3" creationId="{86341B9B-B822-B26D-E169-C3527B147369}"/>
          </ac:picMkLst>
        </pc:picChg>
        <pc:picChg chg="add del mod">
          <ac:chgData name="Miriam Schreiber" userId="5a452ff8-f189-44a9-9767-da59f69398bf" providerId="ADAL" clId="{C8A5F010-3663-4476-BC58-B0A281E6D435}" dt="2022-07-14T10:58:32.091" v="872" actId="478"/>
          <ac:picMkLst>
            <pc:docMk/>
            <pc:sldMk cId="3075301497" sldId="266"/>
            <ac:picMk id="4" creationId="{3E23568F-8135-3418-6AC5-05C2E49A9965}"/>
          </ac:picMkLst>
        </pc:picChg>
        <pc:picChg chg="add mod">
          <ac:chgData name="Miriam Schreiber" userId="5a452ff8-f189-44a9-9767-da59f69398bf" providerId="ADAL" clId="{C8A5F010-3663-4476-BC58-B0A281E6D435}" dt="2022-07-14T11:00:24.395" v="894" actId="1036"/>
          <ac:picMkLst>
            <pc:docMk/>
            <pc:sldMk cId="3075301497" sldId="266"/>
            <ac:picMk id="7" creationId="{BBD782F9-33EC-C24A-092B-24F2A65B84F0}"/>
          </ac:picMkLst>
        </pc:picChg>
        <pc:picChg chg="mod">
          <ac:chgData name="Miriam Schreiber" userId="5a452ff8-f189-44a9-9767-da59f69398bf" providerId="ADAL" clId="{C8A5F010-3663-4476-BC58-B0A281E6D435}" dt="2022-07-14T11:00:33.864" v="906" actId="1036"/>
          <ac:picMkLst>
            <pc:docMk/>
            <pc:sldMk cId="3075301497" sldId="266"/>
            <ac:picMk id="11" creationId="{ADE2DA0F-1935-00C6-4807-B2826682EA24}"/>
          </ac:picMkLst>
        </pc:picChg>
        <pc:picChg chg="mod">
          <ac:chgData name="Miriam Schreiber" userId="5a452ff8-f189-44a9-9767-da59f69398bf" providerId="ADAL" clId="{C8A5F010-3663-4476-BC58-B0A281E6D435}" dt="2022-07-14T10:49:10.070" v="822" actId="1037"/>
          <ac:picMkLst>
            <pc:docMk/>
            <pc:sldMk cId="3075301497" sldId="266"/>
            <ac:picMk id="13" creationId="{42CAEF77-C24F-9556-89D4-8BA3C5FD4853}"/>
          </ac:picMkLst>
        </pc:picChg>
      </pc:sldChg>
      <pc:sldChg chg="modSp mod">
        <pc:chgData name="Miriam Schreiber" userId="5a452ff8-f189-44a9-9767-da59f69398bf" providerId="ADAL" clId="{C8A5F010-3663-4476-BC58-B0A281E6D435}" dt="2022-07-14T11:25:44.595" v="953" actId="1035"/>
        <pc:sldMkLst>
          <pc:docMk/>
          <pc:sldMk cId="400767501" sldId="267"/>
        </pc:sldMkLst>
        <pc:spChg chg="mod">
          <ac:chgData name="Miriam Schreiber" userId="5a452ff8-f189-44a9-9767-da59f69398bf" providerId="ADAL" clId="{C8A5F010-3663-4476-BC58-B0A281E6D435}" dt="2022-07-14T11:01:16.419" v="926" actId="1037"/>
          <ac:spMkLst>
            <pc:docMk/>
            <pc:sldMk cId="400767501" sldId="267"/>
            <ac:spMk id="6" creationId="{CFDD467F-C7C1-4EF4-91AD-144B5D8BDA1C}"/>
          </ac:spMkLst>
        </pc:spChg>
        <pc:spChg chg="mod">
          <ac:chgData name="Miriam Schreiber" userId="5a452ff8-f189-44a9-9767-da59f69398bf" providerId="ADAL" clId="{C8A5F010-3663-4476-BC58-B0A281E6D435}" dt="2022-07-14T11:00:48.858" v="912" actId="404"/>
          <ac:spMkLst>
            <pc:docMk/>
            <pc:sldMk cId="400767501" sldId="267"/>
            <ac:spMk id="8" creationId="{AB4372E7-8724-48FB-A29D-531CA0B36C04}"/>
          </ac:spMkLst>
        </pc:spChg>
        <pc:picChg chg="mod">
          <ac:chgData name="Miriam Schreiber" userId="5a452ff8-f189-44a9-9767-da59f69398bf" providerId="ADAL" clId="{C8A5F010-3663-4476-BC58-B0A281E6D435}" dt="2022-07-14T11:25:36.526" v="950" actId="1036"/>
          <ac:picMkLst>
            <pc:docMk/>
            <pc:sldMk cId="400767501" sldId="267"/>
            <ac:picMk id="3" creationId="{47E8E3AF-B9AB-9699-B9B6-6AEF0AAF2C53}"/>
          </ac:picMkLst>
        </pc:picChg>
        <pc:picChg chg="mod">
          <ac:chgData name="Miriam Schreiber" userId="5a452ff8-f189-44a9-9767-da59f69398bf" providerId="ADAL" clId="{C8A5F010-3663-4476-BC58-B0A281E6D435}" dt="2022-07-14T11:25:32.430" v="943" actId="1035"/>
          <ac:picMkLst>
            <pc:docMk/>
            <pc:sldMk cId="400767501" sldId="267"/>
            <ac:picMk id="11" creationId="{C1D56F29-85D7-80F8-4C67-10A14972869D}"/>
          </ac:picMkLst>
        </pc:picChg>
        <pc:picChg chg="mod">
          <ac:chgData name="Miriam Schreiber" userId="5a452ff8-f189-44a9-9767-da59f69398bf" providerId="ADAL" clId="{C8A5F010-3663-4476-BC58-B0A281E6D435}" dt="2022-07-14T11:25:44.595" v="953" actId="1035"/>
          <ac:picMkLst>
            <pc:docMk/>
            <pc:sldMk cId="400767501" sldId="267"/>
            <ac:picMk id="13" creationId="{6C45A2DA-276C-00D1-AFA2-8757384C7FDE}"/>
          </ac:picMkLst>
        </pc:picChg>
      </pc:sldChg>
      <pc:sldChg chg="modSp mod">
        <pc:chgData name="Miriam Schreiber" userId="5a452ff8-f189-44a9-9767-da59f69398bf" providerId="ADAL" clId="{C8A5F010-3663-4476-BC58-B0A281E6D435}" dt="2022-07-14T11:30:33.242" v="1029" actId="1035"/>
        <pc:sldMkLst>
          <pc:docMk/>
          <pc:sldMk cId="876991986" sldId="268"/>
        </pc:sldMkLst>
        <pc:spChg chg="mod">
          <ac:chgData name="Miriam Schreiber" userId="5a452ff8-f189-44a9-9767-da59f69398bf" providerId="ADAL" clId="{C8A5F010-3663-4476-BC58-B0A281E6D435}" dt="2022-07-14T11:30:12.869" v="985" actId="1038"/>
          <ac:spMkLst>
            <pc:docMk/>
            <pc:sldMk cId="876991986" sldId="268"/>
            <ac:spMk id="6" creationId="{C964CA16-FFDA-4C42-BA5E-F0E1143F3494}"/>
          </ac:spMkLst>
        </pc:spChg>
        <pc:picChg chg="mod">
          <ac:chgData name="Miriam Schreiber" userId="5a452ff8-f189-44a9-9767-da59f69398bf" providerId="ADAL" clId="{C8A5F010-3663-4476-BC58-B0A281E6D435}" dt="2022-07-14T11:30:26.903" v="1026" actId="1036"/>
          <ac:picMkLst>
            <pc:docMk/>
            <pc:sldMk cId="876991986" sldId="268"/>
            <ac:picMk id="9" creationId="{889B3A18-D439-F070-2CCD-239476FE1A2C}"/>
          </ac:picMkLst>
        </pc:picChg>
        <pc:picChg chg="mod">
          <ac:chgData name="Miriam Schreiber" userId="5a452ff8-f189-44a9-9767-da59f69398bf" providerId="ADAL" clId="{C8A5F010-3663-4476-BC58-B0A281E6D435}" dt="2022-07-14T11:30:21.707" v="1007" actId="1036"/>
          <ac:picMkLst>
            <pc:docMk/>
            <pc:sldMk cId="876991986" sldId="268"/>
            <ac:picMk id="13" creationId="{E54C1BE7-7C63-C7A6-13D5-8CDEDC85D988}"/>
          </ac:picMkLst>
        </pc:picChg>
        <pc:picChg chg="mod">
          <ac:chgData name="Miriam Schreiber" userId="5a452ff8-f189-44a9-9767-da59f69398bf" providerId="ADAL" clId="{C8A5F010-3663-4476-BC58-B0A281E6D435}" dt="2022-07-14T11:30:33.242" v="1029" actId="1035"/>
          <ac:picMkLst>
            <pc:docMk/>
            <pc:sldMk cId="876991986" sldId="268"/>
            <ac:picMk id="15" creationId="{79247245-3B40-6F99-18F4-D496D258B5E1}"/>
          </ac:picMkLst>
        </pc:picChg>
      </pc:sldChg>
      <pc:sldChg chg="modSp mod">
        <pc:chgData name="Miriam Schreiber" userId="5a452ff8-f189-44a9-9767-da59f69398bf" providerId="ADAL" clId="{C8A5F010-3663-4476-BC58-B0A281E6D435}" dt="2022-07-14T12:22:14.551" v="1164" actId="1036"/>
        <pc:sldMkLst>
          <pc:docMk/>
          <pc:sldMk cId="278741267" sldId="269"/>
        </pc:sldMkLst>
        <pc:spChg chg="mod">
          <ac:chgData name="Miriam Schreiber" userId="5a452ff8-f189-44a9-9767-da59f69398bf" providerId="ADAL" clId="{C8A5F010-3663-4476-BC58-B0A281E6D435}" dt="2022-07-14T12:22:14.551" v="1164" actId="1036"/>
          <ac:spMkLst>
            <pc:docMk/>
            <pc:sldMk cId="278741267" sldId="269"/>
            <ac:spMk id="6" creationId="{79C79450-6BD3-4489-93FC-DB1217F398AB}"/>
          </ac:spMkLst>
        </pc:spChg>
        <pc:picChg chg="mod">
          <ac:chgData name="Miriam Schreiber" userId="5a452ff8-f189-44a9-9767-da59f69398bf" providerId="ADAL" clId="{C8A5F010-3663-4476-BC58-B0A281E6D435}" dt="2022-07-14T11:31:09.302" v="1086" actId="1036"/>
          <ac:picMkLst>
            <pc:docMk/>
            <pc:sldMk cId="278741267" sldId="269"/>
            <ac:picMk id="3" creationId="{DFF4045E-17F5-FE64-0BD7-9356AB8068D3}"/>
          </ac:picMkLst>
        </pc:picChg>
        <pc:picChg chg="mod">
          <ac:chgData name="Miriam Schreiber" userId="5a452ff8-f189-44a9-9767-da59f69398bf" providerId="ADAL" clId="{C8A5F010-3663-4476-BC58-B0A281E6D435}" dt="2022-07-14T11:30:59.783" v="1057" actId="1035"/>
          <ac:picMkLst>
            <pc:docMk/>
            <pc:sldMk cId="278741267" sldId="269"/>
            <ac:picMk id="11" creationId="{E11DB744-274D-413B-8D3B-25A7FF5A5879}"/>
          </ac:picMkLst>
        </pc:picChg>
        <pc:picChg chg="mod">
          <ac:chgData name="Miriam Schreiber" userId="5a452ff8-f189-44a9-9767-da59f69398bf" providerId="ADAL" clId="{C8A5F010-3663-4476-BC58-B0A281E6D435}" dt="2022-07-14T11:31:16.523" v="1089" actId="1035"/>
          <ac:picMkLst>
            <pc:docMk/>
            <pc:sldMk cId="278741267" sldId="269"/>
            <ac:picMk id="13" creationId="{EA07E126-EB13-346B-47E8-3523305F1119}"/>
          </ac:picMkLst>
        </pc:picChg>
      </pc:sldChg>
      <pc:sldChg chg="modSp mod">
        <pc:chgData name="Miriam Schreiber" userId="5a452ff8-f189-44a9-9767-da59f69398bf" providerId="ADAL" clId="{C8A5F010-3663-4476-BC58-B0A281E6D435}" dt="2022-07-14T12:22:21.964" v="1171" actId="1036"/>
        <pc:sldMkLst>
          <pc:docMk/>
          <pc:sldMk cId="184047479" sldId="270"/>
        </pc:sldMkLst>
        <pc:spChg chg="mod">
          <ac:chgData name="Miriam Schreiber" userId="5a452ff8-f189-44a9-9767-da59f69398bf" providerId="ADAL" clId="{C8A5F010-3663-4476-BC58-B0A281E6D435}" dt="2022-07-14T12:22:21.964" v="1171" actId="1036"/>
          <ac:spMkLst>
            <pc:docMk/>
            <pc:sldMk cId="184047479" sldId="270"/>
            <ac:spMk id="6" creationId="{2E7D0881-5A91-43C3-B747-B953909A7062}"/>
          </ac:spMkLst>
        </pc:spChg>
        <pc:picChg chg="mod">
          <ac:chgData name="Miriam Schreiber" userId="5a452ff8-f189-44a9-9767-da59f69398bf" providerId="ADAL" clId="{C8A5F010-3663-4476-BC58-B0A281E6D435}" dt="2022-07-14T12:21:42.147" v="1141" actId="1036"/>
          <ac:picMkLst>
            <pc:docMk/>
            <pc:sldMk cId="184047479" sldId="270"/>
            <ac:picMk id="3" creationId="{B6BB453B-F42B-DCDB-0DED-31F04DE60F93}"/>
          </ac:picMkLst>
        </pc:picChg>
        <pc:picChg chg="mod">
          <ac:chgData name="Miriam Schreiber" userId="5a452ff8-f189-44a9-9767-da59f69398bf" providerId="ADAL" clId="{C8A5F010-3663-4476-BC58-B0A281E6D435}" dt="2022-07-14T12:21:47.265" v="1144" actId="1036"/>
          <ac:picMkLst>
            <pc:docMk/>
            <pc:sldMk cId="184047479" sldId="270"/>
            <ac:picMk id="11" creationId="{83641E18-856D-7896-EF2D-14717A719390}"/>
          </ac:picMkLst>
        </pc:picChg>
        <pc:picChg chg="mod">
          <ac:chgData name="Miriam Schreiber" userId="5a452ff8-f189-44a9-9767-da59f69398bf" providerId="ADAL" clId="{C8A5F010-3663-4476-BC58-B0A281E6D435}" dt="2022-07-14T12:21:35.288" v="1116" actId="1035"/>
          <ac:picMkLst>
            <pc:docMk/>
            <pc:sldMk cId="184047479" sldId="270"/>
            <ac:picMk id="13" creationId="{95451E3D-662F-9BC8-CA81-1D7D33E8CFE3}"/>
          </ac:picMkLst>
        </pc:picChg>
      </pc:sldChg>
      <pc:sldChg chg="modSp mod">
        <pc:chgData name="Miriam Schreiber" userId="5a452ff8-f189-44a9-9767-da59f69398bf" providerId="ADAL" clId="{C8A5F010-3663-4476-BC58-B0A281E6D435}" dt="2022-07-14T12:23:33.551" v="1272" actId="1036"/>
        <pc:sldMkLst>
          <pc:docMk/>
          <pc:sldMk cId="3644538968" sldId="271"/>
        </pc:sldMkLst>
        <pc:spChg chg="mod">
          <ac:chgData name="Miriam Schreiber" userId="5a452ff8-f189-44a9-9767-da59f69398bf" providerId="ADAL" clId="{C8A5F010-3663-4476-BC58-B0A281E6D435}" dt="2022-07-14T12:23:08.635" v="1200" actId="1036"/>
          <ac:spMkLst>
            <pc:docMk/>
            <pc:sldMk cId="3644538968" sldId="271"/>
            <ac:spMk id="6" creationId="{58C13013-5966-4872-A46E-E18762FC371F}"/>
          </ac:spMkLst>
        </pc:spChg>
        <pc:picChg chg="mod">
          <ac:chgData name="Miriam Schreiber" userId="5a452ff8-f189-44a9-9767-da59f69398bf" providerId="ADAL" clId="{C8A5F010-3663-4476-BC58-B0A281E6D435}" dt="2022-07-14T12:23:27.781" v="1265" actId="1036"/>
          <ac:picMkLst>
            <pc:docMk/>
            <pc:sldMk cId="3644538968" sldId="271"/>
            <ac:picMk id="3" creationId="{40FC078B-1BB0-F128-A097-CFA9248108A1}"/>
          </ac:picMkLst>
        </pc:picChg>
        <pc:picChg chg="mod">
          <ac:chgData name="Miriam Schreiber" userId="5a452ff8-f189-44a9-9767-da59f69398bf" providerId="ADAL" clId="{C8A5F010-3663-4476-BC58-B0A281E6D435}" dt="2022-07-14T12:23:19.938" v="1238" actId="1035"/>
          <ac:picMkLst>
            <pc:docMk/>
            <pc:sldMk cId="3644538968" sldId="271"/>
            <ac:picMk id="11" creationId="{DB6EEDF0-8209-50DD-0C52-39A048916A09}"/>
          </ac:picMkLst>
        </pc:picChg>
        <pc:picChg chg="mod">
          <ac:chgData name="Miriam Schreiber" userId="5a452ff8-f189-44a9-9767-da59f69398bf" providerId="ADAL" clId="{C8A5F010-3663-4476-BC58-B0A281E6D435}" dt="2022-07-14T12:23:33.551" v="1272" actId="1036"/>
          <ac:picMkLst>
            <pc:docMk/>
            <pc:sldMk cId="3644538968" sldId="271"/>
            <ac:picMk id="13" creationId="{EECA856D-4CB6-FF68-32B3-08CC477BCFB0}"/>
          </ac:picMkLst>
        </pc:picChg>
      </pc:sldChg>
      <pc:sldChg chg="modSp mod">
        <pc:chgData name="Miriam Schreiber" userId="5a452ff8-f189-44a9-9767-da59f69398bf" providerId="ADAL" clId="{C8A5F010-3663-4476-BC58-B0A281E6D435}" dt="2022-07-14T12:25:16.991" v="1344" actId="1038"/>
        <pc:sldMkLst>
          <pc:docMk/>
          <pc:sldMk cId="4065609595" sldId="272"/>
        </pc:sldMkLst>
        <pc:spChg chg="mod">
          <ac:chgData name="Miriam Schreiber" userId="5a452ff8-f189-44a9-9767-da59f69398bf" providerId="ADAL" clId="{C8A5F010-3663-4476-BC58-B0A281E6D435}" dt="2022-07-14T12:25:16.991" v="1344" actId="1038"/>
          <ac:spMkLst>
            <pc:docMk/>
            <pc:sldMk cId="4065609595" sldId="272"/>
            <ac:spMk id="6" creationId="{77FB7F16-D884-4E3B-8711-96937AF5D979}"/>
          </ac:spMkLst>
        </pc:spChg>
        <pc:picChg chg="mod">
          <ac:chgData name="Miriam Schreiber" userId="5a452ff8-f189-44a9-9767-da59f69398bf" providerId="ADAL" clId="{C8A5F010-3663-4476-BC58-B0A281E6D435}" dt="2022-07-14T12:24:25.312" v="1326" actId="1036"/>
          <ac:picMkLst>
            <pc:docMk/>
            <pc:sldMk cId="4065609595" sldId="272"/>
            <ac:picMk id="3" creationId="{D69588AB-C0EC-30F8-737F-58CA70D41565}"/>
          </ac:picMkLst>
        </pc:picChg>
        <pc:picChg chg="mod">
          <ac:chgData name="Miriam Schreiber" userId="5a452ff8-f189-44a9-9767-da59f69398bf" providerId="ADAL" clId="{C8A5F010-3663-4476-BC58-B0A281E6D435}" dt="2022-07-14T12:24:29.740" v="1329" actId="1035"/>
          <ac:picMkLst>
            <pc:docMk/>
            <pc:sldMk cId="4065609595" sldId="272"/>
            <ac:picMk id="11" creationId="{DFFDF61E-35C8-7A09-FE41-5410E8065A12}"/>
          </ac:picMkLst>
        </pc:picChg>
        <pc:picChg chg="mod">
          <ac:chgData name="Miriam Schreiber" userId="5a452ff8-f189-44a9-9767-da59f69398bf" providerId="ADAL" clId="{C8A5F010-3663-4476-BC58-B0A281E6D435}" dt="2022-07-14T12:24:19.037" v="1300" actId="1036"/>
          <ac:picMkLst>
            <pc:docMk/>
            <pc:sldMk cId="4065609595" sldId="272"/>
            <ac:picMk id="13" creationId="{104A28DA-BA72-57EE-DF97-E7B8B92C3392}"/>
          </ac:picMkLst>
        </pc:picChg>
      </pc:sldChg>
      <pc:sldChg chg="modSp mod">
        <pc:chgData name="Miriam Schreiber" userId="5a452ff8-f189-44a9-9767-da59f69398bf" providerId="ADAL" clId="{C8A5F010-3663-4476-BC58-B0A281E6D435}" dt="2022-07-14T12:25:40.777" v="1400" actId="1035"/>
        <pc:sldMkLst>
          <pc:docMk/>
          <pc:sldMk cId="1669478830" sldId="273"/>
        </pc:sldMkLst>
        <pc:spChg chg="mod">
          <ac:chgData name="Miriam Schreiber" userId="5a452ff8-f189-44a9-9767-da59f69398bf" providerId="ADAL" clId="{C8A5F010-3663-4476-BC58-B0A281E6D435}" dt="2022-07-14T12:24:53.773" v="1343" actId="1038"/>
          <ac:spMkLst>
            <pc:docMk/>
            <pc:sldMk cId="1669478830" sldId="273"/>
            <ac:spMk id="6" creationId="{B0EB6B2B-7B86-4777-8711-BEC1086FAE6C}"/>
          </ac:spMkLst>
        </pc:spChg>
        <pc:picChg chg="mod">
          <ac:chgData name="Miriam Schreiber" userId="5a452ff8-f189-44a9-9767-da59f69398bf" providerId="ADAL" clId="{C8A5F010-3663-4476-BC58-B0A281E6D435}" dt="2022-07-14T12:25:35.491" v="1395" actId="1035"/>
          <ac:picMkLst>
            <pc:docMk/>
            <pc:sldMk cId="1669478830" sldId="273"/>
            <ac:picMk id="3" creationId="{31752317-FAC6-FE57-22A7-46FA48673CB0}"/>
          </ac:picMkLst>
        </pc:picChg>
        <pc:picChg chg="mod">
          <ac:chgData name="Miriam Schreiber" userId="5a452ff8-f189-44a9-9767-da59f69398bf" providerId="ADAL" clId="{C8A5F010-3663-4476-BC58-B0A281E6D435}" dt="2022-07-14T12:25:28.539" v="1367" actId="1035"/>
          <ac:picMkLst>
            <pc:docMk/>
            <pc:sldMk cId="1669478830" sldId="273"/>
            <ac:picMk id="11" creationId="{86FADA0A-4FAD-4D61-12C6-0C8A45AEEBC3}"/>
          </ac:picMkLst>
        </pc:picChg>
        <pc:picChg chg="mod">
          <ac:chgData name="Miriam Schreiber" userId="5a452ff8-f189-44a9-9767-da59f69398bf" providerId="ADAL" clId="{C8A5F010-3663-4476-BC58-B0A281E6D435}" dt="2022-07-14T12:25:40.777" v="1400" actId="1035"/>
          <ac:picMkLst>
            <pc:docMk/>
            <pc:sldMk cId="1669478830" sldId="273"/>
            <ac:picMk id="13" creationId="{E7E9F08D-448A-7A09-7EFF-02D729A1F459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12:31:13.608" v="1623" actId="1035"/>
        <pc:sldMkLst>
          <pc:docMk/>
          <pc:sldMk cId="4147364772" sldId="274"/>
        </pc:sldMkLst>
        <pc:spChg chg="mod">
          <ac:chgData name="Miriam Schreiber" userId="5a452ff8-f189-44a9-9767-da59f69398bf" providerId="ADAL" clId="{C8A5F010-3663-4476-BC58-B0A281E6D435}" dt="2022-07-14T12:27:41.923" v="1447" actId="1036"/>
          <ac:spMkLst>
            <pc:docMk/>
            <pc:sldMk cId="4147364772" sldId="274"/>
            <ac:spMk id="6" creationId="{0048B1DF-517F-4412-8748-313CCB03431C}"/>
          </ac:spMkLst>
        </pc:spChg>
        <pc:spChg chg="mod">
          <ac:chgData name="Miriam Schreiber" userId="5a452ff8-f189-44a9-9767-da59f69398bf" providerId="ADAL" clId="{C8A5F010-3663-4476-BC58-B0A281E6D435}" dt="2022-07-14T12:31:10.938" v="1621" actId="1076"/>
          <ac:spMkLst>
            <pc:docMk/>
            <pc:sldMk cId="4147364772" sldId="274"/>
            <ac:spMk id="8" creationId="{03C7374D-F934-4597-BAF9-6212B4655ED1}"/>
          </ac:spMkLst>
        </pc:spChg>
        <pc:spChg chg="add del mod">
          <ac:chgData name="Miriam Schreiber" userId="5a452ff8-f189-44a9-9767-da59f69398bf" providerId="ADAL" clId="{C8A5F010-3663-4476-BC58-B0A281E6D435}" dt="2022-07-14T12:28:20.524" v="1453" actId="478"/>
          <ac:spMkLst>
            <pc:docMk/>
            <pc:sldMk cId="4147364772" sldId="274"/>
            <ac:spMk id="9" creationId="{C596B85F-7D59-2259-3151-2908C49B1527}"/>
          </ac:spMkLst>
        </pc:spChg>
        <pc:picChg chg="add del mod">
          <ac:chgData name="Miriam Schreiber" userId="5a452ff8-f189-44a9-9767-da59f69398bf" providerId="ADAL" clId="{C8A5F010-3663-4476-BC58-B0A281E6D435}" dt="2022-07-14T12:29:23.015" v="1513" actId="478"/>
          <ac:picMkLst>
            <pc:docMk/>
            <pc:sldMk cId="4147364772" sldId="274"/>
            <ac:picMk id="3" creationId="{6E8DE9DF-4766-52C3-E9FA-3EAA1685F1E3}"/>
          </ac:picMkLst>
        </pc:picChg>
        <pc:picChg chg="del">
          <ac:chgData name="Miriam Schreiber" userId="5a452ff8-f189-44a9-9767-da59f69398bf" providerId="ADAL" clId="{C8A5F010-3663-4476-BC58-B0A281E6D435}" dt="2022-07-14T12:28:17.539" v="1452" actId="478"/>
          <ac:picMkLst>
            <pc:docMk/>
            <pc:sldMk cId="4147364772" sldId="274"/>
            <ac:picMk id="5" creationId="{1C7E06A8-BFF5-44C8-BED3-42E4EDABE76F}"/>
          </ac:picMkLst>
        </pc:picChg>
        <pc:picChg chg="del">
          <ac:chgData name="Miriam Schreiber" userId="5a452ff8-f189-44a9-9767-da59f69398bf" providerId="ADAL" clId="{C8A5F010-3663-4476-BC58-B0A281E6D435}" dt="2022-07-14T12:28:17.539" v="1452" actId="478"/>
          <ac:picMkLst>
            <pc:docMk/>
            <pc:sldMk cId="4147364772" sldId="274"/>
            <ac:picMk id="7" creationId="{F60C0200-79F4-428E-9191-D4713FB94626}"/>
          </ac:picMkLst>
        </pc:picChg>
        <pc:picChg chg="add del mod">
          <ac:chgData name="Miriam Schreiber" userId="5a452ff8-f189-44a9-9767-da59f69398bf" providerId="ADAL" clId="{C8A5F010-3663-4476-BC58-B0A281E6D435}" dt="2022-07-14T12:29:23.015" v="1513" actId="478"/>
          <ac:picMkLst>
            <pc:docMk/>
            <pc:sldMk cId="4147364772" sldId="274"/>
            <ac:picMk id="11" creationId="{6C53E13F-5F52-5628-3CFB-5727B1E08D53}"/>
          </ac:picMkLst>
        </pc:picChg>
        <pc:picChg chg="add del mod">
          <ac:chgData name="Miriam Schreiber" userId="5a452ff8-f189-44a9-9767-da59f69398bf" providerId="ADAL" clId="{C8A5F010-3663-4476-BC58-B0A281E6D435}" dt="2022-07-14T12:29:23.015" v="1513" actId="478"/>
          <ac:picMkLst>
            <pc:docMk/>
            <pc:sldMk cId="4147364772" sldId="274"/>
            <ac:picMk id="13" creationId="{EBFEDC2A-ED69-E525-03FB-90C89989FA89}"/>
          </ac:picMkLst>
        </pc:picChg>
        <pc:picChg chg="add mod">
          <ac:chgData name="Miriam Schreiber" userId="5a452ff8-f189-44a9-9767-da59f69398bf" providerId="ADAL" clId="{C8A5F010-3663-4476-BC58-B0A281E6D435}" dt="2022-07-14T12:30:25.121" v="1557" actId="1036"/>
          <ac:picMkLst>
            <pc:docMk/>
            <pc:sldMk cId="4147364772" sldId="274"/>
            <ac:picMk id="15" creationId="{1B686652-C541-9E8D-EA80-7D4772084517}"/>
          </ac:picMkLst>
        </pc:picChg>
        <pc:picChg chg="add mod">
          <ac:chgData name="Miriam Schreiber" userId="5a452ff8-f189-44a9-9767-da59f69398bf" providerId="ADAL" clId="{C8A5F010-3663-4476-BC58-B0A281E6D435}" dt="2022-07-14T12:30:54.870" v="1614" actId="1036"/>
          <ac:picMkLst>
            <pc:docMk/>
            <pc:sldMk cId="4147364772" sldId="274"/>
            <ac:picMk id="17" creationId="{4603634C-1822-370F-F8CB-77815EB386E3}"/>
          </ac:picMkLst>
        </pc:picChg>
        <pc:picChg chg="add mod">
          <ac:chgData name="Miriam Schreiber" userId="5a452ff8-f189-44a9-9767-da59f69398bf" providerId="ADAL" clId="{C8A5F010-3663-4476-BC58-B0A281E6D435}" dt="2022-07-14T12:31:13.608" v="1623" actId="1035"/>
          <ac:picMkLst>
            <pc:docMk/>
            <pc:sldMk cId="4147364772" sldId="274"/>
            <ac:picMk id="19" creationId="{9AF4BCC5-7A96-F6ED-D668-6ACB68FC28A5}"/>
          </ac:picMkLst>
        </pc:picChg>
      </pc:sldChg>
      <pc:sldChg chg="modSp mod">
        <pc:chgData name="Miriam Schreiber" userId="5a452ff8-f189-44a9-9767-da59f69398bf" providerId="ADAL" clId="{C8A5F010-3663-4476-BC58-B0A281E6D435}" dt="2022-07-14T12:32:17.264" v="1698" actId="1036"/>
        <pc:sldMkLst>
          <pc:docMk/>
          <pc:sldMk cId="3197210578" sldId="275"/>
        </pc:sldMkLst>
        <pc:spChg chg="mod">
          <ac:chgData name="Miriam Schreiber" userId="5a452ff8-f189-44a9-9767-da59f69398bf" providerId="ADAL" clId="{C8A5F010-3663-4476-BC58-B0A281E6D435}" dt="2022-07-14T12:31:53.497" v="1684" actId="1038"/>
          <ac:spMkLst>
            <pc:docMk/>
            <pc:sldMk cId="3197210578" sldId="275"/>
            <ac:spMk id="6" creationId="{6BF33752-3FC7-4788-A089-A4082ADAD222}"/>
          </ac:spMkLst>
        </pc:spChg>
        <pc:picChg chg="mod">
          <ac:chgData name="Miriam Schreiber" userId="5a452ff8-f189-44a9-9767-da59f69398bf" providerId="ADAL" clId="{C8A5F010-3663-4476-BC58-B0A281E6D435}" dt="2022-07-14T12:31:34.524" v="1677" actId="1035"/>
          <ac:picMkLst>
            <pc:docMk/>
            <pc:sldMk cId="3197210578" sldId="275"/>
            <ac:picMk id="3" creationId="{07DCD99F-CD84-DB21-36E1-6F8F86647191}"/>
          </ac:picMkLst>
        </pc:picChg>
        <pc:picChg chg="mod">
          <ac:chgData name="Miriam Schreiber" userId="5a452ff8-f189-44a9-9767-da59f69398bf" providerId="ADAL" clId="{C8A5F010-3663-4476-BC58-B0A281E6D435}" dt="2022-07-14T12:32:17.264" v="1698" actId="1036"/>
          <ac:picMkLst>
            <pc:docMk/>
            <pc:sldMk cId="3197210578" sldId="275"/>
            <ac:picMk id="11" creationId="{27B8F844-A7EC-7BCD-D579-9113D0E4F800}"/>
          </ac:picMkLst>
        </pc:picChg>
        <pc:picChg chg="mod">
          <ac:chgData name="Miriam Schreiber" userId="5a452ff8-f189-44a9-9767-da59f69398bf" providerId="ADAL" clId="{C8A5F010-3663-4476-BC58-B0A281E6D435}" dt="2022-07-14T12:31:24.964" v="1648" actId="1036"/>
          <ac:picMkLst>
            <pc:docMk/>
            <pc:sldMk cId="3197210578" sldId="275"/>
            <ac:picMk id="13" creationId="{33BC61E8-D422-757C-50D2-72860B480344}"/>
          </ac:picMkLst>
        </pc:picChg>
      </pc:sldChg>
      <pc:sldChg chg="modSp mod">
        <pc:chgData name="Miriam Schreiber" userId="5a452ff8-f189-44a9-9767-da59f69398bf" providerId="ADAL" clId="{C8A5F010-3663-4476-BC58-B0A281E6D435}" dt="2022-07-14T12:32:50.606" v="1719" actId="1076"/>
        <pc:sldMkLst>
          <pc:docMk/>
          <pc:sldMk cId="3440018613" sldId="276"/>
        </pc:sldMkLst>
        <pc:spChg chg="mod">
          <ac:chgData name="Miriam Schreiber" userId="5a452ff8-f189-44a9-9767-da59f69398bf" providerId="ADAL" clId="{C8A5F010-3663-4476-BC58-B0A281E6D435}" dt="2022-07-14T12:32:35.216" v="1709" actId="1035"/>
          <ac:spMkLst>
            <pc:docMk/>
            <pc:sldMk cId="3440018613" sldId="276"/>
            <ac:spMk id="6" creationId="{2AB776A6-BAB2-44B8-9E57-E586B4F32EB3}"/>
          </ac:spMkLst>
        </pc:spChg>
        <pc:picChg chg="mod">
          <ac:chgData name="Miriam Schreiber" userId="5a452ff8-f189-44a9-9767-da59f69398bf" providerId="ADAL" clId="{C8A5F010-3663-4476-BC58-B0A281E6D435}" dt="2022-07-14T12:32:46.630" v="1718" actId="1036"/>
          <ac:picMkLst>
            <pc:docMk/>
            <pc:sldMk cId="3440018613" sldId="276"/>
            <ac:picMk id="3" creationId="{382D12CD-E58F-E683-00C0-AE12DF8EBC5B}"/>
          </ac:picMkLst>
        </pc:picChg>
        <pc:picChg chg="mod">
          <ac:chgData name="Miriam Schreiber" userId="5a452ff8-f189-44a9-9767-da59f69398bf" providerId="ADAL" clId="{C8A5F010-3663-4476-BC58-B0A281E6D435}" dt="2022-07-14T12:32:40.690" v="1715" actId="1035"/>
          <ac:picMkLst>
            <pc:docMk/>
            <pc:sldMk cId="3440018613" sldId="276"/>
            <ac:picMk id="11" creationId="{8C402857-DDE6-F039-89ED-590ED1FDBFC3}"/>
          </ac:picMkLst>
        </pc:picChg>
        <pc:picChg chg="mod">
          <ac:chgData name="Miriam Schreiber" userId="5a452ff8-f189-44a9-9767-da59f69398bf" providerId="ADAL" clId="{C8A5F010-3663-4476-BC58-B0A281E6D435}" dt="2022-07-14T12:32:50.606" v="1719" actId="1076"/>
          <ac:picMkLst>
            <pc:docMk/>
            <pc:sldMk cId="3440018613" sldId="276"/>
            <ac:picMk id="13" creationId="{40DFBDCD-F6DD-9847-AC61-DD090FAA6472}"/>
          </ac:picMkLst>
        </pc:picChg>
      </pc:sldChg>
      <pc:sldChg chg="modSp mod">
        <pc:chgData name="Miriam Schreiber" userId="5a452ff8-f189-44a9-9767-da59f69398bf" providerId="ADAL" clId="{C8A5F010-3663-4476-BC58-B0A281E6D435}" dt="2022-07-14T12:33:26.668" v="1771" actId="1036"/>
        <pc:sldMkLst>
          <pc:docMk/>
          <pc:sldMk cId="1826662784" sldId="277"/>
        </pc:sldMkLst>
        <pc:spChg chg="mod">
          <ac:chgData name="Miriam Schreiber" userId="5a452ff8-f189-44a9-9767-da59f69398bf" providerId="ADAL" clId="{C8A5F010-3663-4476-BC58-B0A281E6D435}" dt="2022-07-14T12:33:07.091" v="1728" actId="1036"/>
          <ac:spMkLst>
            <pc:docMk/>
            <pc:sldMk cId="1826662784" sldId="277"/>
            <ac:spMk id="6" creationId="{693C06FC-B407-407F-A0B9-1CD61D6F0CF0}"/>
          </ac:spMkLst>
        </pc:spChg>
        <pc:picChg chg="mod">
          <ac:chgData name="Miriam Schreiber" userId="5a452ff8-f189-44a9-9767-da59f69398bf" providerId="ADAL" clId="{C8A5F010-3663-4476-BC58-B0A281E6D435}" dt="2022-07-14T12:33:20.831" v="1762" actId="1036"/>
          <ac:picMkLst>
            <pc:docMk/>
            <pc:sldMk cId="1826662784" sldId="277"/>
            <ac:picMk id="3" creationId="{E9413B36-AC8B-843F-AF86-B9C3BAFA79F6}"/>
          </ac:picMkLst>
        </pc:picChg>
        <pc:picChg chg="mod">
          <ac:chgData name="Miriam Schreiber" userId="5a452ff8-f189-44a9-9767-da59f69398bf" providerId="ADAL" clId="{C8A5F010-3663-4476-BC58-B0A281E6D435}" dt="2022-07-14T12:33:15.730" v="1751" actId="1038"/>
          <ac:picMkLst>
            <pc:docMk/>
            <pc:sldMk cId="1826662784" sldId="277"/>
            <ac:picMk id="11" creationId="{4B6C7BBC-0AF0-D18D-4F1A-BB9ED77E2990}"/>
          </ac:picMkLst>
        </pc:picChg>
        <pc:picChg chg="mod">
          <ac:chgData name="Miriam Schreiber" userId="5a452ff8-f189-44a9-9767-da59f69398bf" providerId="ADAL" clId="{C8A5F010-3663-4476-BC58-B0A281E6D435}" dt="2022-07-14T12:33:26.668" v="1771" actId="1036"/>
          <ac:picMkLst>
            <pc:docMk/>
            <pc:sldMk cId="1826662784" sldId="277"/>
            <ac:picMk id="13" creationId="{D1ECE49B-0EBE-54D5-ABA4-D1362144632C}"/>
          </ac:picMkLst>
        </pc:picChg>
      </pc:sldChg>
      <pc:sldChg chg="modSp mod">
        <pc:chgData name="Miriam Schreiber" userId="5a452ff8-f189-44a9-9767-da59f69398bf" providerId="ADAL" clId="{C8A5F010-3663-4476-BC58-B0A281E6D435}" dt="2022-07-14T12:34:55.912" v="1888" actId="1038"/>
        <pc:sldMkLst>
          <pc:docMk/>
          <pc:sldMk cId="1213069761" sldId="278"/>
        </pc:sldMkLst>
        <pc:spChg chg="mod">
          <ac:chgData name="Miriam Schreiber" userId="5a452ff8-f189-44a9-9767-da59f69398bf" providerId="ADAL" clId="{C8A5F010-3663-4476-BC58-B0A281E6D435}" dt="2022-07-14T12:34:55.912" v="1888" actId="1038"/>
          <ac:spMkLst>
            <pc:docMk/>
            <pc:sldMk cId="1213069761" sldId="278"/>
            <ac:spMk id="6" creationId="{062B0B4D-BAF2-4325-B915-0CF714CEF515}"/>
          </ac:spMkLst>
        </pc:spChg>
        <pc:picChg chg="mod">
          <ac:chgData name="Miriam Schreiber" userId="5a452ff8-f189-44a9-9767-da59f69398bf" providerId="ADAL" clId="{C8A5F010-3663-4476-BC58-B0A281E6D435}" dt="2022-07-14T12:33:59.027" v="1822" actId="1035"/>
          <ac:picMkLst>
            <pc:docMk/>
            <pc:sldMk cId="1213069761" sldId="278"/>
            <ac:picMk id="3" creationId="{793F53A3-C01C-CF60-785F-13355A49817B}"/>
          </ac:picMkLst>
        </pc:picChg>
        <pc:picChg chg="mod">
          <ac:chgData name="Miriam Schreiber" userId="5a452ff8-f189-44a9-9767-da59f69398bf" providerId="ADAL" clId="{C8A5F010-3663-4476-BC58-B0A281E6D435}" dt="2022-07-14T12:33:54.287" v="1810" actId="1035"/>
          <ac:picMkLst>
            <pc:docMk/>
            <pc:sldMk cId="1213069761" sldId="278"/>
            <ac:picMk id="11" creationId="{11DF3466-15C9-10D2-E29B-A8C5A99145FC}"/>
          </ac:picMkLst>
        </pc:picChg>
        <pc:picChg chg="mod">
          <ac:chgData name="Miriam Schreiber" userId="5a452ff8-f189-44a9-9767-da59f69398bf" providerId="ADAL" clId="{C8A5F010-3663-4476-BC58-B0A281E6D435}" dt="2022-07-14T12:34:04.847" v="1832" actId="1036"/>
          <ac:picMkLst>
            <pc:docMk/>
            <pc:sldMk cId="1213069761" sldId="278"/>
            <ac:picMk id="13" creationId="{6256F431-1C5C-24D2-CCD0-C72E6DC43B50}"/>
          </ac:picMkLst>
        </pc:picChg>
      </pc:sldChg>
      <pc:sldChg chg="modSp mod">
        <pc:chgData name="Miriam Schreiber" userId="5a452ff8-f189-44a9-9767-da59f69398bf" providerId="ADAL" clId="{C8A5F010-3663-4476-BC58-B0A281E6D435}" dt="2022-07-14T12:34:43.910" v="1887" actId="1076"/>
        <pc:sldMkLst>
          <pc:docMk/>
          <pc:sldMk cId="2424307640" sldId="279"/>
        </pc:sldMkLst>
        <pc:spChg chg="mod">
          <ac:chgData name="Miriam Schreiber" userId="5a452ff8-f189-44a9-9767-da59f69398bf" providerId="ADAL" clId="{C8A5F010-3663-4476-BC58-B0A281E6D435}" dt="2022-07-14T12:34:28.047" v="1853" actId="1038"/>
          <ac:spMkLst>
            <pc:docMk/>
            <pc:sldMk cId="2424307640" sldId="279"/>
            <ac:spMk id="6" creationId="{650CACA9-9C0D-49E2-A76D-AB5821A41F77}"/>
          </ac:spMkLst>
        </pc:spChg>
        <pc:picChg chg="mod">
          <ac:chgData name="Miriam Schreiber" userId="5a452ff8-f189-44a9-9767-da59f69398bf" providerId="ADAL" clId="{C8A5F010-3663-4476-BC58-B0A281E6D435}" dt="2022-07-14T12:34:40.625" v="1886" actId="1036"/>
          <ac:picMkLst>
            <pc:docMk/>
            <pc:sldMk cId="2424307640" sldId="279"/>
            <ac:picMk id="3" creationId="{EB765045-44DB-CCF3-0EA4-BC60992AEE28}"/>
          </ac:picMkLst>
        </pc:picChg>
        <pc:picChg chg="mod">
          <ac:chgData name="Miriam Schreiber" userId="5a452ff8-f189-44a9-9767-da59f69398bf" providerId="ADAL" clId="{C8A5F010-3663-4476-BC58-B0A281E6D435}" dt="2022-07-14T12:34:33.889" v="1869" actId="1035"/>
          <ac:picMkLst>
            <pc:docMk/>
            <pc:sldMk cId="2424307640" sldId="279"/>
            <ac:picMk id="11" creationId="{249B5C50-D198-36D5-5A31-F33F027C196F}"/>
          </ac:picMkLst>
        </pc:picChg>
        <pc:picChg chg="mod">
          <ac:chgData name="Miriam Schreiber" userId="5a452ff8-f189-44a9-9767-da59f69398bf" providerId="ADAL" clId="{C8A5F010-3663-4476-BC58-B0A281E6D435}" dt="2022-07-14T12:34:43.910" v="1887" actId="1076"/>
          <ac:picMkLst>
            <pc:docMk/>
            <pc:sldMk cId="2424307640" sldId="279"/>
            <ac:picMk id="13" creationId="{496B33EE-CA13-EC94-8DBA-1971BA051845}"/>
          </ac:picMkLst>
        </pc:picChg>
      </pc:sldChg>
      <pc:sldChg chg="modSp mod">
        <pc:chgData name="Miriam Schreiber" userId="5a452ff8-f189-44a9-9767-da59f69398bf" providerId="ADAL" clId="{C8A5F010-3663-4476-BC58-B0A281E6D435}" dt="2022-07-14T12:35:43.170" v="1963" actId="1036"/>
        <pc:sldMkLst>
          <pc:docMk/>
          <pc:sldMk cId="508478025" sldId="280"/>
        </pc:sldMkLst>
        <pc:spChg chg="mod">
          <ac:chgData name="Miriam Schreiber" userId="5a452ff8-f189-44a9-9767-da59f69398bf" providerId="ADAL" clId="{C8A5F010-3663-4476-BC58-B0A281E6D435}" dt="2022-07-14T12:35:22.717" v="1905" actId="948"/>
          <ac:spMkLst>
            <pc:docMk/>
            <pc:sldMk cId="508478025" sldId="280"/>
            <ac:spMk id="6" creationId="{508E004A-EF2B-4DC0-BEE9-82D6E1BD7208}"/>
          </ac:spMkLst>
        </pc:spChg>
        <pc:picChg chg="mod">
          <ac:chgData name="Miriam Schreiber" userId="5a452ff8-f189-44a9-9767-da59f69398bf" providerId="ADAL" clId="{C8A5F010-3663-4476-BC58-B0A281E6D435}" dt="2022-07-14T12:35:36.604" v="1950" actId="1036"/>
          <ac:picMkLst>
            <pc:docMk/>
            <pc:sldMk cId="508478025" sldId="280"/>
            <ac:picMk id="3" creationId="{4C391552-699E-E504-0D78-D10CD7613268}"/>
          </ac:picMkLst>
        </pc:picChg>
        <pc:picChg chg="mod">
          <ac:chgData name="Miriam Schreiber" userId="5a452ff8-f189-44a9-9767-da59f69398bf" providerId="ADAL" clId="{C8A5F010-3663-4476-BC58-B0A281E6D435}" dt="2022-07-14T12:35:31.860" v="1935" actId="1036"/>
          <ac:picMkLst>
            <pc:docMk/>
            <pc:sldMk cId="508478025" sldId="280"/>
            <ac:picMk id="11" creationId="{091F06FE-1114-3127-117D-CD5C2E1DB227}"/>
          </ac:picMkLst>
        </pc:picChg>
        <pc:picChg chg="mod">
          <ac:chgData name="Miriam Schreiber" userId="5a452ff8-f189-44a9-9767-da59f69398bf" providerId="ADAL" clId="{C8A5F010-3663-4476-BC58-B0A281E6D435}" dt="2022-07-14T12:35:43.170" v="1963" actId="1036"/>
          <ac:picMkLst>
            <pc:docMk/>
            <pc:sldMk cId="508478025" sldId="280"/>
            <ac:picMk id="13" creationId="{B67225FB-91DB-E7F0-75BF-C1E22842AF01}"/>
          </ac:picMkLst>
        </pc:picChg>
      </pc:sldChg>
      <pc:sldChg chg="modSp mod">
        <pc:chgData name="Miriam Schreiber" userId="5a452ff8-f189-44a9-9767-da59f69398bf" providerId="ADAL" clId="{C8A5F010-3663-4476-BC58-B0A281E6D435}" dt="2022-07-14T12:36:41.924" v="2013" actId="1035"/>
        <pc:sldMkLst>
          <pc:docMk/>
          <pc:sldMk cId="1041015941" sldId="281"/>
        </pc:sldMkLst>
        <pc:spChg chg="mod">
          <ac:chgData name="Miriam Schreiber" userId="5a452ff8-f189-44a9-9767-da59f69398bf" providerId="ADAL" clId="{C8A5F010-3663-4476-BC58-B0A281E6D435}" dt="2022-07-14T12:36:11.141" v="1978" actId="1038"/>
          <ac:spMkLst>
            <pc:docMk/>
            <pc:sldMk cId="1041015941" sldId="281"/>
            <ac:spMk id="6" creationId="{5A7B7D13-5693-4F42-8663-C0D4C0026FF8}"/>
          </ac:spMkLst>
        </pc:spChg>
        <pc:picChg chg="mod">
          <ac:chgData name="Miriam Schreiber" userId="5a452ff8-f189-44a9-9767-da59f69398bf" providerId="ADAL" clId="{C8A5F010-3663-4476-BC58-B0A281E6D435}" dt="2022-07-14T12:36:35.219" v="2010" actId="1036"/>
          <ac:picMkLst>
            <pc:docMk/>
            <pc:sldMk cId="1041015941" sldId="281"/>
            <ac:picMk id="3" creationId="{EA2CCA40-0F01-05CB-85C1-AC6FB6BD788D}"/>
          </ac:picMkLst>
        </pc:picChg>
        <pc:picChg chg="mod">
          <ac:chgData name="Miriam Schreiber" userId="5a452ff8-f189-44a9-9767-da59f69398bf" providerId="ADAL" clId="{C8A5F010-3663-4476-BC58-B0A281E6D435}" dt="2022-07-14T12:36:29.656" v="1994" actId="1036"/>
          <ac:picMkLst>
            <pc:docMk/>
            <pc:sldMk cId="1041015941" sldId="281"/>
            <ac:picMk id="11" creationId="{9F1E0B43-7420-87E4-2C1C-7DCE38BE5296}"/>
          </ac:picMkLst>
        </pc:picChg>
        <pc:picChg chg="mod">
          <ac:chgData name="Miriam Schreiber" userId="5a452ff8-f189-44a9-9767-da59f69398bf" providerId="ADAL" clId="{C8A5F010-3663-4476-BC58-B0A281E6D435}" dt="2022-07-14T12:36:41.924" v="2013" actId="1035"/>
          <ac:picMkLst>
            <pc:docMk/>
            <pc:sldMk cId="1041015941" sldId="281"/>
            <ac:picMk id="13" creationId="{70F27FC6-091E-2884-F4BD-71137645FD12}"/>
          </ac:picMkLst>
        </pc:picChg>
      </pc:sldChg>
      <pc:sldChg chg="modSp mod">
        <pc:chgData name="Miriam Schreiber" userId="5a452ff8-f189-44a9-9767-da59f69398bf" providerId="ADAL" clId="{C8A5F010-3663-4476-BC58-B0A281E6D435}" dt="2022-07-14T12:37:24.948" v="2108" actId="1036"/>
        <pc:sldMkLst>
          <pc:docMk/>
          <pc:sldMk cId="3079572683" sldId="282"/>
        </pc:sldMkLst>
        <pc:spChg chg="mod">
          <ac:chgData name="Miriam Schreiber" userId="5a452ff8-f189-44a9-9767-da59f69398bf" providerId="ADAL" clId="{C8A5F010-3663-4476-BC58-B0A281E6D435}" dt="2022-07-14T12:37:24.948" v="2108" actId="1036"/>
          <ac:spMkLst>
            <pc:docMk/>
            <pc:sldMk cId="3079572683" sldId="282"/>
            <ac:spMk id="6" creationId="{C2ABBA9E-5E78-4392-9620-B9C9CD81C30F}"/>
          </ac:spMkLst>
        </pc:spChg>
        <pc:picChg chg="mod">
          <ac:chgData name="Miriam Schreiber" userId="5a452ff8-f189-44a9-9767-da59f69398bf" providerId="ADAL" clId="{C8A5F010-3663-4476-BC58-B0A281E6D435}" dt="2022-07-14T12:37:04.121" v="2077" actId="1036"/>
          <ac:picMkLst>
            <pc:docMk/>
            <pc:sldMk cId="3079572683" sldId="282"/>
            <ac:picMk id="3" creationId="{9DD5A558-87E4-165E-E039-5B8F317D1BCF}"/>
          </ac:picMkLst>
        </pc:picChg>
        <pc:picChg chg="mod">
          <ac:chgData name="Miriam Schreiber" userId="5a452ff8-f189-44a9-9767-da59f69398bf" providerId="ADAL" clId="{C8A5F010-3663-4476-BC58-B0A281E6D435}" dt="2022-07-14T12:37:11.357" v="2097" actId="1036"/>
          <ac:picMkLst>
            <pc:docMk/>
            <pc:sldMk cId="3079572683" sldId="282"/>
            <ac:picMk id="11" creationId="{C3329143-95BA-FD01-E019-A04B1543C8F3}"/>
          </ac:picMkLst>
        </pc:picChg>
        <pc:picChg chg="mod">
          <ac:chgData name="Miriam Schreiber" userId="5a452ff8-f189-44a9-9767-da59f69398bf" providerId="ADAL" clId="{C8A5F010-3663-4476-BC58-B0A281E6D435}" dt="2022-07-14T12:36:55.594" v="2039" actId="1037"/>
          <ac:picMkLst>
            <pc:docMk/>
            <pc:sldMk cId="3079572683" sldId="282"/>
            <ac:picMk id="13" creationId="{D8DE479A-F289-FD1E-2479-D16C3564C957}"/>
          </ac:picMkLst>
        </pc:picChg>
      </pc:sldChg>
      <pc:sldChg chg="modSp mod">
        <pc:chgData name="Miriam Schreiber" userId="5a452ff8-f189-44a9-9767-da59f69398bf" providerId="ADAL" clId="{C8A5F010-3663-4476-BC58-B0A281E6D435}" dt="2022-07-14T12:38:13.593" v="2171" actId="1035"/>
        <pc:sldMkLst>
          <pc:docMk/>
          <pc:sldMk cId="403888727" sldId="283"/>
        </pc:sldMkLst>
        <pc:spChg chg="mod">
          <ac:chgData name="Miriam Schreiber" userId="5a452ff8-f189-44a9-9767-da59f69398bf" providerId="ADAL" clId="{C8A5F010-3663-4476-BC58-B0A281E6D435}" dt="2022-07-14T12:38:13.593" v="2171" actId="1035"/>
          <ac:spMkLst>
            <pc:docMk/>
            <pc:sldMk cId="403888727" sldId="283"/>
            <ac:spMk id="6" creationId="{2E16B56B-25A7-4CAB-93B0-FD84BD9B04C9}"/>
          </ac:spMkLst>
        </pc:spChg>
        <pc:picChg chg="mod">
          <ac:chgData name="Miriam Schreiber" userId="5a452ff8-f189-44a9-9767-da59f69398bf" providerId="ADAL" clId="{C8A5F010-3663-4476-BC58-B0A281E6D435}" dt="2022-07-14T12:37:53.072" v="2156" actId="1036"/>
          <ac:picMkLst>
            <pc:docMk/>
            <pc:sldMk cId="403888727" sldId="283"/>
            <ac:picMk id="3" creationId="{3A392C40-9051-5948-2DDE-B2132E6D7570}"/>
          </ac:picMkLst>
        </pc:picChg>
        <pc:picChg chg="mod">
          <ac:chgData name="Miriam Schreiber" userId="5a452ff8-f189-44a9-9767-da59f69398bf" providerId="ADAL" clId="{C8A5F010-3663-4476-BC58-B0A281E6D435}" dt="2022-07-14T12:37:46.733" v="2138" actId="1035"/>
          <ac:picMkLst>
            <pc:docMk/>
            <pc:sldMk cId="403888727" sldId="283"/>
            <ac:picMk id="11" creationId="{8BD41570-4DE9-48B4-BFBE-35BBE9EAEC3A}"/>
          </ac:picMkLst>
        </pc:picChg>
        <pc:picChg chg="mod">
          <ac:chgData name="Miriam Schreiber" userId="5a452ff8-f189-44a9-9767-da59f69398bf" providerId="ADAL" clId="{C8A5F010-3663-4476-BC58-B0A281E6D435}" dt="2022-07-14T12:38:00.287" v="2166" actId="1035"/>
          <ac:picMkLst>
            <pc:docMk/>
            <pc:sldMk cId="403888727" sldId="283"/>
            <ac:picMk id="13" creationId="{FB56B987-CCBA-771B-11E8-A2D804B20398}"/>
          </ac:picMkLst>
        </pc:picChg>
      </pc:sldChg>
      <pc:sldChg chg="modSp mod">
        <pc:chgData name="Miriam Schreiber" userId="5a452ff8-f189-44a9-9767-da59f69398bf" providerId="ADAL" clId="{C8A5F010-3663-4476-BC58-B0A281E6D435}" dt="2022-07-14T12:38:56.545" v="2229" actId="1036"/>
        <pc:sldMkLst>
          <pc:docMk/>
          <pc:sldMk cId="380493374" sldId="284"/>
        </pc:sldMkLst>
        <pc:spChg chg="mod">
          <ac:chgData name="Miriam Schreiber" userId="5a452ff8-f189-44a9-9767-da59f69398bf" providerId="ADAL" clId="{C8A5F010-3663-4476-BC58-B0A281E6D435}" dt="2022-07-14T12:38:34.111" v="2186" actId="1038"/>
          <ac:spMkLst>
            <pc:docMk/>
            <pc:sldMk cId="380493374" sldId="284"/>
            <ac:spMk id="6" creationId="{48A87CD9-7C3A-4B5B-AC44-B6541CEBE8C7}"/>
          </ac:spMkLst>
        </pc:spChg>
        <pc:picChg chg="mod">
          <ac:chgData name="Miriam Schreiber" userId="5a452ff8-f189-44a9-9767-da59f69398bf" providerId="ADAL" clId="{C8A5F010-3663-4476-BC58-B0A281E6D435}" dt="2022-07-14T12:38:45.936" v="2212" actId="1035"/>
          <ac:picMkLst>
            <pc:docMk/>
            <pc:sldMk cId="380493374" sldId="284"/>
            <ac:picMk id="3" creationId="{A55650E7-BF8C-301D-DBF4-582861C38414}"/>
          </ac:picMkLst>
        </pc:picChg>
        <pc:picChg chg="mod">
          <ac:chgData name="Miriam Schreiber" userId="5a452ff8-f189-44a9-9767-da59f69398bf" providerId="ADAL" clId="{C8A5F010-3663-4476-BC58-B0A281E6D435}" dt="2022-07-14T12:38:40.790" v="2199" actId="1036"/>
          <ac:picMkLst>
            <pc:docMk/>
            <pc:sldMk cId="380493374" sldId="284"/>
            <ac:picMk id="11" creationId="{D49192AA-0617-1C99-FA75-1C8073FE40D4}"/>
          </ac:picMkLst>
        </pc:picChg>
        <pc:picChg chg="mod">
          <ac:chgData name="Miriam Schreiber" userId="5a452ff8-f189-44a9-9767-da59f69398bf" providerId="ADAL" clId="{C8A5F010-3663-4476-BC58-B0A281E6D435}" dt="2022-07-14T12:38:56.545" v="2229" actId="1036"/>
          <ac:picMkLst>
            <pc:docMk/>
            <pc:sldMk cId="380493374" sldId="284"/>
            <ac:picMk id="13" creationId="{EE28B52C-AF09-BD47-464E-B0248A6EE5AE}"/>
          </ac:picMkLst>
        </pc:picChg>
      </pc:sldChg>
      <pc:sldChg chg="modSp mod">
        <pc:chgData name="Miriam Schreiber" userId="5a452ff8-f189-44a9-9767-da59f69398bf" providerId="ADAL" clId="{C8A5F010-3663-4476-BC58-B0A281E6D435}" dt="2022-07-14T12:39:29.330" v="2295" actId="1037"/>
        <pc:sldMkLst>
          <pc:docMk/>
          <pc:sldMk cId="1518853995" sldId="285"/>
        </pc:sldMkLst>
        <pc:spChg chg="mod">
          <ac:chgData name="Miriam Schreiber" userId="5a452ff8-f189-44a9-9767-da59f69398bf" providerId="ADAL" clId="{C8A5F010-3663-4476-BC58-B0A281E6D435}" dt="2022-07-14T12:39:29.330" v="2295" actId="1037"/>
          <ac:spMkLst>
            <pc:docMk/>
            <pc:sldMk cId="1518853995" sldId="285"/>
            <ac:spMk id="6" creationId="{4D60637C-53D7-4E02-81B7-14B0C1308C2D}"/>
          </ac:spMkLst>
        </pc:spChg>
        <pc:picChg chg="mod">
          <ac:chgData name="Miriam Schreiber" userId="5a452ff8-f189-44a9-9767-da59f69398bf" providerId="ADAL" clId="{C8A5F010-3663-4476-BC58-B0A281E6D435}" dt="2022-07-14T12:39:12.127" v="2272" actId="1036"/>
          <ac:picMkLst>
            <pc:docMk/>
            <pc:sldMk cId="1518853995" sldId="285"/>
            <ac:picMk id="3" creationId="{1C817AE6-1A33-CFF0-BA2E-29DD21CEB488}"/>
          </ac:picMkLst>
        </pc:picChg>
        <pc:picChg chg="mod">
          <ac:chgData name="Miriam Schreiber" userId="5a452ff8-f189-44a9-9767-da59f69398bf" providerId="ADAL" clId="{C8A5F010-3663-4476-BC58-B0A281E6D435}" dt="2022-07-14T12:39:06.019" v="2251" actId="1036"/>
          <ac:picMkLst>
            <pc:docMk/>
            <pc:sldMk cId="1518853995" sldId="285"/>
            <ac:picMk id="11" creationId="{D4AC688B-AEBF-421C-2CB3-E797C533F778}"/>
          </ac:picMkLst>
        </pc:picChg>
        <pc:picChg chg="mod">
          <ac:chgData name="Miriam Schreiber" userId="5a452ff8-f189-44a9-9767-da59f69398bf" providerId="ADAL" clId="{C8A5F010-3663-4476-BC58-B0A281E6D435}" dt="2022-07-14T12:39:17.988" v="2285" actId="1036"/>
          <ac:picMkLst>
            <pc:docMk/>
            <pc:sldMk cId="1518853995" sldId="285"/>
            <ac:picMk id="13" creationId="{2523A676-DF6F-958F-7E05-38B5C940C75C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12:51:26.857" v="2381" actId="207"/>
        <pc:sldMkLst>
          <pc:docMk/>
          <pc:sldMk cId="4210948899" sldId="286"/>
        </pc:sldMkLst>
        <pc:spChg chg="mod">
          <ac:chgData name="Miriam Schreiber" userId="5a452ff8-f189-44a9-9767-da59f69398bf" providerId="ADAL" clId="{C8A5F010-3663-4476-BC58-B0A281E6D435}" dt="2022-07-14T12:51:21.203" v="2380" actId="1038"/>
          <ac:spMkLst>
            <pc:docMk/>
            <pc:sldMk cId="4210948899" sldId="286"/>
            <ac:spMk id="6" creationId="{5BB469A1-1C03-4F61-B510-A317EED09C2D}"/>
          </ac:spMkLst>
        </pc:spChg>
        <pc:spChg chg="mod">
          <ac:chgData name="Miriam Schreiber" userId="5a452ff8-f189-44a9-9767-da59f69398bf" providerId="ADAL" clId="{C8A5F010-3663-4476-BC58-B0A281E6D435}" dt="2022-07-14T12:51:26.857" v="2381" actId="207"/>
          <ac:spMkLst>
            <pc:docMk/>
            <pc:sldMk cId="4210948899" sldId="286"/>
            <ac:spMk id="8" creationId="{138202AF-DE71-488E-968D-A106D96143AA}"/>
          </ac:spMkLst>
        </pc:spChg>
        <pc:picChg chg="del">
          <ac:chgData name="Miriam Schreiber" userId="5a452ff8-f189-44a9-9767-da59f69398bf" providerId="ADAL" clId="{C8A5F010-3663-4476-BC58-B0A281E6D435}" dt="2022-07-14T12:50:18.717" v="2297" actId="478"/>
          <ac:picMkLst>
            <pc:docMk/>
            <pc:sldMk cId="4210948899" sldId="286"/>
            <ac:picMk id="3" creationId="{92AD8DF3-ABC5-E824-50CF-0901D72F1554}"/>
          </ac:picMkLst>
        </pc:picChg>
        <pc:picChg chg="add mod">
          <ac:chgData name="Miriam Schreiber" userId="5a452ff8-f189-44a9-9767-da59f69398bf" providerId="ADAL" clId="{C8A5F010-3663-4476-BC58-B0A281E6D435}" dt="2022-07-14T12:50:37.507" v="2338" actId="1036"/>
          <ac:picMkLst>
            <pc:docMk/>
            <pc:sldMk cId="4210948899" sldId="286"/>
            <ac:picMk id="4" creationId="{2F310ED0-D1E9-E7F2-BFF3-DF4833071193}"/>
          </ac:picMkLst>
        </pc:picChg>
        <pc:picChg chg="mod">
          <ac:chgData name="Miriam Schreiber" userId="5a452ff8-f189-44a9-9767-da59f69398bf" providerId="ADAL" clId="{C8A5F010-3663-4476-BC58-B0A281E6D435}" dt="2022-07-14T12:50:45.080" v="2365" actId="1036"/>
          <ac:picMkLst>
            <pc:docMk/>
            <pc:sldMk cId="4210948899" sldId="286"/>
            <ac:picMk id="11" creationId="{5469A01C-F6F0-066F-EEE7-F2CB47553A6D}"/>
          </ac:picMkLst>
        </pc:picChg>
        <pc:picChg chg="mod">
          <ac:chgData name="Miriam Schreiber" userId="5a452ff8-f189-44a9-9767-da59f69398bf" providerId="ADAL" clId="{C8A5F010-3663-4476-BC58-B0A281E6D435}" dt="2022-07-14T12:50:59.781" v="2368" actId="1035"/>
          <ac:picMkLst>
            <pc:docMk/>
            <pc:sldMk cId="4210948899" sldId="286"/>
            <ac:picMk id="13" creationId="{C7B9EE34-19DB-8481-0B5D-0B69B72CA9EA}"/>
          </ac:picMkLst>
        </pc:picChg>
      </pc:sldChg>
      <pc:sldChg chg="modSp mod">
        <pc:chgData name="Miriam Schreiber" userId="5a452ff8-f189-44a9-9767-da59f69398bf" providerId="ADAL" clId="{C8A5F010-3663-4476-BC58-B0A281E6D435}" dt="2022-07-14T12:52:10.447" v="2429" actId="948"/>
        <pc:sldMkLst>
          <pc:docMk/>
          <pc:sldMk cId="931156729" sldId="287"/>
        </pc:sldMkLst>
        <pc:spChg chg="mod">
          <ac:chgData name="Miriam Schreiber" userId="5a452ff8-f189-44a9-9767-da59f69398bf" providerId="ADAL" clId="{C8A5F010-3663-4476-BC58-B0A281E6D435}" dt="2022-07-14T12:52:10.447" v="2429" actId="948"/>
          <ac:spMkLst>
            <pc:docMk/>
            <pc:sldMk cId="931156729" sldId="287"/>
            <ac:spMk id="6" creationId="{29551B27-21AC-4C8D-B0D4-A619BA82A16A}"/>
          </ac:spMkLst>
        </pc:spChg>
        <pc:picChg chg="mod">
          <ac:chgData name="Miriam Schreiber" userId="5a452ff8-f189-44a9-9767-da59f69398bf" providerId="ADAL" clId="{C8A5F010-3663-4476-BC58-B0A281E6D435}" dt="2022-07-14T12:51:41.098" v="2420" actId="1035"/>
          <ac:picMkLst>
            <pc:docMk/>
            <pc:sldMk cId="931156729" sldId="287"/>
            <ac:picMk id="3" creationId="{FB0D25DF-44E1-1455-3173-ED1902FC70EB}"/>
          </ac:picMkLst>
        </pc:picChg>
        <pc:picChg chg="mod">
          <ac:chgData name="Miriam Schreiber" userId="5a452ff8-f189-44a9-9767-da59f69398bf" providerId="ADAL" clId="{C8A5F010-3663-4476-BC58-B0A281E6D435}" dt="2022-07-14T12:51:34.120" v="2402" actId="1036"/>
          <ac:picMkLst>
            <pc:docMk/>
            <pc:sldMk cId="931156729" sldId="287"/>
            <ac:picMk id="11" creationId="{A124806D-CAAB-3FD4-CBE3-A5637F0BD1E3}"/>
          </ac:picMkLst>
        </pc:picChg>
        <pc:picChg chg="mod">
          <ac:chgData name="Miriam Schreiber" userId="5a452ff8-f189-44a9-9767-da59f69398bf" providerId="ADAL" clId="{C8A5F010-3663-4476-BC58-B0A281E6D435}" dt="2022-07-14T12:51:47.977" v="2426" actId="1036"/>
          <ac:picMkLst>
            <pc:docMk/>
            <pc:sldMk cId="931156729" sldId="287"/>
            <ac:picMk id="13" creationId="{FDAECFDB-B7F5-11E4-795C-A81C952D7481}"/>
          </ac:picMkLst>
        </pc:picChg>
      </pc:sldChg>
      <pc:sldChg chg="modSp mod">
        <pc:chgData name="Miriam Schreiber" userId="5a452ff8-f189-44a9-9767-da59f69398bf" providerId="ADAL" clId="{C8A5F010-3663-4476-BC58-B0A281E6D435}" dt="2022-07-14T12:53:32.085" v="2519" actId="1035"/>
        <pc:sldMkLst>
          <pc:docMk/>
          <pc:sldMk cId="539789028" sldId="288"/>
        </pc:sldMkLst>
        <pc:spChg chg="mod">
          <ac:chgData name="Miriam Schreiber" userId="5a452ff8-f189-44a9-9767-da59f69398bf" providerId="ADAL" clId="{C8A5F010-3663-4476-BC58-B0A281E6D435}" dt="2022-07-14T12:53:32.085" v="2519" actId="1035"/>
          <ac:spMkLst>
            <pc:docMk/>
            <pc:sldMk cId="539789028" sldId="288"/>
            <ac:spMk id="6" creationId="{45DEC47C-E0EE-41D9-95D9-3F6B1D862F69}"/>
          </ac:spMkLst>
        </pc:spChg>
        <pc:picChg chg="mod">
          <ac:chgData name="Miriam Schreiber" userId="5a452ff8-f189-44a9-9767-da59f69398bf" providerId="ADAL" clId="{C8A5F010-3663-4476-BC58-B0A281E6D435}" dt="2022-07-14T12:53:15.735" v="2500" actId="1036"/>
          <ac:picMkLst>
            <pc:docMk/>
            <pc:sldMk cId="539789028" sldId="288"/>
            <ac:picMk id="3" creationId="{47540FC1-1DD0-6DCF-579E-5143D1C03801}"/>
          </ac:picMkLst>
        </pc:picChg>
        <pc:picChg chg="mod">
          <ac:chgData name="Miriam Schreiber" userId="5a452ff8-f189-44a9-9767-da59f69398bf" providerId="ADAL" clId="{C8A5F010-3663-4476-BC58-B0A281E6D435}" dt="2022-07-14T12:53:12.305" v="2497" actId="1035"/>
          <ac:picMkLst>
            <pc:docMk/>
            <pc:sldMk cId="539789028" sldId="288"/>
            <ac:picMk id="11" creationId="{CB70B0BA-9B1B-A7CE-25E6-5344C7963C2F}"/>
          </ac:picMkLst>
        </pc:picChg>
        <pc:picChg chg="mod">
          <ac:chgData name="Miriam Schreiber" userId="5a452ff8-f189-44a9-9767-da59f69398bf" providerId="ADAL" clId="{C8A5F010-3663-4476-BC58-B0A281E6D435}" dt="2022-07-14T12:53:23.164" v="2511" actId="1035"/>
          <ac:picMkLst>
            <pc:docMk/>
            <pc:sldMk cId="539789028" sldId="288"/>
            <ac:picMk id="13" creationId="{EF39DC2B-1B81-C96D-53A3-F9DD454760EA}"/>
          </ac:picMkLst>
        </pc:picChg>
      </pc:sldChg>
      <pc:sldChg chg="modSp mod">
        <pc:chgData name="Miriam Schreiber" userId="5a452ff8-f189-44a9-9767-da59f69398bf" providerId="ADAL" clId="{C8A5F010-3663-4476-BC58-B0A281E6D435}" dt="2022-07-14T12:52:48.236" v="2477" actId="1036"/>
        <pc:sldMkLst>
          <pc:docMk/>
          <pc:sldMk cId="1050678150" sldId="289"/>
        </pc:sldMkLst>
        <pc:spChg chg="mod">
          <ac:chgData name="Miriam Schreiber" userId="5a452ff8-f189-44a9-9767-da59f69398bf" providerId="ADAL" clId="{C8A5F010-3663-4476-BC58-B0A281E6D435}" dt="2022-07-14T12:52:26.692" v="2441" actId="1038"/>
          <ac:spMkLst>
            <pc:docMk/>
            <pc:sldMk cId="1050678150" sldId="289"/>
            <ac:spMk id="6" creationId="{6BA0B57D-FB38-431E-A464-D415DFE34D74}"/>
          </ac:spMkLst>
        </pc:spChg>
        <pc:picChg chg="mod">
          <ac:chgData name="Miriam Schreiber" userId="5a452ff8-f189-44a9-9767-da59f69398bf" providerId="ADAL" clId="{C8A5F010-3663-4476-BC58-B0A281E6D435}" dt="2022-07-14T12:52:40.970" v="2465" actId="1036"/>
          <ac:picMkLst>
            <pc:docMk/>
            <pc:sldMk cId="1050678150" sldId="289"/>
            <ac:picMk id="3" creationId="{AA443AB4-BA2A-CAEF-A31F-BA8ACB0FDFC7}"/>
          </ac:picMkLst>
        </pc:picChg>
        <pc:picChg chg="mod">
          <ac:chgData name="Miriam Schreiber" userId="5a452ff8-f189-44a9-9767-da59f69398bf" providerId="ADAL" clId="{C8A5F010-3663-4476-BC58-B0A281E6D435}" dt="2022-07-14T12:52:34.109" v="2451" actId="1036"/>
          <ac:picMkLst>
            <pc:docMk/>
            <pc:sldMk cId="1050678150" sldId="289"/>
            <ac:picMk id="11" creationId="{FB39B434-4408-DFD0-7CD1-87D6D411C46B}"/>
          </ac:picMkLst>
        </pc:picChg>
        <pc:picChg chg="mod">
          <ac:chgData name="Miriam Schreiber" userId="5a452ff8-f189-44a9-9767-da59f69398bf" providerId="ADAL" clId="{C8A5F010-3663-4476-BC58-B0A281E6D435}" dt="2022-07-14T12:52:48.236" v="2477" actId="1036"/>
          <ac:picMkLst>
            <pc:docMk/>
            <pc:sldMk cId="1050678150" sldId="289"/>
            <ac:picMk id="13" creationId="{89019D0A-5298-E7E8-24DB-994F25FC9FF2}"/>
          </ac:picMkLst>
        </pc:picChg>
      </pc:sldChg>
      <pc:sldChg chg="modSp mod">
        <pc:chgData name="Miriam Schreiber" userId="5a452ff8-f189-44a9-9767-da59f69398bf" providerId="ADAL" clId="{C8A5F010-3663-4476-BC58-B0A281E6D435}" dt="2022-07-14T12:54:02.297" v="2553" actId="1036"/>
        <pc:sldMkLst>
          <pc:docMk/>
          <pc:sldMk cId="3331911335" sldId="290"/>
        </pc:sldMkLst>
        <pc:spChg chg="mod">
          <ac:chgData name="Miriam Schreiber" userId="5a452ff8-f189-44a9-9767-da59f69398bf" providerId="ADAL" clId="{C8A5F010-3663-4476-BC58-B0A281E6D435}" dt="2022-07-14T12:53:41.121" v="2522" actId="1035"/>
          <ac:spMkLst>
            <pc:docMk/>
            <pc:sldMk cId="3331911335" sldId="290"/>
            <ac:spMk id="6" creationId="{C3948DBD-C6BE-419C-9B95-12A5E92359EB}"/>
          </ac:spMkLst>
        </pc:spChg>
        <pc:picChg chg="mod">
          <ac:chgData name="Miriam Schreiber" userId="5a452ff8-f189-44a9-9767-da59f69398bf" providerId="ADAL" clId="{C8A5F010-3663-4476-BC58-B0A281E6D435}" dt="2022-07-14T12:53:55.695" v="2550" actId="1036"/>
          <ac:picMkLst>
            <pc:docMk/>
            <pc:sldMk cId="3331911335" sldId="290"/>
            <ac:picMk id="3" creationId="{46F0C0E1-A2FD-466F-119F-91AFE23FCAA1}"/>
          </ac:picMkLst>
        </pc:picChg>
        <pc:picChg chg="mod">
          <ac:chgData name="Miriam Schreiber" userId="5a452ff8-f189-44a9-9767-da59f69398bf" providerId="ADAL" clId="{C8A5F010-3663-4476-BC58-B0A281E6D435}" dt="2022-07-14T12:53:49.977" v="2537" actId="1036"/>
          <ac:picMkLst>
            <pc:docMk/>
            <pc:sldMk cId="3331911335" sldId="290"/>
            <ac:picMk id="11" creationId="{2C67E49F-AA63-3E88-F1EB-C28E4A485985}"/>
          </ac:picMkLst>
        </pc:picChg>
        <pc:picChg chg="mod">
          <ac:chgData name="Miriam Schreiber" userId="5a452ff8-f189-44a9-9767-da59f69398bf" providerId="ADAL" clId="{C8A5F010-3663-4476-BC58-B0A281E6D435}" dt="2022-07-14T12:54:02.297" v="2553" actId="1036"/>
          <ac:picMkLst>
            <pc:docMk/>
            <pc:sldMk cId="3331911335" sldId="290"/>
            <ac:picMk id="13" creationId="{1158E23F-877F-A98A-FEA0-AAEA03217289}"/>
          </ac:picMkLst>
        </pc:picChg>
      </pc:sldChg>
      <pc:sldChg chg="modSp mod">
        <pc:chgData name="Miriam Schreiber" userId="5a452ff8-f189-44a9-9767-da59f69398bf" providerId="ADAL" clId="{C8A5F010-3663-4476-BC58-B0A281E6D435}" dt="2022-07-14T12:55:14.389" v="2620" actId="1038"/>
        <pc:sldMkLst>
          <pc:docMk/>
          <pc:sldMk cId="73139265" sldId="291"/>
        </pc:sldMkLst>
        <pc:spChg chg="mod">
          <ac:chgData name="Miriam Schreiber" userId="5a452ff8-f189-44a9-9767-da59f69398bf" providerId="ADAL" clId="{C8A5F010-3663-4476-BC58-B0A281E6D435}" dt="2022-07-14T12:55:14.389" v="2620" actId="1038"/>
          <ac:spMkLst>
            <pc:docMk/>
            <pc:sldMk cId="73139265" sldId="291"/>
            <ac:spMk id="6" creationId="{DC5F5444-229F-4DD8-A4D1-94AA5FA88350}"/>
          </ac:spMkLst>
        </pc:spChg>
        <pc:picChg chg="mod">
          <ac:chgData name="Miriam Schreiber" userId="5a452ff8-f189-44a9-9767-da59f69398bf" providerId="ADAL" clId="{C8A5F010-3663-4476-BC58-B0A281E6D435}" dt="2022-07-14T12:54:40.894" v="2593" actId="1036"/>
          <ac:picMkLst>
            <pc:docMk/>
            <pc:sldMk cId="73139265" sldId="291"/>
            <ac:picMk id="3" creationId="{5811EC6E-51E6-244F-48F1-C812B5B64E92}"/>
          </ac:picMkLst>
        </pc:picChg>
        <pc:picChg chg="mod">
          <ac:chgData name="Miriam Schreiber" userId="5a452ff8-f189-44a9-9767-da59f69398bf" providerId="ADAL" clId="{C8A5F010-3663-4476-BC58-B0A281E6D435}" dt="2022-07-14T12:54:35.476" v="2578" actId="1036"/>
          <ac:picMkLst>
            <pc:docMk/>
            <pc:sldMk cId="73139265" sldId="291"/>
            <ac:picMk id="11" creationId="{86717E59-8D22-1C10-C4BA-01F6E75C63F7}"/>
          </ac:picMkLst>
        </pc:picChg>
        <pc:picChg chg="mod">
          <ac:chgData name="Miriam Schreiber" userId="5a452ff8-f189-44a9-9767-da59f69398bf" providerId="ADAL" clId="{C8A5F010-3663-4476-BC58-B0A281E6D435}" dt="2022-07-14T12:54:54.262" v="2601" actId="1036"/>
          <ac:picMkLst>
            <pc:docMk/>
            <pc:sldMk cId="73139265" sldId="291"/>
            <ac:picMk id="13" creationId="{4D8576EA-5C9E-0335-F17A-CCA326D89992}"/>
          </ac:picMkLst>
        </pc:picChg>
      </pc:sldChg>
      <pc:sldChg chg="modSp mod">
        <pc:chgData name="Miriam Schreiber" userId="5a452ff8-f189-44a9-9767-da59f69398bf" providerId="ADAL" clId="{C8A5F010-3663-4476-BC58-B0A281E6D435}" dt="2022-07-14T12:55:43.892" v="2656" actId="1036"/>
        <pc:sldMkLst>
          <pc:docMk/>
          <pc:sldMk cId="4231437813" sldId="292"/>
        </pc:sldMkLst>
        <pc:spChg chg="mod">
          <ac:chgData name="Miriam Schreiber" userId="5a452ff8-f189-44a9-9767-da59f69398bf" providerId="ADAL" clId="{C8A5F010-3663-4476-BC58-B0A281E6D435}" dt="2022-07-14T12:55:25.537" v="2628" actId="1036"/>
          <ac:spMkLst>
            <pc:docMk/>
            <pc:sldMk cId="4231437813" sldId="292"/>
            <ac:spMk id="6" creationId="{198441B3-0507-4896-85DE-F9FC8FB1E198}"/>
          </ac:spMkLst>
        </pc:spChg>
        <pc:picChg chg="mod">
          <ac:chgData name="Miriam Schreiber" userId="5a452ff8-f189-44a9-9767-da59f69398bf" providerId="ADAL" clId="{C8A5F010-3663-4476-BC58-B0A281E6D435}" dt="2022-07-14T12:55:37.196" v="2647" actId="1036"/>
          <ac:picMkLst>
            <pc:docMk/>
            <pc:sldMk cId="4231437813" sldId="292"/>
            <ac:picMk id="3" creationId="{07F4201E-1D0E-2C52-B2A3-769DCBE15830}"/>
          </ac:picMkLst>
        </pc:picChg>
        <pc:picChg chg="mod">
          <ac:chgData name="Miriam Schreiber" userId="5a452ff8-f189-44a9-9767-da59f69398bf" providerId="ADAL" clId="{C8A5F010-3663-4476-BC58-B0A281E6D435}" dt="2022-07-14T12:55:33.981" v="2645" actId="1036"/>
          <ac:picMkLst>
            <pc:docMk/>
            <pc:sldMk cId="4231437813" sldId="292"/>
            <ac:picMk id="11" creationId="{44589BCF-186C-89C6-80FB-10BF2987AA2D}"/>
          </ac:picMkLst>
        </pc:picChg>
        <pc:picChg chg="mod">
          <ac:chgData name="Miriam Schreiber" userId="5a452ff8-f189-44a9-9767-da59f69398bf" providerId="ADAL" clId="{C8A5F010-3663-4476-BC58-B0A281E6D435}" dt="2022-07-14T12:55:43.892" v="2656" actId="1036"/>
          <ac:picMkLst>
            <pc:docMk/>
            <pc:sldMk cId="4231437813" sldId="292"/>
            <ac:picMk id="13" creationId="{1FAB859D-8BE8-C325-DCD9-969C8DA712AD}"/>
          </ac:picMkLst>
        </pc:picChg>
      </pc:sldChg>
      <pc:sldChg chg="modSp mod">
        <pc:chgData name="Miriam Schreiber" userId="5a452ff8-f189-44a9-9767-da59f69398bf" providerId="ADAL" clId="{C8A5F010-3663-4476-BC58-B0A281E6D435}" dt="2022-07-14T12:56:24.020" v="2716" actId="1036"/>
        <pc:sldMkLst>
          <pc:docMk/>
          <pc:sldMk cId="2713121485" sldId="293"/>
        </pc:sldMkLst>
        <pc:spChg chg="mod">
          <ac:chgData name="Miriam Schreiber" userId="5a452ff8-f189-44a9-9767-da59f69398bf" providerId="ADAL" clId="{C8A5F010-3663-4476-BC58-B0A281E6D435}" dt="2022-07-14T12:56:24.020" v="2716" actId="1036"/>
          <ac:spMkLst>
            <pc:docMk/>
            <pc:sldMk cId="2713121485" sldId="293"/>
            <ac:spMk id="6" creationId="{0479FDC4-BCBE-43F0-808F-E583A72DA177}"/>
          </ac:spMkLst>
        </pc:spChg>
        <pc:picChg chg="mod">
          <ac:chgData name="Miriam Schreiber" userId="5a452ff8-f189-44a9-9767-da59f69398bf" providerId="ADAL" clId="{C8A5F010-3663-4476-BC58-B0A281E6D435}" dt="2022-07-14T12:56:01.506" v="2703" actId="1036"/>
          <ac:picMkLst>
            <pc:docMk/>
            <pc:sldMk cId="2713121485" sldId="293"/>
            <ac:picMk id="3" creationId="{B8711312-0060-7D9C-9626-89C25F1F90E5}"/>
          </ac:picMkLst>
        </pc:picChg>
        <pc:picChg chg="mod">
          <ac:chgData name="Miriam Schreiber" userId="5a452ff8-f189-44a9-9767-da59f69398bf" providerId="ADAL" clId="{C8A5F010-3663-4476-BC58-B0A281E6D435}" dt="2022-07-14T12:55:55.262" v="2678" actId="1036"/>
          <ac:picMkLst>
            <pc:docMk/>
            <pc:sldMk cId="2713121485" sldId="293"/>
            <ac:picMk id="11" creationId="{C141B540-1C74-3A33-7EF5-6EB04234ABEC}"/>
          </ac:picMkLst>
        </pc:picChg>
        <pc:picChg chg="mod">
          <ac:chgData name="Miriam Schreiber" userId="5a452ff8-f189-44a9-9767-da59f69398bf" providerId="ADAL" clId="{C8A5F010-3663-4476-BC58-B0A281E6D435}" dt="2022-07-14T12:56:06.842" v="2706" actId="1036"/>
          <ac:picMkLst>
            <pc:docMk/>
            <pc:sldMk cId="2713121485" sldId="293"/>
            <ac:picMk id="13" creationId="{21D18916-5F43-D07C-4B94-ACD8D96EF53A}"/>
          </ac:picMkLst>
        </pc:picChg>
      </pc:sldChg>
      <pc:sldChg chg="modSp mod">
        <pc:chgData name="Miriam Schreiber" userId="5a452ff8-f189-44a9-9767-da59f69398bf" providerId="ADAL" clId="{C8A5F010-3663-4476-BC58-B0A281E6D435}" dt="2022-07-14T12:56:54.593" v="2744" actId="1076"/>
        <pc:sldMkLst>
          <pc:docMk/>
          <pc:sldMk cId="506193483" sldId="294"/>
        </pc:sldMkLst>
        <pc:spChg chg="mod">
          <ac:chgData name="Miriam Schreiber" userId="5a452ff8-f189-44a9-9767-da59f69398bf" providerId="ADAL" clId="{C8A5F010-3663-4476-BC58-B0A281E6D435}" dt="2022-07-14T12:56:41.999" v="2730" actId="1038"/>
          <ac:spMkLst>
            <pc:docMk/>
            <pc:sldMk cId="506193483" sldId="294"/>
            <ac:spMk id="6" creationId="{130C1B92-07D8-4073-A888-F89A491A587F}"/>
          </ac:spMkLst>
        </pc:spChg>
        <pc:picChg chg="mod">
          <ac:chgData name="Miriam Schreiber" userId="5a452ff8-f189-44a9-9767-da59f69398bf" providerId="ADAL" clId="{C8A5F010-3663-4476-BC58-B0A281E6D435}" dt="2022-07-14T12:56:51.090" v="2743" actId="1036"/>
          <ac:picMkLst>
            <pc:docMk/>
            <pc:sldMk cId="506193483" sldId="294"/>
            <ac:picMk id="9" creationId="{05C2598B-45AF-3C2A-D417-4A357413EA9C}"/>
          </ac:picMkLst>
        </pc:picChg>
        <pc:picChg chg="mod">
          <ac:chgData name="Miriam Schreiber" userId="5a452ff8-f189-44a9-9767-da59f69398bf" providerId="ADAL" clId="{C8A5F010-3663-4476-BC58-B0A281E6D435}" dt="2022-07-14T12:56:47.259" v="2736" actId="1035"/>
          <ac:picMkLst>
            <pc:docMk/>
            <pc:sldMk cId="506193483" sldId="294"/>
            <ac:picMk id="13" creationId="{C50CF2E4-E2DC-E1B1-8316-390F45B4516F}"/>
          </ac:picMkLst>
        </pc:picChg>
        <pc:picChg chg="mod">
          <ac:chgData name="Miriam Schreiber" userId="5a452ff8-f189-44a9-9767-da59f69398bf" providerId="ADAL" clId="{C8A5F010-3663-4476-BC58-B0A281E6D435}" dt="2022-07-14T12:56:54.593" v="2744" actId="1076"/>
          <ac:picMkLst>
            <pc:docMk/>
            <pc:sldMk cId="506193483" sldId="294"/>
            <ac:picMk id="15" creationId="{E6FF2302-1540-7DEC-9CB3-0E1A3A6F16D1}"/>
          </ac:picMkLst>
        </pc:picChg>
      </pc:sldChg>
      <pc:sldChg chg="modSp mod">
        <pc:chgData name="Miriam Schreiber" userId="5a452ff8-f189-44a9-9767-da59f69398bf" providerId="ADAL" clId="{C8A5F010-3663-4476-BC58-B0A281E6D435}" dt="2022-07-14T12:57:37.098" v="2793" actId="1036"/>
        <pc:sldMkLst>
          <pc:docMk/>
          <pc:sldMk cId="2070099244" sldId="295"/>
        </pc:sldMkLst>
        <pc:spChg chg="mod">
          <ac:chgData name="Miriam Schreiber" userId="5a452ff8-f189-44a9-9767-da59f69398bf" providerId="ADAL" clId="{C8A5F010-3663-4476-BC58-B0A281E6D435}" dt="2022-07-14T12:57:14.396" v="2753" actId="1036"/>
          <ac:spMkLst>
            <pc:docMk/>
            <pc:sldMk cId="2070099244" sldId="295"/>
            <ac:spMk id="6" creationId="{81F84FA5-4009-476C-83EF-30BBFAA615D4}"/>
          </ac:spMkLst>
        </pc:spChg>
        <pc:picChg chg="mod">
          <ac:chgData name="Miriam Schreiber" userId="5a452ff8-f189-44a9-9767-da59f69398bf" providerId="ADAL" clId="{C8A5F010-3663-4476-BC58-B0A281E6D435}" dt="2022-07-14T12:57:26.733" v="2785" actId="1036"/>
          <ac:picMkLst>
            <pc:docMk/>
            <pc:sldMk cId="2070099244" sldId="295"/>
            <ac:picMk id="3" creationId="{18AB0D35-1670-28FF-6F36-68394AE6763B}"/>
          </ac:picMkLst>
        </pc:picChg>
        <pc:picChg chg="mod">
          <ac:chgData name="Miriam Schreiber" userId="5a452ff8-f189-44a9-9767-da59f69398bf" providerId="ADAL" clId="{C8A5F010-3663-4476-BC58-B0A281E6D435}" dt="2022-07-14T12:57:22.151" v="2775" actId="1036"/>
          <ac:picMkLst>
            <pc:docMk/>
            <pc:sldMk cId="2070099244" sldId="295"/>
            <ac:picMk id="11" creationId="{C4CC8DFE-8DF4-EC54-F7C5-3B7E973CFB0B}"/>
          </ac:picMkLst>
        </pc:picChg>
        <pc:picChg chg="mod">
          <ac:chgData name="Miriam Schreiber" userId="5a452ff8-f189-44a9-9767-da59f69398bf" providerId="ADAL" clId="{C8A5F010-3663-4476-BC58-B0A281E6D435}" dt="2022-07-14T12:57:37.098" v="2793" actId="1036"/>
          <ac:picMkLst>
            <pc:docMk/>
            <pc:sldMk cId="2070099244" sldId="295"/>
            <ac:picMk id="13" creationId="{EAC541A9-7BA6-C956-5C88-0426242A6E2D}"/>
          </ac:picMkLst>
        </pc:picChg>
      </pc:sldChg>
      <pc:sldChg chg="modSp mod">
        <pc:chgData name="Miriam Schreiber" userId="5a452ff8-f189-44a9-9767-da59f69398bf" providerId="ADAL" clId="{C8A5F010-3663-4476-BC58-B0A281E6D435}" dt="2022-07-14T12:58:21.302" v="2853" actId="1036"/>
        <pc:sldMkLst>
          <pc:docMk/>
          <pc:sldMk cId="484755535" sldId="296"/>
        </pc:sldMkLst>
        <pc:spChg chg="mod">
          <ac:chgData name="Miriam Schreiber" userId="5a452ff8-f189-44a9-9767-da59f69398bf" providerId="ADAL" clId="{C8A5F010-3663-4476-BC58-B0A281E6D435}" dt="2022-07-14T12:58:03.449" v="2806" actId="1036"/>
          <ac:spMkLst>
            <pc:docMk/>
            <pc:sldMk cId="484755535" sldId="296"/>
            <ac:spMk id="6" creationId="{3619BEF4-CDE0-44C7-BEB3-F61D38CD2286}"/>
          </ac:spMkLst>
        </pc:spChg>
        <pc:picChg chg="mod">
          <ac:chgData name="Miriam Schreiber" userId="5a452ff8-f189-44a9-9767-da59f69398bf" providerId="ADAL" clId="{C8A5F010-3663-4476-BC58-B0A281E6D435}" dt="2022-07-14T12:58:14.893" v="2833" actId="1035"/>
          <ac:picMkLst>
            <pc:docMk/>
            <pc:sldMk cId="484755535" sldId="296"/>
            <ac:picMk id="3" creationId="{95713251-D3E7-C265-B630-BA54A9F4B015}"/>
          </ac:picMkLst>
        </pc:picChg>
        <pc:picChg chg="mod">
          <ac:chgData name="Miriam Schreiber" userId="5a452ff8-f189-44a9-9767-da59f69398bf" providerId="ADAL" clId="{C8A5F010-3663-4476-BC58-B0A281E6D435}" dt="2022-07-14T12:58:21.302" v="2853" actId="1036"/>
          <ac:picMkLst>
            <pc:docMk/>
            <pc:sldMk cId="484755535" sldId="296"/>
            <ac:picMk id="11" creationId="{24D5CF86-7531-6EAB-0F29-DF190F285128}"/>
          </ac:picMkLst>
        </pc:picChg>
        <pc:picChg chg="mod">
          <ac:chgData name="Miriam Schreiber" userId="5a452ff8-f189-44a9-9767-da59f69398bf" providerId="ADAL" clId="{C8A5F010-3663-4476-BC58-B0A281E6D435}" dt="2022-07-14T12:58:08.604" v="2818" actId="1036"/>
          <ac:picMkLst>
            <pc:docMk/>
            <pc:sldMk cId="484755535" sldId="296"/>
            <ac:picMk id="13" creationId="{8BCA7E36-685A-D9F7-2C20-A478C694D8E7}"/>
          </ac:picMkLst>
        </pc:picChg>
      </pc:sldChg>
      <pc:sldChg chg="modSp mod">
        <pc:chgData name="Miriam Schreiber" userId="5a452ff8-f189-44a9-9767-da59f69398bf" providerId="ADAL" clId="{C8A5F010-3663-4476-BC58-B0A281E6D435}" dt="2022-07-14T12:58:52.918" v="2909" actId="1036"/>
        <pc:sldMkLst>
          <pc:docMk/>
          <pc:sldMk cId="3365079120" sldId="297"/>
        </pc:sldMkLst>
        <pc:spChg chg="mod">
          <ac:chgData name="Miriam Schreiber" userId="5a452ff8-f189-44a9-9767-da59f69398bf" providerId="ADAL" clId="{C8A5F010-3663-4476-BC58-B0A281E6D435}" dt="2022-07-14T12:58:36.157" v="2864" actId="1036"/>
          <ac:spMkLst>
            <pc:docMk/>
            <pc:sldMk cId="3365079120" sldId="297"/>
            <ac:spMk id="6" creationId="{42490F92-4741-4B45-9D0B-B2FD910B793A}"/>
          </ac:spMkLst>
        </pc:spChg>
        <pc:picChg chg="mod">
          <ac:chgData name="Miriam Schreiber" userId="5a452ff8-f189-44a9-9767-da59f69398bf" providerId="ADAL" clId="{C8A5F010-3663-4476-BC58-B0A281E6D435}" dt="2022-07-14T12:58:48.229" v="2901" actId="1036"/>
          <ac:picMkLst>
            <pc:docMk/>
            <pc:sldMk cId="3365079120" sldId="297"/>
            <ac:picMk id="3" creationId="{5A3AC009-0BB8-6EF1-F295-0B6389599335}"/>
          </ac:picMkLst>
        </pc:picChg>
        <pc:picChg chg="mod">
          <ac:chgData name="Miriam Schreiber" userId="5a452ff8-f189-44a9-9767-da59f69398bf" providerId="ADAL" clId="{C8A5F010-3663-4476-BC58-B0A281E6D435}" dt="2022-07-14T12:58:42.469" v="2882" actId="1036"/>
          <ac:picMkLst>
            <pc:docMk/>
            <pc:sldMk cId="3365079120" sldId="297"/>
            <ac:picMk id="11" creationId="{58C44D1C-2C8B-5073-F345-30D7C1515C3F}"/>
          </ac:picMkLst>
        </pc:picChg>
        <pc:picChg chg="mod">
          <ac:chgData name="Miriam Schreiber" userId="5a452ff8-f189-44a9-9767-da59f69398bf" providerId="ADAL" clId="{C8A5F010-3663-4476-BC58-B0A281E6D435}" dt="2022-07-14T12:58:52.918" v="2909" actId="1036"/>
          <ac:picMkLst>
            <pc:docMk/>
            <pc:sldMk cId="3365079120" sldId="297"/>
            <ac:picMk id="13" creationId="{3B11695D-949B-26D1-05FF-64DEBA9C7347}"/>
          </ac:picMkLst>
        </pc:picChg>
      </pc:sldChg>
      <pc:sldChg chg="modSp mod">
        <pc:chgData name="Miriam Schreiber" userId="5a452ff8-f189-44a9-9767-da59f69398bf" providerId="ADAL" clId="{C8A5F010-3663-4476-BC58-B0A281E6D435}" dt="2022-07-14T12:59:33.383" v="2955" actId="1076"/>
        <pc:sldMkLst>
          <pc:docMk/>
          <pc:sldMk cId="280178470" sldId="298"/>
        </pc:sldMkLst>
        <pc:spChg chg="mod">
          <ac:chgData name="Miriam Schreiber" userId="5a452ff8-f189-44a9-9767-da59f69398bf" providerId="ADAL" clId="{C8A5F010-3663-4476-BC58-B0A281E6D435}" dt="2022-07-14T12:59:18.061" v="2928" actId="1036"/>
          <ac:spMkLst>
            <pc:docMk/>
            <pc:sldMk cId="280178470" sldId="298"/>
            <ac:spMk id="6" creationId="{0BE2C3CA-D998-4693-893F-7AF02B152E7C}"/>
          </ac:spMkLst>
        </pc:spChg>
        <pc:picChg chg="mod">
          <ac:chgData name="Miriam Schreiber" userId="5a452ff8-f189-44a9-9767-da59f69398bf" providerId="ADAL" clId="{C8A5F010-3663-4476-BC58-B0A281E6D435}" dt="2022-07-14T12:59:29.532" v="2954" actId="1036"/>
          <ac:picMkLst>
            <pc:docMk/>
            <pc:sldMk cId="280178470" sldId="298"/>
            <ac:picMk id="3" creationId="{61DA001C-354F-1D3E-69F0-9ACA5C18623C}"/>
          </ac:picMkLst>
        </pc:picChg>
        <pc:picChg chg="mod">
          <ac:chgData name="Miriam Schreiber" userId="5a452ff8-f189-44a9-9767-da59f69398bf" providerId="ADAL" clId="{C8A5F010-3663-4476-BC58-B0A281E6D435}" dt="2022-07-14T12:59:25.721" v="2946" actId="1036"/>
          <ac:picMkLst>
            <pc:docMk/>
            <pc:sldMk cId="280178470" sldId="298"/>
            <ac:picMk id="11" creationId="{EF2DD855-5BF3-7AC1-B7A2-869961F85B60}"/>
          </ac:picMkLst>
        </pc:picChg>
        <pc:picChg chg="mod">
          <ac:chgData name="Miriam Schreiber" userId="5a452ff8-f189-44a9-9767-da59f69398bf" providerId="ADAL" clId="{C8A5F010-3663-4476-BC58-B0A281E6D435}" dt="2022-07-14T12:59:33.383" v="2955" actId="1076"/>
          <ac:picMkLst>
            <pc:docMk/>
            <pc:sldMk cId="280178470" sldId="298"/>
            <ac:picMk id="13" creationId="{FEFC7E3C-56D5-79ED-EAC9-A655782F8B13}"/>
          </ac:picMkLst>
        </pc:picChg>
      </pc:sldChg>
      <pc:sldChg chg="modSp mod">
        <pc:chgData name="Miriam Schreiber" userId="5a452ff8-f189-44a9-9767-da59f69398bf" providerId="ADAL" clId="{C8A5F010-3663-4476-BC58-B0A281E6D435}" dt="2022-07-14T13:01:48.215" v="3094" actId="1036"/>
        <pc:sldMkLst>
          <pc:docMk/>
          <pc:sldMk cId="3142224386" sldId="299"/>
        </pc:sldMkLst>
        <pc:spChg chg="mod">
          <ac:chgData name="Miriam Schreiber" userId="5a452ff8-f189-44a9-9767-da59f69398bf" providerId="ADAL" clId="{C8A5F010-3663-4476-BC58-B0A281E6D435}" dt="2022-07-14T12:59:45.986" v="2964" actId="1038"/>
          <ac:spMkLst>
            <pc:docMk/>
            <pc:sldMk cId="3142224386" sldId="299"/>
            <ac:spMk id="6" creationId="{5B5BE085-694D-40D2-8783-30083CDD095A}"/>
          </ac:spMkLst>
        </pc:spChg>
        <pc:picChg chg="mod">
          <ac:chgData name="Miriam Schreiber" userId="5a452ff8-f189-44a9-9767-da59f69398bf" providerId="ADAL" clId="{C8A5F010-3663-4476-BC58-B0A281E6D435}" dt="2022-07-14T12:59:58.020" v="3000" actId="1036"/>
          <ac:picMkLst>
            <pc:docMk/>
            <pc:sldMk cId="3142224386" sldId="299"/>
            <ac:picMk id="3" creationId="{AC5C9FB0-4B17-52E6-7081-3EAEF13CA820}"/>
          </ac:picMkLst>
        </pc:picChg>
        <pc:picChg chg="mod">
          <ac:chgData name="Miriam Schreiber" userId="5a452ff8-f189-44a9-9767-da59f69398bf" providerId="ADAL" clId="{C8A5F010-3663-4476-BC58-B0A281E6D435}" dt="2022-07-14T13:01:48.215" v="3094" actId="1036"/>
          <ac:picMkLst>
            <pc:docMk/>
            <pc:sldMk cId="3142224386" sldId="299"/>
            <ac:picMk id="11" creationId="{00BDF3AE-9387-8ACC-463F-A4906D5C6693}"/>
          </ac:picMkLst>
        </pc:picChg>
        <pc:picChg chg="mod">
          <ac:chgData name="Miriam Schreiber" userId="5a452ff8-f189-44a9-9767-da59f69398bf" providerId="ADAL" clId="{C8A5F010-3663-4476-BC58-B0A281E6D435}" dt="2022-07-14T13:00:02.426" v="3003" actId="1036"/>
          <ac:picMkLst>
            <pc:docMk/>
            <pc:sldMk cId="3142224386" sldId="299"/>
            <ac:picMk id="13" creationId="{5D70947F-A684-99FE-F74A-EDE9EB8AEA51}"/>
          </ac:picMkLst>
        </pc:picChg>
      </pc:sldChg>
      <pc:sldChg chg="modSp mod">
        <pc:chgData name="Miriam Schreiber" userId="5a452ff8-f189-44a9-9767-da59f69398bf" providerId="ADAL" clId="{C8A5F010-3663-4476-BC58-B0A281E6D435}" dt="2022-07-14T13:00:48.220" v="3082" actId="1036"/>
        <pc:sldMkLst>
          <pc:docMk/>
          <pc:sldMk cId="1459853529" sldId="300"/>
        </pc:sldMkLst>
        <pc:spChg chg="mod">
          <ac:chgData name="Miriam Schreiber" userId="5a452ff8-f189-44a9-9767-da59f69398bf" providerId="ADAL" clId="{C8A5F010-3663-4476-BC58-B0A281E6D435}" dt="2022-07-14T13:00:28.564" v="3020" actId="1035"/>
          <ac:spMkLst>
            <pc:docMk/>
            <pc:sldMk cId="1459853529" sldId="300"/>
            <ac:spMk id="4" creationId="{8E35EAFF-1F7A-40BD-9AE3-064739B11890}"/>
          </ac:spMkLst>
        </pc:spChg>
        <pc:picChg chg="mod">
          <ac:chgData name="Miriam Schreiber" userId="5a452ff8-f189-44a9-9767-da59f69398bf" providerId="ADAL" clId="{C8A5F010-3663-4476-BC58-B0A281E6D435}" dt="2022-07-14T13:00:41.654" v="3066" actId="1036"/>
          <ac:picMkLst>
            <pc:docMk/>
            <pc:sldMk cId="1459853529" sldId="300"/>
            <ac:picMk id="3" creationId="{633F1B87-2741-52E3-8D43-F83561C3E525}"/>
          </ac:picMkLst>
        </pc:picChg>
        <pc:picChg chg="mod">
          <ac:chgData name="Miriam Schreiber" userId="5a452ff8-f189-44a9-9767-da59f69398bf" providerId="ADAL" clId="{C8A5F010-3663-4476-BC58-B0A281E6D435}" dt="2022-07-14T13:00:34.828" v="3041" actId="1036"/>
          <ac:picMkLst>
            <pc:docMk/>
            <pc:sldMk cId="1459853529" sldId="300"/>
            <ac:picMk id="11" creationId="{5CD3EBDB-2A4B-412B-46E6-7131AC16782D}"/>
          </ac:picMkLst>
        </pc:picChg>
        <pc:picChg chg="mod">
          <ac:chgData name="Miriam Schreiber" userId="5a452ff8-f189-44a9-9767-da59f69398bf" providerId="ADAL" clId="{C8A5F010-3663-4476-BC58-B0A281E6D435}" dt="2022-07-14T13:00:48.220" v="3082" actId="1036"/>
          <ac:picMkLst>
            <pc:docMk/>
            <pc:sldMk cId="1459853529" sldId="300"/>
            <ac:picMk id="13" creationId="{2671CF16-8C15-3B03-3464-460B935FA079}"/>
          </ac:picMkLst>
        </pc:picChg>
      </pc:sldChg>
      <pc:sldChg chg="addSp delSp modSp mod">
        <pc:chgData name="Miriam Schreiber" userId="5a452ff8-f189-44a9-9767-da59f69398bf" providerId="ADAL" clId="{C8A5F010-3663-4476-BC58-B0A281E6D435}" dt="2022-07-14T13:08:38.807" v="3179" actId="1036"/>
        <pc:sldMkLst>
          <pc:docMk/>
          <pc:sldMk cId="2366946141" sldId="301"/>
        </pc:sldMkLst>
        <pc:spChg chg="mod">
          <ac:chgData name="Miriam Schreiber" userId="5a452ff8-f189-44a9-9767-da59f69398bf" providerId="ADAL" clId="{C8A5F010-3663-4476-BC58-B0A281E6D435}" dt="2022-07-14T13:02:44.672" v="3104" actId="1036"/>
          <ac:spMkLst>
            <pc:docMk/>
            <pc:sldMk cId="2366946141" sldId="301"/>
            <ac:spMk id="4" creationId="{C913E983-3A5B-4588-9231-7C0D46B5454C}"/>
          </ac:spMkLst>
        </pc:spChg>
        <pc:spChg chg="mod">
          <ac:chgData name="Miriam Schreiber" userId="5a452ff8-f189-44a9-9767-da59f69398bf" providerId="ADAL" clId="{C8A5F010-3663-4476-BC58-B0A281E6D435}" dt="2022-07-14T13:02:25.329" v="3096" actId="207"/>
          <ac:spMkLst>
            <pc:docMk/>
            <pc:sldMk cId="2366946141" sldId="301"/>
            <ac:spMk id="6" creationId="{5413F4E4-BAE6-4EED-81EB-36CF44E09120}"/>
          </ac:spMkLst>
        </pc:spChg>
        <pc:picChg chg="del mod">
          <ac:chgData name="Miriam Schreiber" userId="5a452ff8-f189-44a9-9767-da59f69398bf" providerId="ADAL" clId="{C8A5F010-3663-4476-BC58-B0A281E6D435}" dt="2022-07-14T13:06:58.831" v="3145" actId="478"/>
          <ac:picMkLst>
            <pc:docMk/>
            <pc:sldMk cId="2366946141" sldId="301"/>
            <ac:picMk id="3" creationId="{6DDFEF0A-D359-422E-B0EF-5C9B8D56C6F6}"/>
          </ac:picMkLst>
        </pc:picChg>
        <pc:picChg chg="add mod">
          <ac:chgData name="Miriam Schreiber" userId="5a452ff8-f189-44a9-9767-da59f69398bf" providerId="ADAL" clId="{C8A5F010-3663-4476-BC58-B0A281E6D435}" dt="2022-07-14T13:07:16.596" v="3164" actId="1035"/>
          <ac:picMkLst>
            <pc:docMk/>
            <pc:sldMk cId="2366946141" sldId="301"/>
            <ac:picMk id="5" creationId="{D47D7C18-F1AC-7666-4B4B-91FCE7C9E4F2}"/>
          </ac:picMkLst>
        </pc:picChg>
        <pc:picChg chg="add mod">
          <ac:chgData name="Miriam Schreiber" userId="5a452ff8-f189-44a9-9767-da59f69398bf" providerId="ADAL" clId="{C8A5F010-3663-4476-BC58-B0A281E6D435}" dt="2022-07-14T13:08:38.807" v="3179" actId="1036"/>
          <ac:picMkLst>
            <pc:docMk/>
            <pc:sldMk cId="2366946141" sldId="301"/>
            <ac:picMk id="8" creationId="{D9084593-8D7C-CE3B-C614-085B0F1C347D}"/>
          </ac:picMkLst>
        </pc:picChg>
        <pc:picChg chg="mod">
          <ac:chgData name="Miriam Schreiber" userId="5a452ff8-f189-44a9-9767-da59f69398bf" providerId="ADAL" clId="{C8A5F010-3663-4476-BC58-B0A281E6D435}" dt="2022-07-14T13:03:08.382" v="3144" actId="1036"/>
          <ac:picMkLst>
            <pc:docMk/>
            <pc:sldMk cId="2366946141" sldId="301"/>
            <ac:picMk id="15" creationId="{1B5CEFBC-38D2-CCDC-A433-E308FBDCC0E8}"/>
          </ac:picMkLst>
        </pc:picChg>
        <pc:picChg chg="mod">
          <ac:chgData name="Miriam Schreiber" userId="5a452ff8-f189-44a9-9767-da59f69398bf" providerId="ADAL" clId="{C8A5F010-3663-4476-BC58-B0A281E6D435}" dt="2022-07-14T13:02:57.376" v="3124" actId="1036"/>
          <ac:picMkLst>
            <pc:docMk/>
            <pc:sldMk cId="2366946141" sldId="301"/>
            <ac:picMk id="17" creationId="{B059A20C-5A1F-13B8-600F-6D1C15FA03EB}"/>
          </ac:picMkLst>
        </pc:picChg>
      </pc:sldChg>
      <pc:sldChg chg="modSp mod">
        <pc:chgData name="Miriam Schreiber" userId="5a452ff8-f189-44a9-9767-da59f69398bf" providerId="ADAL" clId="{C8A5F010-3663-4476-BC58-B0A281E6D435}" dt="2022-07-14T13:09:36.982" v="3253" actId="1037"/>
        <pc:sldMkLst>
          <pc:docMk/>
          <pc:sldMk cId="1889800891" sldId="302"/>
        </pc:sldMkLst>
        <pc:spChg chg="mod">
          <ac:chgData name="Miriam Schreiber" userId="5a452ff8-f189-44a9-9767-da59f69398bf" providerId="ADAL" clId="{C8A5F010-3663-4476-BC58-B0A281E6D435}" dt="2022-07-14T13:09:36.982" v="3253" actId="1037"/>
          <ac:spMkLst>
            <pc:docMk/>
            <pc:sldMk cId="1889800891" sldId="302"/>
            <ac:spMk id="4" creationId="{47946B4A-CC15-4624-A58A-3DCA03F0E43A}"/>
          </ac:spMkLst>
        </pc:spChg>
        <pc:picChg chg="mod">
          <ac:chgData name="Miriam Schreiber" userId="5a452ff8-f189-44a9-9767-da59f69398bf" providerId="ADAL" clId="{C8A5F010-3663-4476-BC58-B0A281E6D435}" dt="2022-07-14T13:09:15.714" v="3242" actId="1035"/>
          <ac:picMkLst>
            <pc:docMk/>
            <pc:sldMk cId="1889800891" sldId="302"/>
            <ac:picMk id="9" creationId="{AA3D9B4F-C3E5-F0E7-1B7E-414C7251E7A0}"/>
          </ac:picMkLst>
        </pc:picChg>
        <pc:picChg chg="mod">
          <ac:chgData name="Miriam Schreiber" userId="5a452ff8-f189-44a9-9767-da59f69398bf" providerId="ADAL" clId="{C8A5F010-3663-4476-BC58-B0A281E6D435}" dt="2022-07-14T13:09:07.126" v="3202" actId="1036"/>
          <ac:picMkLst>
            <pc:docMk/>
            <pc:sldMk cId="1889800891" sldId="302"/>
            <ac:picMk id="13" creationId="{EB562AB5-D748-6DD0-D72D-0563BAACF3DC}"/>
          </ac:picMkLst>
        </pc:picChg>
        <pc:picChg chg="mod">
          <ac:chgData name="Miriam Schreiber" userId="5a452ff8-f189-44a9-9767-da59f69398bf" providerId="ADAL" clId="{C8A5F010-3663-4476-BC58-B0A281E6D435}" dt="2022-07-14T13:09:22.463" v="3252" actId="1035"/>
          <ac:picMkLst>
            <pc:docMk/>
            <pc:sldMk cId="1889800891" sldId="302"/>
            <ac:picMk id="15" creationId="{E65F64EF-AEF7-D3DE-6BC0-45D4D831A88B}"/>
          </ac:picMkLst>
        </pc:picChg>
      </pc:sldChg>
      <pc:sldChg chg="modSp mod">
        <pc:chgData name="Miriam Schreiber" userId="5a452ff8-f189-44a9-9767-da59f69398bf" providerId="ADAL" clId="{C8A5F010-3663-4476-BC58-B0A281E6D435}" dt="2022-07-14T13:10:19.297" v="3312" actId="1035"/>
        <pc:sldMkLst>
          <pc:docMk/>
          <pc:sldMk cId="386663992" sldId="303"/>
        </pc:sldMkLst>
        <pc:spChg chg="mod">
          <ac:chgData name="Miriam Schreiber" userId="5a452ff8-f189-44a9-9767-da59f69398bf" providerId="ADAL" clId="{C8A5F010-3663-4476-BC58-B0A281E6D435}" dt="2022-07-14T13:10:01.287" v="3269" actId="1038"/>
          <ac:spMkLst>
            <pc:docMk/>
            <pc:sldMk cId="386663992" sldId="303"/>
            <ac:spMk id="4" creationId="{8CE0BCD6-3484-4113-9CA4-F18477475A33}"/>
          </ac:spMkLst>
        </pc:spChg>
        <pc:picChg chg="mod">
          <ac:chgData name="Miriam Schreiber" userId="5a452ff8-f189-44a9-9767-da59f69398bf" providerId="ADAL" clId="{C8A5F010-3663-4476-BC58-B0A281E6D435}" dt="2022-07-14T13:10:15.071" v="3309" actId="1036"/>
          <ac:picMkLst>
            <pc:docMk/>
            <pc:sldMk cId="386663992" sldId="303"/>
            <ac:picMk id="3" creationId="{C5C6AB75-25DE-FB1A-5BFC-AD2A780C5216}"/>
          </ac:picMkLst>
        </pc:picChg>
        <pc:picChg chg="mod">
          <ac:chgData name="Miriam Schreiber" userId="5a452ff8-f189-44a9-9767-da59f69398bf" providerId="ADAL" clId="{C8A5F010-3663-4476-BC58-B0A281E6D435}" dt="2022-07-14T13:10:10.213" v="3296" actId="1036"/>
          <ac:picMkLst>
            <pc:docMk/>
            <pc:sldMk cId="386663992" sldId="303"/>
            <ac:picMk id="11" creationId="{C32823F1-0899-52BE-E99D-4B50548CC14C}"/>
          </ac:picMkLst>
        </pc:picChg>
        <pc:picChg chg="mod">
          <ac:chgData name="Miriam Schreiber" userId="5a452ff8-f189-44a9-9767-da59f69398bf" providerId="ADAL" clId="{C8A5F010-3663-4476-BC58-B0A281E6D435}" dt="2022-07-14T13:10:19.297" v="3312" actId="1035"/>
          <ac:picMkLst>
            <pc:docMk/>
            <pc:sldMk cId="386663992" sldId="303"/>
            <ac:picMk id="13" creationId="{EA956D70-BD22-3483-5E46-E017BDE25EC0}"/>
          </ac:picMkLst>
        </pc:picChg>
      </pc:sldChg>
      <pc:sldChg chg="modSp mod">
        <pc:chgData name="Miriam Schreiber" userId="5a452ff8-f189-44a9-9767-da59f69398bf" providerId="ADAL" clId="{C8A5F010-3663-4476-BC58-B0A281E6D435}" dt="2022-07-14T13:10:59.257" v="3354" actId="1035"/>
        <pc:sldMkLst>
          <pc:docMk/>
          <pc:sldMk cId="427213959" sldId="304"/>
        </pc:sldMkLst>
        <pc:spChg chg="mod">
          <ac:chgData name="Miriam Schreiber" userId="5a452ff8-f189-44a9-9767-da59f69398bf" providerId="ADAL" clId="{C8A5F010-3663-4476-BC58-B0A281E6D435}" dt="2022-07-14T13:10:54.112" v="3345" actId="948"/>
          <ac:spMkLst>
            <pc:docMk/>
            <pc:sldMk cId="427213959" sldId="304"/>
            <ac:spMk id="8" creationId="{42617D10-8537-4EF9-BFCF-A18BA6062DC6}"/>
          </ac:spMkLst>
        </pc:spChg>
        <pc:picChg chg="mod">
          <ac:chgData name="Miriam Schreiber" userId="5a452ff8-f189-44a9-9767-da59f69398bf" providerId="ADAL" clId="{C8A5F010-3663-4476-BC58-B0A281E6D435}" dt="2022-07-14T13:10:45.142" v="3344" actId="1036"/>
          <ac:picMkLst>
            <pc:docMk/>
            <pc:sldMk cId="427213959" sldId="304"/>
            <ac:picMk id="3" creationId="{017553FA-69BF-D68B-BD8D-545F0DD14EE8}"/>
          </ac:picMkLst>
        </pc:picChg>
        <pc:picChg chg="mod">
          <ac:chgData name="Miriam Schreiber" userId="5a452ff8-f189-44a9-9767-da59f69398bf" providerId="ADAL" clId="{C8A5F010-3663-4476-BC58-B0A281E6D435}" dt="2022-07-14T13:10:40.233" v="3330" actId="1035"/>
          <ac:picMkLst>
            <pc:docMk/>
            <pc:sldMk cId="427213959" sldId="304"/>
            <ac:picMk id="11" creationId="{7FE8B90D-38C2-7040-E73E-2C32834DE247}"/>
          </ac:picMkLst>
        </pc:picChg>
        <pc:picChg chg="mod">
          <ac:chgData name="Miriam Schreiber" userId="5a452ff8-f189-44a9-9767-da59f69398bf" providerId="ADAL" clId="{C8A5F010-3663-4476-BC58-B0A281E6D435}" dt="2022-07-14T13:10:59.257" v="3354" actId="1035"/>
          <ac:picMkLst>
            <pc:docMk/>
            <pc:sldMk cId="427213959" sldId="304"/>
            <ac:picMk id="13" creationId="{7EB6A0CA-77B2-CDC0-C7D1-C2A2B4351773}"/>
          </ac:picMkLst>
        </pc:picChg>
      </pc:sldChg>
      <pc:sldChg chg="modSp mod">
        <pc:chgData name="Miriam Schreiber" userId="5a452ff8-f189-44a9-9767-da59f69398bf" providerId="ADAL" clId="{C8A5F010-3663-4476-BC58-B0A281E6D435}" dt="2022-07-14T13:11:29.629" v="3432" actId="1036"/>
        <pc:sldMkLst>
          <pc:docMk/>
          <pc:sldMk cId="1375688946" sldId="305"/>
        </pc:sldMkLst>
        <pc:spChg chg="mod">
          <ac:chgData name="Miriam Schreiber" userId="5a452ff8-f189-44a9-9767-da59f69398bf" providerId="ADAL" clId="{C8A5F010-3663-4476-BC58-B0A281E6D435}" dt="2022-07-14T13:11:08.728" v="3366" actId="1036"/>
          <ac:spMkLst>
            <pc:docMk/>
            <pc:sldMk cId="1375688946" sldId="305"/>
            <ac:spMk id="8" creationId="{15FE1ED8-5A33-4EC1-96FA-F708FF405EA0}"/>
          </ac:spMkLst>
        </pc:spChg>
        <pc:picChg chg="mod">
          <ac:chgData name="Miriam Schreiber" userId="5a452ff8-f189-44a9-9767-da59f69398bf" providerId="ADAL" clId="{C8A5F010-3663-4476-BC58-B0A281E6D435}" dt="2022-07-14T13:11:24.351" v="3423" actId="1036"/>
          <ac:picMkLst>
            <pc:docMk/>
            <pc:sldMk cId="1375688946" sldId="305"/>
            <ac:picMk id="4" creationId="{73F6E4D5-78B4-8431-696A-586045994EA7}"/>
          </ac:picMkLst>
        </pc:picChg>
        <pc:picChg chg="mod">
          <ac:chgData name="Miriam Schreiber" userId="5a452ff8-f189-44a9-9767-da59f69398bf" providerId="ADAL" clId="{C8A5F010-3663-4476-BC58-B0A281E6D435}" dt="2022-07-14T13:11:29.629" v="3432" actId="1036"/>
          <ac:picMkLst>
            <pc:docMk/>
            <pc:sldMk cId="1375688946" sldId="305"/>
            <ac:picMk id="11" creationId="{0360566B-F9C1-5CD1-270D-59B76816AEB3}"/>
          </ac:picMkLst>
        </pc:picChg>
        <pc:picChg chg="mod">
          <ac:chgData name="Miriam Schreiber" userId="5a452ff8-f189-44a9-9767-da59f69398bf" providerId="ADAL" clId="{C8A5F010-3663-4476-BC58-B0A281E6D435}" dt="2022-07-14T13:11:17.097" v="3392" actId="1036"/>
          <ac:picMkLst>
            <pc:docMk/>
            <pc:sldMk cId="1375688946" sldId="305"/>
            <ac:picMk id="13" creationId="{C0B6DAFF-81C8-D5FE-D38D-1B996772D223}"/>
          </ac:picMkLst>
        </pc:picChg>
      </pc:sldChg>
      <pc:sldChg chg="delSp modSp mod">
        <pc:chgData name="Miriam Schreiber" userId="5a452ff8-f189-44a9-9767-da59f69398bf" providerId="ADAL" clId="{C8A5F010-3663-4476-BC58-B0A281E6D435}" dt="2022-07-27T10:33:07.396" v="3963" actId="1076"/>
        <pc:sldMkLst>
          <pc:docMk/>
          <pc:sldMk cId="1251862347" sldId="306"/>
        </pc:sldMkLst>
        <pc:spChg chg="mod">
          <ac:chgData name="Miriam Schreiber" userId="5a452ff8-f189-44a9-9767-da59f69398bf" providerId="ADAL" clId="{C8A5F010-3663-4476-BC58-B0A281E6D435}" dt="2022-07-27T10:33:07.396" v="3963" actId="1076"/>
          <ac:spMkLst>
            <pc:docMk/>
            <pc:sldMk cId="1251862347" sldId="306"/>
            <ac:spMk id="2" creationId="{6788BF9D-8D7A-44BE-9892-A00E38126BAE}"/>
          </ac:spMkLst>
        </pc:spChg>
        <pc:spChg chg="del">
          <ac:chgData name="Miriam Schreiber" userId="5a452ff8-f189-44a9-9767-da59f69398bf" providerId="ADAL" clId="{C8A5F010-3663-4476-BC58-B0A281E6D435}" dt="2022-07-27T10:29:26.100" v="3465" actId="478"/>
          <ac:spMkLst>
            <pc:docMk/>
            <pc:sldMk cId="1251862347" sldId="306"/>
            <ac:spMk id="3" creationId="{54CE2834-6AC5-479D-AA7C-1212CBDC4DE0}"/>
          </ac:spMkLst>
        </pc:spChg>
      </pc:sldChg>
    </pc:docChg>
  </pc:docChgLst>
  <pc:docChgLst>
    <pc:chgData name="Miriam Schreiber" userId="5a452ff8-f189-44a9-9767-da59f69398bf" providerId="ADAL" clId="{7A8111AC-5017-4CF1-AB1B-6A71CD7BFCD8}"/>
    <pc:docChg chg="undo redo custSel addSld delSld modSld sldOrd">
      <pc:chgData name="Miriam Schreiber" userId="5a452ff8-f189-44a9-9767-da59f69398bf" providerId="ADAL" clId="{7A8111AC-5017-4CF1-AB1B-6A71CD7BFCD8}" dt="2022-05-01T15:12:30.139" v="3736" actId="20577"/>
      <pc:docMkLst>
        <pc:docMk/>
      </pc:docMkLst>
      <pc:sldChg chg="addSp delSp modSp new mod">
        <pc:chgData name="Miriam Schreiber" userId="5a452ff8-f189-44a9-9767-da59f69398bf" providerId="ADAL" clId="{7A8111AC-5017-4CF1-AB1B-6A71CD7BFCD8}" dt="2022-05-01T14:59:45.893" v="3176" actId="1036"/>
        <pc:sldMkLst>
          <pc:docMk/>
          <pc:sldMk cId="3354761709" sldId="256"/>
        </pc:sldMkLst>
        <pc:spChg chg="del">
          <ac:chgData name="Miriam Schreiber" userId="5a452ff8-f189-44a9-9767-da59f69398bf" providerId="ADAL" clId="{7A8111AC-5017-4CF1-AB1B-6A71CD7BFCD8}" dt="2022-04-29T12:37:37.402" v="109" actId="478"/>
          <ac:spMkLst>
            <pc:docMk/>
            <pc:sldMk cId="3354761709" sldId="256"/>
            <ac:spMk id="2" creationId="{15E50C5C-C14B-4A1F-931E-6EB0A1E6E7CA}"/>
          </ac:spMkLst>
        </pc:spChg>
        <pc:spChg chg="del">
          <ac:chgData name="Miriam Schreiber" userId="5a452ff8-f189-44a9-9767-da59f69398bf" providerId="ADAL" clId="{7A8111AC-5017-4CF1-AB1B-6A71CD7BFCD8}" dt="2022-04-29T12:37:44.256" v="110" actId="478"/>
          <ac:spMkLst>
            <pc:docMk/>
            <pc:sldMk cId="3354761709" sldId="256"/>
            <ac:spMk id="3" creationId="{F1BDF947-4E23-4B63-BBEF-CE60BAEA21DD}"/>
          </ac:spMkLst>
        </pc:spChg>
        <pc:spChg chg="add mod">
          <ac:chgData name="Miriam Schreiber" userId="5a452ff8-f189-44a9-9767-da59f69398bf" providerId="ADAL" clId="{7A8111AC-5017-4CF1-AB1B-6A71CD7BFCD8}" dt="2022-05-01T14:59:13.459" v="3162" actId="20577"/>
          <ac:spMkLst>
            <pc:docMk/>
            <pc:sldMk cId="3354761709" sldId="256"/>
            <ac:spMk id="4" creationId="{4D194A9A-FA82-4B66-899B-251F60ACC329}"/>
          </ac:spMkLst>
        </pc:spChg>
        <pc:spChg chg="add del mod">
          <ac:chgData name="Miriam Schreiber" userId="5a452ff8-f189-44a9-9767-da59f69398bf" providerId="ADAL" clId="{7A8111AC-5017-4CF1-AB1B-6A71CD7BFCD8}" dt="2022-05-01T14:59:15.777" v="3163" actId="478"/>
          <ac:spMkLst>
            <pc:docMk/>
            <pc:sldMk cId="3354761709" sldId="256"/>
            <ac:spMk id="6" creationId="{1AFCF649-0F34-460E-B121-83810C2CD09A}"/>
          </ac:spMkLst>
        </pc:spChg>
        <pc:spChg chg="add del mod">
          <ac:chgData name="Miriam Schreiber" userId="5a452ff8-f189-44a9-9767-da59f69398bf" providerId="ADAL" clId="{7A8111AC-5017-4CF1-AB1B-6A71CD7BFCD8}" dt="2022-05-01T14:59:11.446" v="3160"/>
          <ac:spMkLst>
            <pc:docMk/>
            <pc:sldMk cId="3354761709" sldId="256"/>
            <ac:spMk id="8" creationId="{D5A26043-B2C5-4DB5-915F-AC38512D9EC6}"/>
          </ac:spMkLst>
        </pc:spChg>
        <pc:spChg chg="add mod">
          <ac:chgData name="Miriam Schreiber" userId="5a452ff8-f189-44a9-9767-da59f69398bf" providerId="ADAL" clId="{7A8111AC-5017-4CF1-AB1B-6A71CD7BFCD8}" dt="2022-05-01T14:59:45.893" v="3176" actId="1036"/>
          <ac:spMkLst>
            <pc:docMk/>
            <pc:sldMk cId="3354761709" sldId="256"/>
            <ac:spMk id="9" creationId="{81A037DC-49A4-4C4A-9F61-C2B5B97CAE93}"/>
          </ac:spMkLst>
        </pc:spChg>
        <pc:picChg chg="add mod">
          <ac:chgData name="Miriam Schreiber" userId="5a452ff8-f189-44a9-9767-da59f69398bf" providerId="ADAL" clId="{7A8111AC-5017-4CF1-AB1B-6A71CD7BFCD8}" dt="2022-04-29T12:37:32.821" v="108" actId="1038"/>
          <ac:picMkLst>
            <pc:docMk/>
            <pc:sldMk cId="3354761709" sldId="256"/>
            <ac:picMk id="5" creationId="{4625AABD-4051-40E5-B0B7-31AB44C43E05}"/>
          </ac:picMkLst>
        </pc:picChg>
        <pc:picChg chg="add mod">
          <ac:chgData name="Miriam Schreiber" userId="5a452ff8-f189-44a9-9767-da59f69398bf" providerId="ADAL" clId="{7A8111AC-5017-4CF1-AB1B-6A71CD7BFCD8}" dt="2022-04-29T12:37:24.967" v="103" actId="1035"/>
          <ac:picMkLst>
            <pc:docMk/>
            <pc:sldMk cId="3354761709" sldId="256"/>
            <ac:picMk id="7" creationId="{E62083EF-FDBF-4DCD-B94C-2DA85B5DEA2B}"/>
          </ac:picMkLst>
        </pc:picChg>
      </pc:sldChg>
      <pc:sldChg chg="addSp delSp modSp new mod">
        <pc:chgData name="Miriam Schreiber" userId="5a452ff8-f189-44a9-9767-da59f69398bf" providerId="ADAL" clId="{7A8111AC-5017-4CF1-AB1B-6A71CD7BFCD8}" dt="2022-05-01T15:00:09.862" v="3196" actId="20577"/>
        <pc:sldMkLst>
          <pc:docMk/>
          <pc:sldMk cId="601455446" sldId="257"/>
        </pc:sldMkLst>
        <pc:spChg chg="del">
          <ac:chgData name="Miriam Schreiber" userId="5a452ff8-f189-44a9-9767-da59f69398bf" providerId="ADAL" clId="{7A8111AC-5017-4CF1-AB1B-6A71CD7BFCD8}" dt="2022-05-01T14:57:11.407" v="3080" actId="478"/>
          <ac:spMkLst>
            <pc:docMk/>
            <pc:sldMk cId="601455446" sldId="257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2:37:13.961" v="61"/>
          <ac:spMkLst>
            <pc:docMk/>
            <pc:sldMk cId="601455446" sldId="257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0:09.862" v="3196" actId="20577"/>
          <ac:spMkLst>
            <pc:docMk/>
            <pc:sldMk cId="601455446" sldId="257"/>
            <ac:spMk id="6" creationId="{59660C4D-04F0-4B70-98AD-637D01BD6EBA}"/>
          </ac:spMkLst>
        </pc:spChg>
        <pc:spChg chg="add mod">
          <ac:chgData name="Miriam Schreiber" userId="5a452ff8-f189-44a9-9767-da59f69398bf" providerId="ADAL" clId="{7A8111AC-5017-4CF1-AB1B-6A71CD7BFCD8}" dt="2022-05-01T15:00:01.590" v="3186" actId="20577"/>
          <ac:spMkLst>
            <pc:docMk/>
            <pc:sldMk cId="601455446" sldId="257"/>
            <ac:spMk id="8" creationId="{C5709267-CBE0-48CD-B55E-E4927E1AE97E}"/>
          </ac:spMkLst>
        </pc:spChg>
        <pc:picChg chg="add mod">
          <ac:chgData name="Miriam Schreiber" userId="5a452ff8-f189-44a9-9767-da59f69398bf" providerId="ADAL" clId="{7A8111AC-5017-4CF1-AB1B-6A71CD7BFCD8}" dt="2022-04-29T12:38:40.883" v="194" actId="1037"/>
          <ac:picMkLst>
            <pc:docMk/>
            <pc:sldMk cId="601455446" sldId="257"/>
            <ac:picMk id="5" creationId="{BD4C377B-8AC9-4F5C-8E3A-5E8E81BB3C90}"/>
          </ac:picMkLst>
        </pc:picChg>
        <pc:picChg chg="add mod">
          <ac:chgData name="Miriam Schreiber" userId="5a452ff8-f189-44a9-9767-da59f69398bf" providerId="ADAL" clId="{7A8111AC-5017-4CF1-AB1B-6A71CD7BFCD8}" dt="2022-04-29T12:38:07.279" v="126" actId="1035"/>
          <ac:picMkLst>
            <pc:docMk/>
            <pc:sldMk cId="601455446" sldId="257"/>
            <ac:picMk id="7" creationId="{B5A0E005-DDBF-4A15-975A-D857BC737D89}"/>
          </ac:picMkLst>
        </pc:picChg>
      </pc:sldChg>
      <pc:sldChg chg="addSp delSp modSp new mod">
        <pc:chgData name="Miriam Schreiber" userId="5a452ff8-f189-44a9-9767-da59f69398bf" providerId="ADAL" clId="{7A8111AC-5017-4CF1-AB1B-6A71CD7BFCD8}" dt="2022-05-01T15:00:28.775" v="3212" actId="20577"/>
        <pc:sldMkLst>
          <pc:docMk/>
          <pc:sldMk cId="1596869533" sldId="258"/>
        </pc:sldMkLst>
        <pc:spChg chg="del">
          <ac:chgData name="Miriam Schreiber" userId="5a452ff8-f189-44a9-9767-da59f69398bf" providerId="ADAL" clId="{7A8111AC-5017-4CF1-AB1B-6A71CD7BFCD8}" dt="2022-05-01T14:57:09.312" v="3079" actId="478"/>
          <ac:spMkLst>
            <pc:docMk/>
            <pc:sldMk cId="1596869533" sldId="258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2:39:13.318" v="195"/>
          <ac:spMkLst>
            <pc:docMk/>
            <pc:sldMk cId="1596869533" sldId="258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0:28.775" v="3212" actId="20577"/>
          <ac:spMkLst>
            <pc:docMk/>
            <pc:sldMk cId="1596869533" sldId="258"/>
            <ac:spMk id="6" creationId="{C717718C-ADA6-41D1-B66A-614BFD5ACEE9}"/>
          </ac:spMkLst>
        </pc:spChg>
        <pc:spChg chg="add mod">
          <ac:chgData name="Miriam Schreiber" userId="5a452ff8-f189-44a9-9767-da59f69398bf" providerId="ADAL" clId="{7A8111AC-5017-4CF1-AB1B-6A71CD7BFCD8}" dt="2022-05-01T15:00:20.953" v="3204" actId="20577"/>
          <ac:spMkLst>
            <pc:docMk/>
            <pc:sldMk cId="1596869533" sldId="258"/>
            <ac:spMk id="8" creationId="{B87B7B73-EE22-4910-A47E-D9DE96BBAA07}"/>
          </ac:spMkLst>
        </pc:spChg>
        <pc:picChg chg="add mod">
          <ac:chgData name="Miriam Schreiber" userId="5a452ff8-f189-44a9-9767-da59f69398bf" providerId="ADAL" clId="{7A8111AC-5017-4CF1-AB1B-6A71CD7BFCD8}" dt="2022-04-29T12:39:40.938" v="286" actId="1035"/>
          <ac:picMkLst>
            <pc:docMk/>
            <pc:sldMk cId="1596869533" sldId="258"/>
            <ac:picMk id="5" creationId="{48205C41-C2FB-47F7-8D27-C94A69471240}"/>
          </ac:picMkLst>
        </pc:picChg>
        <pc:picChg chg="add mod">
          <ac:chgData name="Miriam Schreiber" userId="5a452ff8-f189-44a9-9767-da59f69398bf" providerId="ADAL" clId="{7A8111AC-5017-4CF1-AB1B-6A71CD7BFCD8}" dt="2022-04-29T12:39:21.179" v="226" actId="1037"/>
          <ac:picMkLst>
            <pc:docMk/>
            <pc:sldMk cId="1596869533" sldId="258"/>
            <ac:picMk id="7" creationId="{6BC256D1-A66E-4790-83A3-4BA74A4B17E0}"/>
          </ac:picMkLst>
        </pc:picChg>
      </pc:sldChg>
      <pc:sldChg chg="addSp delSp modSp new mod">
        <pc:chgData name="Miriam Schreiber" userId="5a452ff8-f189-44a9-9767-da59f69398bf" providerId="ADAL" clId="{7A8111AC-5017-4CF1-AB1B-6A71CD7BFCD8}" dt="2022-05-01T15:00:47.874" v="3233" actId="20577"/>
        <pc:sldMkLst>
          <pc:docMk/>
          <pc:sldMk cId="2160225767" sldId="259"/>
        </pc:sldMkLst>
        <pc:spChg chg="del">
          <ac:chgData name="Miriam Schreiber" userId="5a452ff8-f189-44a9-9767-da59f69398bf" providerId="ADAL" clId="{7A8111AC-5017-4CF1-AB1B-6A71CD7BFCD8}" dt="2022-05-01T14:57:07.299" v="3078" actId="478"/>
          <ac:spMkLst>
            <pc:docMk/>
            <pc:sldMk cId="2160225767" sldId="259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2:40:03.352" v="287"/>
          <ac:spMkLst>
            <pc:docMk/>
            <pc:sldMk cId="2160225767" sldId="259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0:47.874" v="3233" actId="20577"/>
          <ac:spMkLst>
            <pc:docMk/>
            <pc:sldMk cId="2160225767" sldId="259"/>
            <ac:spMk id="6" creationId="{405C5AF2-E057-4892-AB31-3103FF06E14D}"/>
          </ac:spMkLst>
        </pc:spChg>
        <pc:spChg chg="add mod">
          <ac:chgData name="Miriam Schreiber" userId="5a452ff8-f189-44a9-9767-da59f69398bf" providerId="ADAL" clId="{7A8111AC-5017-4CF1-AB1B-6A71CD7BFCD8}" dt="2022-05-01T15:00:38.263" v="3224" actId="20577"/>
          <ac:spMkLst>
            <pc:docMk/>
            <pc:sldMk cId="2160225767" sldId="259"/>
            <ac:spMk id="8" creationId="{AA743670-2322-45AB-BB47-5EB7A72AF044}"/>
          </ac:spMkLst>
        </pc:spChg>
        <pc:picChg chg="add mod">
          <ac:chgData name="Miriam Schreiber" userId="5a452ff8-f189-44a9-9767-da59f69398bf" providerId="ADAL" clId="{7A8111AC-5017-4CF1-AB1B-6A71CD7BFCD8}" dt="2022-04-29T12:40:25.435" v="333" actId="1038"/>
          <ac:picMkLst>
            <pc:docMk/>
            <pc:sldMk cId="2160225767" sldId="259"/>
            <ac:picMk id="5" creationId="{D8A09990-BAC8-4898-B640-ECB64ED4AC7F}"/>
          </ac:picMkLst>
        </pc:picChg>
        <pc:picChg chg="add mod">
          <ac:chgData name="Miriam Schreiber" userId="5a452ff8-f189-44a9-9767-da59f69398bf" providerId="ADAL" clId="{7A8111AC-5017-4CF1-AB1B-6A71CD7BFCD8}" dt="2022-04-29T12:40:20.071" v="326" actId="1037"/>
          <ac:picMkLst>
            <pc:docMk/>
            <pc:sldMk cId="2160225767" sldId="259"/>
            <ac:picMk id="7" creationId="{2937165A-04A9-4115-BE76-879B0DC8A785}"/>
          </ac:picMkLst>
        </pc:picChg>
      </pc:sldChg>
      <pc:sldChg chg="addSp delSp modSp new mod">
        <pc:chgData name="Miriam Schreiber" userId="5a452ff8-f189-44a9-9767-da59f69398bf" providerId="ADAL" clId="{7A8111AC-5017-4CF1-AB1B-6A71CD7BFCD8}" dt="2022-05-01T15:01:26.274" v="3247" actId="20577"/>
        <pc:sldMkLst>
          <pc:docMk/>
          <pc:sldMk cId="3673431481" sldId="260"/>
        </pc:sldMkLst>
        <pc:spChg chg="del">
          <ac:chgData name="Miriam Schreiber" userId="5a452ff8-f189-44a9-9767-da59f69398bf" providerId="ADAL" clId="{7A8111AC-5017-4CF1-AB1B-6A71CD7BFCD8}" dt="2022-05-01T14:57:04.942" v="3077" actId="478"/>
          <ac:spMkLst>
            <pc:docMk/>
            <pc:sldMk cId="3673431481" sldId="260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2:41:00.365" v="334"/>
          <ac:spMkLst>
            <pc:docMk/>
            <pc:sldMk cId="3673431481" sldId="260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1:26.274" v="3247" actId="20577"/>
          <ac:spMkLst>
            <pc:docMk/>
            <pc:sldMk cId="3673431481" sldId="260"/>
            <ac:spMk id="6" creationId="{420FC7E7-BB26-418C-84D0-E1E4F725C995}"/>
          </ac:spMkLst>
        </pc:spChg>
        <pc:spChg chg="add mod">
          <ac:chgData name="Miriam Schreiber" userId="5a452ff8-f189-44a9-9767-da59f69398bf" providerId="ADAL" clId="{7A8111AC-5017-4CF1-AB1B-6A71CD7BFCD8}" dt="2022-05-01T15:01:08.508" v="3239" actId="20577"/>
          <ac:spMkLst>
            <pc:docMk/>
            <pc:sldMk cId="3673431481" sldId="260"/>
            <ac:spMk id="8" creationId="{7E53E133-1C5B-4A01-A10E-28C17B808EE9}"/>
          </ac:spMkLst>
        </pc:spChg>
        <pc:picChg chg="add mod">
          <ac:chgData name="Miriam Schreiber" userId="5a452ff8-f189-44a9-9767-da59f69398bf" providerId="ADAL" clId="{7A8111AC-5017-4CF1-AB1B-6A71CD7BFCD8}" dt="2022-04-29T12:41:19.888" v="391" actId="1037"/>
          <ac:picMkLst>
            <pc:docMk/>
            <pc:sldMk cId="3673431481" sldId="260"/>
            <ac:picMk id="5" creationId="{641B99D9-434E-4245-A7FA-EB61B8BD18A2}"/>
          </ac:picMkLst>
        </pc:picChg>
        <pc:picChg chg="add mod">
          <ac:chgData name="Miriam Schreiber" userId="5a452ff8-f189-44a9-9767-da59f69398bf" providerId="ADAL" clId="{7A8111AC-5017-4CF1-AB1B-6A71CD7BFCD8}" dt="2022-04-29T12:41:06.917" v="377" actId="1038"/>
          <ac:picMkLst>
            <pc:docMk/>
            <pc:sldMk cId="3673431481" sldId="260"/>
            <ac:picMk id="7" creationId="{9F3E5FDC-7A3B-4427-BE3E-0F15F10EE773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1:48.658" v="3263" actId="20577"/>
        <pc:sldMkLst>
          <pc:docMk/>
          <pc:sldMk cId="1550663886" sldId="261"/>
        </pc:sldMkLst>
        <pc:spChg chg="del">
          <ac:chgData name="Miriam Schreiber" userId="5a452ff8-f189-44a9-9767-da59f69398bf" providerId="ADAL" clId="{7A8111AC-5017-4CF1-AB1B-6A71CD7BFCD8}" dt="2022-05-01T14:57:02.902" v="3076" actId="478"/>
          <ac:spMkLst>
            <pc:docMk/>
            <pc:sldMk cId="1550663886" sldId="261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2:41:39.471" v="392"/>
          <ac:spMkLst>
            <pc:docMk/>
            <pc:sldMk cId="1550663886" sldId="261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1:48.658" v="3263" actId="20577"/>
          <ac:spMkLst>
            <pc:docMk/>
            <pc:sldMk cId="1550663886" sldId="261"/>
            <ac:spMk id="6" creationId="{830B0E41-FD67-4C9B-9ACB-95DDFD5DDF74}"/>
          </ac:spMkLst>
        </pc:spChg>
        <pc:spChg chg="add mod">
          <ac:chgData name="Miriam Schreiber" userId="5a452ff8-f189-44a9-9767-da59f69398bf" providerId="ADAL" clId="{7A8111AC-5017-4CF1-AB1B-6A71CD7BFCD8}" dt="2022-05-01T15:01:37.043" v="3255" actId="20577"/>
          <ac:spMkLst>
            <pc:docMk/>
            <pc:sldMk cId="1550663886" sldId="261"/>
            <ac:spMk id="8" creationId="{F0F786A3-DA6E-475D-8F99-12073F0A9EE0}"/>
          </ac:spMkLst>
        </pc:spChg>
        <pc:picChg chg="add mod">
          <ac:chgData name="Miriam Schreiber" userId="5a452ff8-f189-44a9-9767-da59f69398bf" providerId="ADAL" clId="{7A8111AC-5017-4CF1-AB1B-6A71CD7BFCD8}" dt="2022-04-29T12:42:01.982" v="433" actId="1037"/>
          <ac:picMkLst>
            <pc:docMk/>
            <pc:sldMk cId="1550663886" sldId="261"/>
            <ac:picMk id="5" creationId="{B90EBFC2-D01D-4B7E-B935-B52D7AA6A271}"/>
          </ac:picMkLst>
        </pc:picChg>
        <pc:picChg chg="add mod">
          <ac:chgData name="Miriam Schreiber" userId="5a452ff8-f189-44a9-9767-da59f69398bf" providerId="ADAL" clId="{7A8111AC-5017-4CF1-AB1B-6A71CD7BFCD8}" dt="2022-04-29T12:41:45.865" v="408" actId="1035"/>
          <ac:picMkLst>
            <pc:docMk/>
            <pc:sldMk cId="1550663886" sldId="261"/>
            <ac:picMk id="7" creationId="{6A6DDD05-4202-4E61-A478-62FBF86584CF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2:10.459" v="3281" actId="20577"/>
        <pc:sldMkLst>
          <pc:docMk/>
          <pc:sldMk cId="3784542068" sldId="262"/>
        </pc:sldMkLst>
        <pc:spChg chg="del">
          <ac:chgData name="Miriam Schreiber" userId="5a452ff8-f189-44a9-9767-da59f69398bf" providerId="ADAL" clId="{7A8111AC-5017-4CF1-AB1B-6A71CD7BFCD8}" dt="2022-05-01T14:56:59.182" v="3075" actId="478"/>
          <ac:spMkLst>
            <pc:docMk/>
            <pc:sldMk cId="3784542068" sldId="262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2:42:28.390" v="434"/>
          <ac:spMkLst>
            <pc:docMk/>
            <pc:sldMk cId="3784542068" sldId="262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2:10.459" v="3281" actId="20577"/>
          <ac:spMkLst>
            <pc:docMk/>
            <pc:sldMk cId="3784542068" sldId="262"/>
            <ac:spMk id="6" creationId="{7D51C715-249D-4DBC-91A3-68ED7BC4969A}"/>
          </ac:spMkLst>
        </pc:spChg>
        <pc:spChg chg="add mod">
          <ac:chgData name="Miriam Schreiber" userId="5a452ff8-f189-44a9-9767-da59f69398bf" providerId="ADAL" clId="{7A8111AC-5017-4CF1-AB1B-6A71CD7BFCD8}" dt="2022-05-01T15:02:01.816" v="3273" actId="20577"/>
          <ac:spMkLst>
            <pc:docMk/>
            <pc:sldMk cId="3784542068" sldId="262"/>
            <ac:spMk id="8" creationId="{B4A066CC-ADFA-477C-A16B-D4A40A0E3265}"/>
          </ac:spMkLst>
        </pc:spChg>
        <pc:picChg chg="add mod">
          <ac:chgData name="Miriam Schreiber" userId="5a452ff8-f189-44a9-9767-da59f69398bf" providerId="ADAL" clId="{7A8111AC-5017-4CF1-AB1B-6A71CD7BFCD8}" dt="2022-04-29T12:42:45.665" v="479" actId="1037"/>
          <ac:picMkLst>
            <pc:docMk/>
            <pc:sldMk cId="3784542068" sldId="262"/>
            <ac:picMk id="5" creationId="{D80E6760-14A7-47B6-B0AE-9DB4254520E5}"/>
          </ac:picMkLst>
        </pc:picChg>
        <pc:picChg chg="add mod">
          <ac:chgData name="Miriam Schreiber" userId="5a452ff8-f189-44a9-9767-da59f69398bf" providerId="ADAL" clId="{7A8111AC-5017-4CF1-AB1B-6A71CD7BFCD8}" dt="2022-04-29T12:42:33.863" v="451" actId="1037"/>
          <ac:picMkLst>
            <pc:docMk/>
            <pc:sldMk cId="3784542068" sldId="262"/>
            <ac:picMk id="7" creationId="{57F2A8A2-20DB-4881-86FE-325D38AEB771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2:30.191" v="3295" actId="20577"/>
        <pc:sldMkLst>
          <pc:docMk/>
          <pc:sldMk cId="448169074" sldId="263"/>
        </pc:sldMkLst>
        <pc:spChg chg="del">
          <ac:chgData name="Miriam Schreiber" userId="5a452ff8-f189-44a9-9767-da59f69398bf" providerId="ADAL" clId="{7A8111AC-5017-4CF1-AB1B-6A71CD7BFCD8}" dt="2022-05-01T14:56:56.222" v="3074" actId="478"/>
          <ac:spMkLst>
            <pc:docMk/>
            <pc:sldMk cId="448169074" sldId="263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2:42:58.905" v="480"/>
          <ac:spMkLst>
            <pc:docMk/>
            <pc:sldMk cId="448169074" sldId="263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2:30.191" v="3295" actId="20577"/>
          <ac:spMkLst>
            <pc:docMk/>
            <pc:sldMk cId="448169074" sldId="263"/>
            <ac:spMk id="6" creationId="{D74AA698-6A4D-4193-BAFB-9C7736439DE1}"/>
          </ac:spMkLst>
        </pc:spChg>
        <pc:spChg chg="add mod">
          <ac:chgData name="Miriam Schreiber" userId="5a452ff8-f189-44a9-9767-da59f69398bf" providerId="ADAL" clId="{7A8111AC-5017-4CF1-AB1B-6A71CD7BFCD8}" dt="2022-05-01T15:02:20.366" v="3287" actId="20577"/>
          <ac:spMkLst>
            <pc:docMk/>
            <pc:sldMk cId="448169074" sldId="263"/>
            <ac:spMk id="8" creationId="{7032BDE9-425B-4307-BA1C-ADC85EFE9B0E}"/>
          </ac:spMkLst>
        </pc:spChg>
        <pc:picChg chg="add mod">
          <ac:chgData name="Miriam Schreiber" userId="5a452ff8-f189-44a9-9767-da59f69398bf" providerId="ADAL" clId="{7A8111AC-5017-4CF1-AB1B-6A71CD7BFCD8}" dt="2022-05-01T14:56:54.605" v="3073" actId="1037"/>
          <ac:picMkLst>
            <pc:docMk/>
            <pc:sldMk cId="448169074" sldId="263"/>
            <ac:picMk id="5" creationId="{42F5EA1D-6548-4C87-B300-099CB7040ABE}"/>
          </ac:picMkLst>
        </pc:picChg>
        <pc:picChg chg="add mod">
          <ac:chgData name="Miriam Schreiber" userId="5a452ff8-f189-44a9-9767-da59f69398bf" providerId="ADAL" clId="{7A8111AC-5017-4CF1-AB1B-6A71CD7BFCD8}" dt="2022-05-01T14:56:46.774" v="3063" actId="1038"/>
          <ac:picMkLst>
            <pc:docMk/>
            <pc:sldMk cId="448169074" sldId="263"/>
            <ac:picMk id="7" creationId="{68435256-0FA8-46D3-92AC-C8A479E21EFF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2:49.264" v="3309" actId="20577"/>
        <pc:sldMkLst>
          <pc:docMk/>
          <pc:sldMk cId="1362494773" sldId="264"/>
        </pc:sldMkLst>
        <pc:spChg chg="del">
          <ac:chgData name="Miriam Schreiber" userId="5a452ff8-f189-44a9-9767-da59f69398bf" providerId="ADAL" clId="{7A8111AC-5017-4CF1-AB1B-6A71CD7BFCD8}" dt="2022-05-01T14:56:41.629" v="3049" actId="478"/>
          <ac:spMkLst>
            <pc:docMk/>
            <pc:sldMk cId="1362494773" sldId="264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2:43:09.280" v="486"/>
          <ac:spMkLst>
            <pc:docMk/>
            <pc:sldMk cId="1362494773" sldId="264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2:49.264" v="3309" actId="20577"/>
          <ac:spMkLst>
            <pc:docMk/>
            <pc:sldMk cId="1362494773" sldId="264"/>
            <ac:spMk id="6" creationId="{267C9A00-8ADF-4ACC-A0AC-A18BD9FB106A}"/>
          </ac:spMkLst>
        </pc:spChg>
        <pc:spChg chg="add mod">
          <ac:chgData name="Miriam Schreiber" userId="5a452ff8-f189-44a9-9767-da59f69398bf" providerId="ADAL" clId="{7A8111AC-5017-4CF1-AB1B-6A71CD7BFCD8}" dt="2022-05-01T15:02:39.369" v="3301" actId="20577"/>
          <ac:spMkLst>
            <pc:docMk/>
            <pc:sldMk cId="1362494773" sldId="264"/>
            <ac:spMk id="8" creationId="{6078E955-ECDB-49A9-8307-88ADBECF2333}"/>
          </ac:spMkLst>
        </pc:spChg>
        <pc:picChg chg="add mod">
          <ac:chgData name="Miriam Schreiber" userId="5a452ff8-f189-44a9-9767-da59f69398bf" providerId="ADAL" clId="{7A8111AC-5017-4CF1-AB1B-6A71CD7BFCD8}" dt="2022-05-01T14:56:40.300" v="3048" actId="1037"/>
          <ac:picMkLst>
            <pc:docMk/>
            <pc:sldMk cId="1362494773" sldId="264"/>
            <ac:picMk id="5" creationId="{5A2BF9B9-8499-4099-949A-A6A77FCF3CE3}"/>
          </ac:picMkLst>
        </pc:picChg>
        <pc:picChg chg="add mod">
          <ac:chgData name="Miriam Schreiber" userId="5a452ff8-f189-44a9-9767-da59f69398bf" providerId="ADAL" clId="{7A8111AC-5017-4CF1-AB1B-6A71CD7BFCD8}" dt="2022-05-01T14:56:33.261" v="3019" actId="1037"/>
          <ac:picMkLst>
            <pc:docMk/>
            <pc:sldMk cId="1362494773" sldId="264"/>
            <ac:picMk id="7" creationId="{30FDEE95-C911-4DC5-8C74-80CDD3EAB287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3:08.849" v="3329" actId="20577"/>
        <pc:sldMkLst>
          <pc:docMk/>
          <pc:sldMk cId="3799143060" sldId="265"/>
        </pc:sldMkLst>
        <pc:spChg chg="del">
          <ac:chgData name="Miriam Schreiber" userId="5a452ff8-f189-44a9-9767-da59f69398bf" providerId="ADAL" clId="{7A8111AC-5017-4CF1-AB1B-6A71CD7BFCD8}" dt="2022-05-01T14:56:15.934" v="2961" actId="478"/>
          <ac:spMkLst>
            <pc:docMk/>
            <pc:sldMk cId="3799143060" sldId="265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2:43:18.793" v="492"/>
          <ac:spMkLst>
            <pc:docMk/>
            <pc:sldMk cId="3799143060" sldId="265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3:08.849" v="3329" actId="20577"/>
          <ac:spMkLst>
            <pc:docMk/>
            <pc:sldMk cId="3799143060" sldId="265"/>
            <ac:spMk id="6" creationId="{17E67B85-8AFE-49ED-AFB1-205A848DFEF3}"/>
          </ac:spMkLst>
        </pc:spChg>
        <pc:spChg chg="add mod">
          <ac:chgData name="Miriam Schreiber" userId="5a452ff8-f189-44a9-9767-da59f69398bf" providerId="ADAL" clId="{7A8111AC-5017-4CF1-AB1B-6A71CD7BFCD8}" dt="2022-05-01T15:02:58.696" v="3318" actId="20577"/>
          <ac:spMkLst>
            <pc:docMk/>
            <pc:sldMk cId="3799143060" sldId="265"/>
            <ac:spMk id="8" creationId="{41B74A1D-04CE-46D7-B1FB-216F04B1D975}"/>
          </ac:spMkLst>
        </pc:spChg>
        <pc:picChg chg="add mod">
          <ac:chgData name="Miriam Schreiber" userId="5a452ff8-f189-44a9-9767-da59f69398bf" providerId="ADAL" clId="{7A8111AC-5017-4CF1-AB1B-6A71CD7BFCD8}" dt="2022-05-01T14:56:23.566" v="2971" actId="1037"/>
          <ac:picMkLst>
            <pc:docMk/>
            <pc:sldMk cId="3799143060" sldId="265"/>
            <ac:picMk id="5" creationId="{0D772D0B-0206-48EA-A2EF-7FDA98426807}"/>
          </ac:picMkLst>
        </pc:picChg>
        <pc:picChg chg="add mod">
          <ac:chgData name="Miriam Schreiber" userId="5a452ff8-f189-44a9-9767-da59f69398bf" providerId="ADAL" clId="{7A8111AC-5017-4CF1-AB1B-6A71CD7BFCD8}" dt="2022-05-01T14:56:14.737" v="2960" actId="1038"/>
          <ac:picMkLst>
            <pc:docMk/>
            <pc:sldMk cId="3799143060" sldId="265"/>
            <ac:picMk id="7" creationId="{B14E9249-C380-4553-BF8E-C5504E163C45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3:27.605" v="3355" actId="20577"/>
        <pc:sldMkLst>
          <pc:docMk/>
          <pc:sldMk cId="3075301497" sldId="266"/>
        </pc:sldMkLst>
        <pc:spChg chg="del">
          <ac:chgData name="Miriam Schreiber" userId="5a452ff8-f189-44a9-9767-da59f69398bf" providerId="ADAL" clId="{7A8111AC-5017-4CF1-AB1B-6A71CD7BFCD8}" dt="2022-05-01T14:56:05.782" v="2924" actId="478"/>
          <ac:spMkLst>
            <pc:docMk/>
            <pc:sldMk cId="3075301497" sldId="266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2:43:26.821" v="498"/>
          <ac:spMkLst>
            <pc:docMk/>
            <pc:sldMk cId="3075301497" sldId="266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3:27.605" v="3355" actId="20577"/>
          <ac:spMkLst>
            <pc:docMk/>
            <pc:sldMk cId="3075301497" sldId="266"/>
            <ac:spMk id="6" creationId="{4136EF18-8B7E-44E9-BA63-04110F999032}"/>
          </ac:spMkLst>
        </pc:spChg>
        <pc:spChg chg="add mod">
          <ac:chgData name="Miriam Schreiber" userId="5a452ff8-f189-44a9-9767-da59f69398bf" providerId="ADAL" clId="{7A8111AC-5017-4CF1-AB1B-6A71CD7BFCD8}" dt="2022-05-01T15:03:18.237" v="3345" actId="20577"/>
          <ac:spMkLst>
            <pc:docMk/>
            <pc:sldMk cId="3075301497" sldId="266"/>
            <ac:spMk id="8" creationId="{EA11709F-110E-47B6-AF2A-EBBB03506036}"/>
          </ac:spMkLst>
        </pc:spChg>
        <pc:picChg chg="add mod">
          <ac:chgData name="Miriam Schreiber" userId="5a452ff8-f189-44a9-9767-da59f69398bf" providerId="ADAL" clId="{7A8111AC-5017-4CF1-AB1B-6A71CD7BFCD8}" dt="2022-05-01T14:56:04.018" v="2923" actId="1038"/>
          <ac:picMkLst>
            <pc:docMk/>
            <pc:sldMk cId="3075301497" sldId="266"/>
            <ac:picMk id="5" creationId="{15A3BD0D-3DF3-4F80-A17B-8A5E14F54367}"/>
          </ac:picMkLst>
        </pc:picChg>
        <pc:picChg chg="add mod">
          <ac:chgData name="Miriam Schreiber" userId="5a452ff8-f189-44a9-9767-da59f69398bf" providerId="ADAL" clId="{7A8111AC-5017-4CF1-AB1B-6A71CD7BFCD8}" dt="2022-05-01T14:55:53.022" v="2887" actId="1035"/>
          <ac:picMkLst>
            <pc:docMk/>
            <pc:sldMk cId="3075301497" sldId="266"/>
            <ac:picMk id="7" creationId="{340C7610-6C30-42CE-8EF4-E221FCABBEC3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3:43.942" v="3372" actId="20577"/>
        <pc:sldMkLst>
          <pc:docMk/>
          <pc:sldMk cId="400767501" sldId="267"/>
        </pc:sldMkLst>
        <pc:spChg chg="del">
          <ac:chgData name="Miriam Schreiber" userId="5a452ff8-f189-44a9-9767-da59f69398bf" providerId="ADAL" clId="{7A8111AC-5017-4CF1-AB1B-6A71CD7BFCD8}" dt="2022-05-01T14:55:35.166" v="2796" actId="478"/>
          <ac:spMkLst>
            <pc:docMk/>
            <pc:sldMk cId="400767501" sldId="267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2:43:39.900" v="505"/>
          <ac:spMkLst>
            <pc:docMk/>
            <pc:sldMk cId="400767501" sldId="267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3:43.942" v="3372" actId="20577"/>
          <ac:spMkLst>
            <pc:docMk/>
            <pc:sldMk cId="400767501" sldId="267"/>
            <ac:spMk id="6" creationId="{CFDD467F-C7C1-4EF4-91AD-144B5D8BDA1C}"/>
          </ac:spMkLst>
        </pc:spChg>
        <pc:spChg chg="add mod">
          <ac:chgData name="Miriam Schreiber" userId="5a452ff8-f189-44a9-9767-da59f69398bf" providerId="ADAL" clId="{7A8111AC-5017-4CF1-AB1B-6A71CD7BFCD8}" dt="2022-05-01T15:03:35.822" v="3364" actId="20577"/>
          <ac:spMkLst>
            <pc:docMk/>
            <pc:sldMk cId="400767501" sldId="267"/>
            <ac:spMk id="8" creationId="{AB4372E7-8724-48FB-A29D-531CA0B36C04}"/>
          </ac:spMkLst>
        </pc:spChg>
        <pc:picChg chg="add mod">
          <ac:chgData name="Miriam Schreiber" userId="5a452ff8-f189-44a9-9767-da59f69398bf" providerId="ADAL" clId="{7A8111AC-5017-4CF1-AB1B-6A71CD7BFCD8}" dt="2022-05-01T14:55:33.694" v="2795" actId="1038"/>
          <ac:picMkLst>
            <pc:docMk/>
            <pc:sldMk cId="400767501" sldId="267"/>
            <ac:picMk id="5" creationId="{276C5092-D3AD-4314-87FE-50A4EAFA0C65}"/>
          </ac:picMkLst>
        </pc:picChg>
        <pc:picChg chg="add mod">
          <ac:chgData name="Miriam Schreiber" userId="5a452ff8-f189-44a9-9767-da59f69398bf" providerId="ADAL" clId="{7A8111AC-5017-4CF1-AB1B-6A71CD7BFCD8}" dt="2022-05-01T14:55:41.005" v="2840" actId="1036"/>
          <ac:picMkLst>
            <pc:docMk/>
            <pc:sldMk cId="400767501" sldId="267"/>
            <ac:picMk id="7" creationId="{7615B30B-8A77-4784-A9C6-4A2DFA2751B5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4:02.475" v="3389" actId="20577"/>
        <pc:sldMkLst>
          <pc:docMk/>
          <pc:sldMk cId="876991986" sldId="268"/>
        </pc:sldMkLst>
        <pc:spChg chg="del">
          <ac:chgData name="Miriam Schreiber" userId="5a452ff8-f189-44a9-9767-da59f69398bf" providerId="ADAL" clId="{7A8111AC-5017-4CF1-AB1B-6A71CD7BFCD8}" dt="2022-05-01T14:55:15.192" v="2765" actId="478"/>
          <ac:spMkLst>
            <pc:docMk/>
            <pc:sldMk cId="876991986" sldId="268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2:43:54.630" v="514"/>
          <ac:spMkLst>
            <pc:docMk/>
            <pc:sldMk cId="876991986" sldId="268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4:02.475" v="3389" actId="20577"/>
          <ac:spMkLst>
            <pc:docMk/>
            <pc:sldMk cId="876991986" sldId="268"/>
            <ac:spMk id="6" creationId="{C964CA16-FFDA-4C42-BA5E-F0E1143F3494}"/>
          </ac:spMkLst>
        </pc:spChg>
        <pc:spChg chg="add mod">
          <ac:chgData name="Miriam Schreiber" userId="5a452ff8-f189-44a9-9767-da59f69398bf" providerId="ADAL" clId="{7A8111AC-5017-4CF1-AB1B-6A71CD7BFCD8}" dt="2022-05-01T15:03:53.968" v="3381" actId="20577"/>
          <ac:spMkLst>
            <pc:docMk/>
            <pc:sldMk cId="876991986" sldId="268"/>
            <ac:spMk id="8" creationId="{439EDA30-8425-4901-802E-90207EE97CAD}"/>
          </ac:spMkLst>
        </pc:spChg>
        <pc:picChg chg="add mod">
          <ac:chgData name="Miriam Schreiber" userId="5a452ff8-f189-44a9-9767-da59f69398bf" providerId="ADAL" clId="{7A8111AC-5017-4CF1-AB1B-6A71CD7BFCD8}" dt="2022-05-01T14:55:22.157" v="2777" actId="1038"/>
          <ac:picMkLst>
            <pc:docMk/>
            <pc:sldMk cId="876991986" sldId="268"/>
            <ac:picMk id="5" creationId="{9659AF13-B740-4B41-A994-525F70808D9F}"/>
          </ac:picMkLst>
        </pc:picChg>
        <pc:picChg chg="add mod">
          <ac:chgData name="Miriam Schreiber" userId="5a452ff8-f189-44a9-9767-da59f69398bf" providerId="ADAL" clId="{7A8111AC-5017-4CF1-AB1B-6A71CD7BFCD8}" dt="2022-05-01T14:55:14.038" v="2764" actId="1037"/>
          <ac:picMkLst>
            <pc:docMk/>
            <pc:sldMk cId="876991986" sldId="268"/>
            <ac:picMk id="7" creationId="{15981D32-BFFA-4BD6-9482-28D689EE960E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4:31.141" v="3405" actId="20577"/>
        <pc:sldMkLst>
          <pc:docMk/>
          <pc:sldMk cId="278741267" sldId="269"/>
        </pc:sldMkLst>
        <pc:spChg chg="del">
          <ac:chgData name="Miriam Schreiber" userId="5a452ff8-f189-44a9-9767-da59f69398bf" providerId="ADAL" clId="{7A8111AC-5017-4CF1-AB1B-6A71CD7BFCD8}" dt="2022-05-01T14:54:57.255" v="2717" actId="478"/>
          <ac:spMkLst>
            <pc:docMk/>
            <pc:sldMk cId="278741267" sldId="269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2:44:16.083" v="521"/>
          <ac:spMkLst>
            <pc:docMk/>
            <pc:sldMk cId="278741267" sldId="269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4:31.141" v="3405" actId="20577"/>
          <ac:spMkLst>
            <pc:docMk/>
            <pc:sldMk cId="278741267" sldId="269"/>
            <ac:spMk id="6" creationId="{79C79450-6BD3-4489-93FC-DB1217F398AB}"/>
          </ac:spMkLst>
        </pc:spChg>
        <pc:spChg chg="add mod">
          <ac:chgData name="Miriam Schreiber" userId="5a452ff8-f189-44a9-9767-da59f69398bf" providerId="ADAL" clId="{7A8111AC-5017-4CF1-AB1B-6A71CD7BFCD8}" dt="2022-05-01T15:04:26.221" v="3404" actId="20577"/>
          <ac:spMkLst>
            <pc:docMk/>
            <pc:sldMk cId="278741267" sldId="269"/>
            <ac:spMk id="8" creationId="{FD0D2ADE-633D-4322-A6FB-4C5F50CF1880}"/>
          </ac:spMkLst>
        </pc:spChg>
        <pc:picChg chg="add mod">
          <ac:chgData name="Miriam Schreiber" userId="5a452ff8-f189-44a9-9767-da59f69398bf" providerId="ADAL" clId="{7A8111AC-5017-4CF1-AB1B-6A71CD7BFCD8}" dt="2022-05-01T14:55:04.630" v="2727" actId="1037"/>
          <ac:picMkLst>
            <pc:docMk/>
            <pc:sldMk cId="278741267" sldId="269"/>
            <ac:picMk id="5" creationId="{D0FEB56B-D216-44E8-A439-1CA2B90FE608}"/>
          </ac:picMkLst>
        </pc:picChg>
        <pc:picChg chg="add mod">
          <ac:chgData name="Miriam Schreiber" userId="5a452ff8-f189-44a9-9767-da59f69398bf" providerId="ADAL" clId="{7A8111AC-5017-4CF1-AB1B-6A71CD7BFCD8}" dt="2022-05-01T14:54:56.246" v="2716" actId="1036"/>
          <ac:picMkLst>
            <pc:docMk/>
            <pc:sldMk cId="278741267" sldId="269"/>
            <ac:picMk id="7" creationId="{CA20BCC6-4DB8-4D2D-97E0-61064CC18411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4:46.098" v="3419" actId="20577"/>
        <pc:sldMkLst>
          <pc:docMk/>
          <pc:sldMk cId="184047479" sldId="270"/>
        </pc:sldMkLst>
        <pc:spChg chg="del">
          <ac:chgData name="Miriam Schreiber" userId="5a452ff8-f189-44a9-9767-da59f69398bf" providerId="ADAL" clId="{7A8111AC-5017-4CF1-AB1B-6A71CD7BFCD8}" dt="2022-05-01T14:54:40.681" v="2661" actId="478"/>
          <ac:spMkLst>
            <pc:docMk/>
            <pc:sldMk cId="184047479" sldId="270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2:44:39.422" v="528"/>
          <ac:spMkLst>
            <pc:docMk/>
            <pc:sldMk cId="184047479" sldId="270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4:46.098" v="3419" actId="20577"/>
          <ac:spMkLst>
            <pc:docMk/>
            <pc:sldMk cId="184047479" sldId="270"/>
            <ac:spMk id="6" creationId="{2E7D0881-5A91-43C3-B747-B953909A7062}"/>
          </ac:spMkLst>
        </pc:spChg>
        <pc:spChg chg="add mod">
          <ac:chgData name="Miriam Schreiber" userId="5a452ff8-f189-44a9-9767-da59f69398bf" providerId="ADAL" clId="{7A8111AC-5017-4CF1-AB1B-6A71CD7BFCD8}" dt="2022-05-01T15:04:38.960" v="3412" actId="20577"/>
          <ac:spMkLst>
            <pc:docMk/>
            <pc:sldMk cId="184047479" sldId="270"/>
            <ac:spMk id="8" creationId="{5E74E256-A11E-4CA5-A6CE-F839DB213819}"/>
          </ac:spMkLst>
        </pc:spChg>
        <pc:picChg chg="add mod">
          <ac:chgData name="Miriam Schreiber" userId="5a452ff8-f189-44a9-9767-da59f69398bf" providerId="ADAL" clId="{7A8111AC-5017-4CF1-AB1B-6A71CD7BFCD8}" dt="2022-05-01T14:54:48.573" v="2671" actId="1037"/>
          <ac:picMkLst>
            <pc:docMk/>
            <pc:sldMk cId="184047479" sldId="270"/>
            <ac:picMk id="5" creationId="{16B6CAD5-88A8-4A89-95E6-5A5585BBAFC6}"/>
          </ac:picMkLst>
        </pc:picChg>
        <pc:picChg chg="add mod">
          <ac:chgData name="Miriam Schreiber" userId="5a452ff8-f189-44a9-9767-da59f69398bf" providerId="ADAL" clId="{7A8111AC-5017-4CF1-AB1B-6A71CD7BFCD8}" dt="2022-05-01T14:54:39.049" v="2660" actId="1037"/>
          <ac:picMkLst>
            <pc:docMk/>
            <pc:sldMk cId="184047479" sldId="270"/>
            <ac:picMk id="7" creationId="{4F9232FF-9B13-43C3-97C3-46679A1B54CA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5:10.285" v="3435" actId="20577"/>
        <pc:sldMkLst>
          <pc:docMk/>
          <pc:sldMk cId="3644538968" sldId="271"/>
        </pc:sldMkLst>
        <pc:spChg chg="del">
          <ac:chgData name="Miriam Schreiber" userId="5a452ff8-f189-44a9-9767-da59f69398bf" providerId="ADAL" clId="{7A8111AC-5017-4CF1-AB1B-6A71CD7BFCD8}" dt="2022-05-01T14:54:21.943" v="2620" actId="478"/>
          <ac:spMkLst>
            <pc:docMk/>
            <pc:sldMk cId="3644538968" sldId="271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2:44:50.646" v="536"/>
          <ac:spMkLst>
            <pc:docMk/>
            <pc:sldMk cId="3644538968" sldId="271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5:10.285" v="3435" actId="20577"/>
          <ac:spMkLst>
            <pc:docMk/>
            <pc:sldMk cId="3644538968" sldId="271"/>
            <ac:spMk id="6" creationId="{58C13013-5966-4872-A46E-E18762FC371F}"/>
          </ac:spMkLst>
        </pc:spChg>
        <pc:spChg chg="add mod">
          <ac:chgData name="Miriam Schreiber" userId="5a452ff8-f189-44a9-9767-da59f69398bf" providerId="ADAL" clId="{7A8111AC-5017-4CF1-AB1B-6A71CD7BFCD8}" dt="2022-05-01T15:05:02.562" v="3428" actId="20577"/>
          <ac:spMkLst>
            <pc:docMk/>
            <pc:sldMk cId="3644538968" sldId="271"/>
            <ac:spMk id="8" creationId="{791DA3DB-C4B1-4723-9410-876441A38216}"/>
          </ac:spMkLst>
        </pc:spChg>
        <pc:picChg chg="add mod">
          <ac:chgData name="Miriam Schreiber" userId="5a452ff8-f189-44a9-9767-da59f69398bf" providerId="ADAL" clId="{7A8111AC-5017-4CF1-AB1B-6A71CD7BFCD8}" dt="2022-05-01T14:54:31.513" v="2632" actId="1037"/>
          <ac:picMkLst>
            <pc:docMk/>
            <pc:sldMk cId="3644538968" sldId="271"/>
            <ac:picMk id="5" creationId="{3E1BB15D-E522-4E7A-B33F-95078B234CD8}"/>
          </ac:picMkLst>
        </pc:picChg>
        <pc:picChg chg="add mod">
          <ac:chgData name="Miriam Schreiber" userId="5a452ff8-f189-44a9-9767-da59f69398bf" providerId="ADAL" clId="{7A8111AC-5017-4CF1-AB1B-6A71CD7BFCD8}" dt="2022-05-01T14:54:20.373" v="2619" actId="1037"/>
          <ac:picMkLst>
            <pc:docMk/>
            <pc:sldMk cId="3644538968" sldId="271"/>
            <ac:picMk id="7" creationId="{2173B88F-059A-42E8-8CC4-B7F6CECC10A4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5:28.597" v="3453" actId="20577"/>
        <pc:sldMkLst>
          <pc:docMk/>
          <pc:sldMk cId="4065609595" sldId="272"/>
        </pc:sldMkLst>
        <pc:spChg chg="del">
          <ac:chgData name="Miriam Schreiber" userId="5a452ff8-f189-44a9-9767-da59f69398bf" providerId="ADAL" clId="{7A8111AC-5017-4CF1-AB1B-6A71CD7BFCD8}" dt="2022-05-01T14:54:13.462" v="2572" actId="478"/>
          <ac:spMkLst>
            <pc:docMk/>
            <pc:sldMk cId="4065609595" sldId="272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2:45:01.075" v="543"/>
          <ac:spMkLst>
            <pc:docMk/>
            <pc:sldMk cId="4065609595" sldId="272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5:28.597" v="3453" actId="20577"/>
          <ac:spMkLst>
            <pc:docMk/>
            <pc:sldMk cId="4065609595" sldId="272"/>
            <ac:spMk id="6" creationId="{77FB7F16-D884-4E3B-8711-96937AF5D979}"/>
          </ac:spMkLst>
        </pc:spChg>
        <pc:spChg chg="add mod">
          <ac:chgData name="Miriam Schreiber" userId="5a452ff8-f189-44a9-9767-da59f69398bf" providerId="ADAL" clId="{7A8111AC-5017-4CF1-AB1B-6A71CD7BFCD8}" dt="2022-05-01T15:05:18.764" v="3442" actId="20577"/>
          <ac:spMkLst>
            <pc:docMk/>
            <pc:sldMk cId="4065609595" sldId="272"/>
            <ac:spMk id="8" creationId="{E23B6DDF-311E-4821-917B-F5F7258765D8}"/>
          </ac:spMkLst>
        </pc:spChg>
        <pc:picChg chg="add mod">
          <ac:chgData name="Miriam Schreiber" userId="5a452ff8-f189-44a9-9767-da59f69398bf" providerId="ADAL" clId="{7A8111AC-5017-4CF1-AB1B-6A71CD7BFCD8}" dt="2022-05-01T14:54:12.190" v="2571" actId="1037"/>
          <ac:picMkLst>
            <pc:docMk/>
            <pc:sldMk cId="4065609595" sldId="272"/>
            <ac:picMk id="5" creationId="{CA618311-8F8A-4A1E-BF9C-9E7AD6021F42}"/>
          </ac:picMkLst>
        </pc:picChg>
        <pc:picChg chg="add mod">
          <ac:chgData name="Miriam Schreiber" userId="5a452ff8-f189-44a9-9767-da59f69398bf" providerId="ADAL" clId="{7A8111AC-5017-4CF1-AB1B-6A71CD7BFCD8}" dt="2022-05-01T14:54:03.693" v="2560" actId="1037"/>
          <ac:picMkLst>
            <pc:docMk/>
            <pc:sldMk cId="4065609595" sldId="272"/>
            <ac:picMk id="7" creationId="{F3C31599-694D-43FD-8B4B-44A9C675A83D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5:49.772" v="3467" actId="20577"/>
        <pc:sldMkLst>
          <pc:docMk/>
          <pc:sldMk cId="1669478830" sldId="273"/>
        </pc:sldMkLst>
        <pc:spChg chg="del">
          <ac:chgData name="Miriam Schreiber" userId="5a452ff8-f189-44a9-9767-da59f69398bf" providerId="ADAL" clId="{7A8111AC-5017-4CF1-AB1B-6A71CD7BFCD8}" dt="2022-05-01T14:53:53.621" v="2516" actId="478"/>
          <ac:spMkLst>
            <pc:docMk/>
            <pc:sldMk cId="1669478830" sldId="273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2:45:15.640" v="550"/>
          <ac:spMkLst>
            <pc:docMk/>
            <pc:sldMk cId="1669478830" sldId="273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5:49.772" v="3467" actId="20577"/>
          <ac:spMkLst>
            <pc:docMk/>
            <pc:sldMk cId="1669478830" sldId="273"/>
            <ac:spMk id="6" creationId="{B0EB6B2B-7B86-4777-8711-BEC1086FAE6C}"/>
          </ac:spMkLst>
        </pc:spChg>
        <pc:spChg chg="add mod">
          <ac:chgData name="Miriam Schreiber" userId="5a452ff8-f189-44a9-9767-da59f69398bf" providerId="ADAL" clId="{7A8111AC-5017-4CF1-AB1B-6A71CD7BFCD8}" dt="2022-05-01T15:05:38.870" v="3460" actId="20577"/>
          <ac:spMkLst>
            <pc:docMk/>
            <pc:sldMk cId="1669478830" sldId="273"/>
            <ac:spMk id="8" creationId="{EFAA2DB3-AB89-4C34-B823-EAFE22208103}"/>
          </ac:spMkLst>
        </pc:spChg>
        <pc:picChg chg="add mod">
          <ac:chgData name="Miriam Schreiber" userId="5a452ff8-f189-44a9-9767-da59f69398bf" providerId="ADAL" clId="{7A8111AC-5017-4CF1-AB1B-6A71CD7BFCD8}" dt="2022-05-01T14:53:52.358" v="2515" actId="1038"/>
          <ac:picMkLst>
            <pc:docMk/>
            <pc:sldMk cId="1669478830" sldId="273"/>
            <ac:picMk id="5" creationId="{0ABBB726-A382-4337-BC4E-BF928B0E6976}"/>
          </ac:picMkLst>
        </pc:picChg>
        <pc:picChg chg="add mod">
          <ac:chgData name="Miriam Schreiber" userId="5a452ff8-f189-44a9-9767-da59f69398bf" providerId="ADAL" clId="{7A8111AC-5017-4CF1-AB1B-6A71CD7BFCD8}" dt="2022-05-01T14:53:45.694" v="2506" actId="1037"/>
          <ac:picMkLst>
            <pc:docMk/>
            <pc:sldMk cId="1669478830" sldId="273"/>
            <ac:picMk id="7" creationId="{D749D1AF-D855-4D1A-B657-B95A883DB332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6:08.606" v="3485" actId="20577"/>
        <pc:sldMkLst>
          <pc:docMk/>
          <pc:sldMk cId="4147364772" sldId="274"/>
        </pc:sldMkLst>
        <pc:spChg chg="del">
          <ac:chgData name="Miriam Schreiber" userId="5a452ff8-f189-44a9-9767-da59f69398bf" providerId="ADAL" clId="{7A8111AC-5017-4CF1-AB1B-6A71CD7BFCD8}" dt="2022-05-01T14:53:26.871" v="2434" actId="478"/>
          <ac:spMkLst>
            <pc:docMk/>
            <pc:sldMk cId="4147364772" sldId="274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29:42.653" v="558"/>
          <ac:spMkLst>
            <pc:docMk/>
            <pc:sldMk cId="4147364772" sldId="274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6:08.606" v="3485" actId="20577"/>
          <ac:spMkLst>
            <pc:docMk/>
            <pc:sldMk cId="4147364772" sldId="274"/>
            <ac:spMk id="6" creationId="{0048B1DF-517F-4412-8748-313CCB03431C}"/>
          </ac:spMkLst>
        </pc:spChg>
        <pc:spChg chg="add mod">
          <ac:chgData name="Miriam Schreiber" userId="5a452ff8-f189-44a9-9767-da59f69398bf" providerId="ADAL" clId="{7A8111AC-5017-4CF1-AB1B-6A71CD7BFCD8}" dt="2022-05-01T15:06:00.788" v="3478" actId="20577"/>
          <ac:spMkLst>
            <pc:docMk/>
            <pc:sldMk cId="4147364772" sldId="274"/>
            <ac:spMk id="8" creationId="{03C7374D-F934-4597-BAF9-6212B4655ED1}"/>
          </ac:spMkLst>
        </pc:spChg>
        <pc:picChg chg="add mod">
          <ac:chgData name="Miriam Schreiber" userId="5a452ff8-f189-44a9-9767-da59f69398bf" providerId="ADAL" clId="{7A8111AC-5017-4CF1-AB1B-6A71CD7BFCD8}" dt="2022-05-01T14:53:36.013" v="2456" actId="1038"/>
          <ac:picMkLst>
            <pc:docMk/>
            <pc:sldMk cId="4147364772" sldId="274"/>
            <ac:picMk id="5" creationId="{1C7E06A8-BFF5-44C8-BED3-42E4EDABE76F}"/>
          </ac:picMkLst>
        </pc:picChg>
        <pc:picChg chg="add mod">
          <ac:chgData name="Miriam Schreiber" userId="5a452ff8-f189-44a9-9767-da59f69398bf" providerId="ADAL" clId="{7A8111AC-5017-4CF1-AB1B-6A71CD7BFCD8}" dt="2022-05-01T14:53:25.805" v="2433" actId="1035"/>
          <ac:picMkLst>
            <pc:docMk/>
            <pc:sldMk cId="4147364772" sldId="274"/>
            <ac:picMk id="7" creationId="{F60C0200-79F4-428E-9191-D4713FB94626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6:33.982" v="3499" actId="20577"/>
        <pc:sldMkLst>
          <pc:docMk/>
          <pc:sldMk cId="3197210578" sldId="275"/>
        </pc:sldMkLst>
        <pc:spChg chg="del">
          <ac:chgData name="Miriam Schreiber" userId="5a452ff8-f189-44a9-9767-da59f69398bf" providerId="ADAL" clId="{7A8111AC-5017-4CF1-AB1B-6A71CD7BFCD8}" dt="2022-05-01T14:53:08.134" v="2379" actId="478"/>
          <ac:spMkLst>
            <pc:docMk/>
            <pc:sldMk cId="3197210578" sldId="275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29:49.478" v="565"/>
          <ac:spMkLst>
            <pc:docMk/>
            <pc:sldMk cId="3197210578" sldId="275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6:33.982" v="3499" actId="20577"/>
          <ac:spMkLst>
            <pc:docMk/>
            <pc:sldMk cId="3197210578" sldId="275"/>
            <ac:spMk id="6" creationId="{6BF33752-3FC7-4788-A089-A4082ADAD222}"/>
          </ac:spMkLst>
        </pc:spChg>
        <pc:spChg chg="add mod">
          <ac:chgData name="Miriam Schreiber" userId="5a452ff8-f189-44a9-9767-da59f69398bf" providerId="ADAL" clId="{7A8111AC-5017-4CF1-AB1B-6A71CD7BFCD8}" dt="2022-05-01T15:06:21.982" v="3492" actId="20577"/>
          <ac:spMkLst>
            <pc:docMk/>
            <pc:sldMk cId="3197210578" sldId="275"/>
            <ac:spMk id="8" creationId="{A047869D-F5AC-4947-993E-2960A3D15D87}"/>
          </ac:spMkLst>
        </pc:spChg>
        <pc:picChg chg="add mod">
          <ac:chgData name="Miriam Schreiber" userId="5a452ff8-f189-44a9-9767-da59f69398bf" providerId="ADAL" clId="{7A8111AC-5017-4CF1-AB1B-6A71CD7BFCD8}" dt="2022-05-01T14:53:15.341" v="2382" actId="1076"/>
          <ac:picMkLst>
            <pc:docMk/>
            <pc:sldMk cId="3197210578" sldId="275"/>
            <ac:picMk id="5" creationId="{946BAEF4-367D-4E74-8C78-2BEF684CFBFA}"/>
          </ac:picMkLst>
        </pc:picChg>
        <pc:picChg chg="add mod">
          <ac:chgData name="Miriam Schreiber" userId="5a452ff8-f189-44a9-9767-da59f69398bf" providerId="ADAL" clId="{7A8111AC-5017-4CF1-AB1B-6A71CD7BFCD8}" dt="2022-05-01T14:53:06.941" v="2378" actId="1037"/>
          <ac:picMkLst>
            <pc:docMk/>
            <pc:sldMk cId="3197210578" sldId="275"/>
            <ac:picMk id="7" creationId="{FA0572B5-7ED9-4294-BD9E-2793B53790E6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6:49.821" v="3513" actId="20577"/>
        <pc:sldMkLst>
          <pc:docMk/>
          <pc:sldMk cId="3440018613" sldId="276"/>
        </pc:sldMkLst>
        <pc:spChg chg="del">
          <ac:chgData name="Miriam Schreiber" userId="5a452ff8-f189-44a9-9767-da59f69398bf" providerId="ADAL" clId="{7A8111AC-5017-4CF1-AB1B-6A71CD7BFCD8}" dt="2022-05-01T14:52:52.751" v="2306" actId="478"/>
          <ac:spMkLst>
            <pc:docMk/>
            <pc:sldMk cId="3440018613" sldId="276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29:56.469" v="571"/>
          <ac:spMkLst>
            <pc:docMk/>
            <pc:sldMk cId="3440018613" sldId="276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6:49.821" v="3513" actId="20577"/>
          <ac:spMkLst>
            <pc:docMk/>
            <pc:sldMk cId="3440018613" sldId="276"/>
            <ac:spMk id="6" creationId="{2AB776A6-BAB2-44B8-9E57-E586B4F32EB3}"/>
          </ac:spMkLst>
        </pc:spChg>
        <pc:spChg chg="add mod">
          <ac:chgData name="Miriam Schreiber" userId="5a452ff8-f189-44a9-9767-da59f69398bf" providerId="ADAL" clId="{7A8111AC-5017-4CF1-AB1B-6A71CD7BFCD8}" dt="2022-05-01T15:06:45.610" v="3511" actId="20577"/>
          <ac:spMkLst>
            <pc:docMk/>
            <pc:sldMk cId="3440018613" sldId="276"/>
            <ac:spMk id="8" creationId="{D2EF0569-450E-4B60-975D-CBB7B9F41051}"/>
          </ac:spMkLst>
        </pc:spChg>
        <pc:picChg chg="add mod">
          <ac:chgData name="Miriam Schreiber" userId="5a452ff8-f189-44a9-9767-da59f69398bf" providerId="ADAL" clId="{7A8111AC-5017-4CF1-AB1B-6A71CD7BFCD8}" dt="2022-05-01T14:52:58.030" v="2331" actId="1038"/>
          <ac:picMkLst>
            <pc:docMk/>
            <pc:sldMk cId="3440018613" sldId="276"/>
            <ac:picMk id="5" creationId="{B025F16A-7BF3-4333-96D4-60CF11C3DF38}"/>
          </ac:picMkLst>
        </pc:picChg>
        <pc:picChg chg="add mod">
          <ac:chgData name="Miriam Schreiber" userId="5a452ff8-f189-44a9-9767-da59f69398bf" providerId="ADAL" clId="{7A8111AC-5017-4CF1-AB1B-6A71CD7BFCD8}" dt="2022-05-01T14:52:51.238" v="2305" actId="1037"/>
          <ac:picMkLst>
            <pc:docMk/>
            <pc:sldMk cId="3440018613" sldId="276"/>
            <ac:picMk id="7" creationId="{736C818B-28F6-4609-BCF8-1969D136025D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7:07.477" v="3528" actId="20577"/>
        <pc:sldMkLst>
          <pc:docMk/>
          <pc:sldMk cId="1826662784" sldId="277"/>
        </pc:sldMkLst>
        <pc:spChg chg="del">
          <ac:chgData name="Miriam Schreiber" userId="5a452ff8-f189-44a9-9767-da59f69398bf" providerId="ADAL" clId="{7A8111AC-5017-4CF1-AB1B-6A71CD7BFCD8}" dt="2022-05-01T14:52:38.769" v="2250" actId="478"/>
          <ac:spMkLst>
            <pc:docMk/>
            <pc:sldMk cId="1826662784" sldId="277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0:03.414" v="575"/>
          <ac:spMkLst>
            <pc:docMk/>
            <pc:sldMk cId="1826662784" sldId="277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7:07.477" v="3528" actId="20577"/>
          <ac:spMkLst>
            <pc:docMk/>
            <pc:sldMk cId="1826662784" sldId="277"/>
            <ac:spMk id="6" creationId="{693C06FC-B407-407F-A0B9-1CD61D6F0CF0}"/>
          </ac:spMkLst>
        </pc:spChg>
        <pc:spChg chg="add mod">
          <ac:chgData name="Miriam Schreiber" userId="5a452ff8-f189-44a9-9767-da59f69398bf" providerId="ADAL" clId="{7A8111AC-5017-4CF1-AB1B-6A71CD7BFCD8}" dt="2022-05-01T15:07:00.366" v="3521" actId="20577"/>
          <ac:spMkLst>
            <pc:docMk/>
            <pc:sldMk cId="1826662784" sldId="277"/>
            <ac:spMk id="8" creationId="{03F66D35-B6B1-4D90-AAEB-BBAF59B63BC1}"/>
          </ac:spMkLst>
        </pc:spChg>
        <pc:picChg chg="add mod">
          <ac:chgData name="Miriam Schreiber" userId="5a452ff8-f189-44a9-9767-da59f69398bf" providerId="ADAL" clId="{7A8111AC-5017-4CF1-AB1B-6A71CD7BFCD8}" dt="2022-05-01T14:52:37.213" v="2249" actId="1037"/>
          <ac:picMkLst>
            <pc:docMk/>
            <pc:sldMk cId="1826662784" sldId="277"/>
            <ac:picMk id="5" creationId="{DEAB1EE4-4783-4A86-9DB2-C4A738335761}"/>
          </ac:picMkLst>
        </pc:picChg>
        <pc:picChg chg="add mod">
          <ac:chgData name="Miriam Schreiber" userId="5a452ff8-f189-44a9-9767-da59f69398bf" providerId="ADAL" clId="{7A8111AC-5017-4CF1-AB1B-6A71CD7BFCD8}" dt="2022-05-01T14:52:41.768" v="2262" actId="1037"/>
          <ac:picMkLst>
            <pc:docMk/>
            <pc:sldMk cId="1826662784" sldId="277"/>
            <ac:picMk id="7" creationId="{7FE9985F-7DA8-4C8D-8460-DC8D2D212A85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7:26.704" v="3542" actId="20577"/>
        <pc:sldMkLst>
          <pc:docMk/>
          <pc:sldMk cId="1213069761" sldId="278"/>
        </pc:sldMkLst>
        <pc:spChg chg="del">
          <ac:chgData name="Miriam Schreiber" userId="5a452ff8-f189-44a9-9767-da59f69398bf" providerId="ADAL" clId="{7A8111AC-5017-4CF1-AB1B-6A71CD7BFCD8}" dt="2022-05-01T14:52:17.156" v="2218" actId="478"/>
          <ac:spMkLst>
            <pc:docMk/>
            <pc:sldMk cId="1213069761" sldId="278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0:12.377" v="579"/>
          <ac:spMkLst>
            <pc:docMk/>
            <pc:sldMk cId="1213069761" sldId="278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7:26.704" v="3542" actId="20577"/>
          <ac:spMkLst>
            <pc:docMk/>
            <pc:sldMk cId="1213069761" sldId="278"/>
            <ac:spMk id="6" creationId="{062B0B4D-BAF2-4325-B915-0CF714CEF515}"/>
          </ac:spMkLst>
        </pc:spChg>
        <pc:spChg chg="add mod">
          <ac:chgData name="Miriam Schreiber" userId="5a452ff8-f189-44a9-9767-da59f69398bf" providerId="ADAL" clId="{7A8111AC-5017-4CF1-AB1B-6A71CD7BFCD8}" dt="2022-05-01T15:07:17.950" v="3535" actId="20577"/>
          <ac:spMkLst>
            <pc:docMk/>
            <pc:sldMk cId="1213069761" sldId="278"/>
            <ac:spMk id="8" creationId="{C5F0D989-FC28-40B3-8A97-B2021A992CB5}"/>
          </ac:spMkLst>
        </pc:spChg>
        <pc:picChg chg="add mod">
          <ac:chgData name="Miriam Schreiber" userId="5a452ff8-f189-44a9-9767-da59f69398bf" providerId="ADAL" clId="{7A8111AC-5017-4CF1-AB1B-6A71CD7BFCD8}" dt="2022-05-01T14:52:24.375" v="2230" actId="1037"/>
          <ac:picMkLst>
            <pc:docMk/>
            <pc:sldMk cId="1213069761" sldId="278"/>
            <ac:picMk id="5" creationId="{E8450D08-C598-4904-95F7-0C0C86088165}"/>
          </ac:picMkLst>
        </pc:picChg>
        <pc:picChg chg="add mod">
          <ac:chgData name="Miriam Schreiber" userId="5a452ff8-f189-44a9-9767-da59f69398bf" providerId="ADAL" clId="{7A8111AC-5017-4CF1-AB1B-6A71CD7BFCD8}" dt="2022-05-01T14:52:15.735" v="2217" actId="1037"/>
          <ac:picMkLst>
            <pc:docMk/>
            <pc:sldMk cId="1213069761" sldId="278"/>
            <ac:picMk id="7" creationId="{77AFAAAB-EBCF-4357-B9C6-AD86FC909B99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7:39.563" v="3554" actId="20577"/>
        <pc:sldMkLst>
          <pc:docMk/>
          <pc:sldMk cId="2424307640" sldId="279"/>
        </pc:sldMkLst>
        <pc:spChg chg="del">
          <ac:chgData name="Miriam Schreiber" userId="5a452ff8-f189-44a9-9767-da59f69398bf" providerId="ADAL" clId="{7A8111AC-5017-4CF1-AB1B-6A71CD7BFCD8}" dt="2022-05-01T14:52:00.455" v="2137" actId="478"/>
          <ac:spMkLst>
            <pc:docMk/>
            <pc:sldMk cId="2424307640" sldId="279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0:18.364" v="583"/>
          <ac:spMkLst>
            <pc:docMk/>
            <pc:sldMk cId="2424307640" sldId="279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7:39.563" v="3554" actId="20577"/>
          <ac:spMkLst>
            <pc:docMk/>
            <pc:sldMk cId="2424307640" sldId="279"/>
            <ac:spMk id="6" creationId="{650CACA9-9C0D-49E2-A76D-AB5821A41F77}"/>
          </ac:spMkLst>
        </pc:spChg>
        <pc:spChg chg="add mod">
          <ac:chgData name="Miriam Schreiber" userId="5a452ff8-f189-44a9-9767-da59f69398bf" providerId="ADAL" clId="{7A8111AC-5017-4CF1-AB1B-6A71CD7BFCD8}" dt="2022-05-01T15:07:33.047" v="3547" actId="20577"/>
          <ac:spMkLst>
            <pc:docMk/>
            <pc:sldMk cId="2424307640" sldId="279"/>
            <ac:spMk id="8" creationId="{9547C9F9-2ECC-4332-8A1F-6B0D240641C1}"/>
          </ac:spMkLst>
        </pc:spChg>
        <pc:picChg chg="add mod">
          <ac:chgData name="Miriam Schreiber" userId="5a452ff8-f189-44a9-9767-da59f69398bf" providerId="ADAL" clId="{7A8111AC-5017-4CF1-AB1B-6A71CD7BFCD8}" dt="2022-05-01T14:52:07.158" v="2169" actId="1037"/>
          <ac:picMkLst>
            <pc:docMk/>
            <pc:sldMk cId="2424307640" sldId="279"/>
            <ac:picMk id="5" creationId="{C0893EBD-47C9-4CF2-9638-9A118A5C3256}"/>
          </ac:picMkLst>
        </pc:picChg>
        <pc:picChg chg="add mod">
          <ac:chgData name="Miriam Schreiber" userId="5a452ff8-f189-44a9-9767-da59f69398bf" providerId="ADAL" clId="{7A8111AC-5017-4CF1-AB1B-6A71CD7BFCD8}" dt="2022-05-01T14:51:59.326" v="2136" actId="1037"/>
          <ac:picMkLst>
            <pc:docMk/>
            <pc:sldMk cId="2424307640" sldId="279"/>
            <ac:picMk id="7" creationId="{6750A4A8-CE2C-4C7A-9F50-2B396D368BBB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7:55.698" v="3568" actId="20577"/>
        <pc:sldMkLst>
          <pc:docMk/>
          <pc:sldMk cId="508478025" sldId="280"/>
        </pc:sldMkLst>
        <pc:spChg chg="del">
          <ac:chgData name="Miriam Schreiber" userId="5a452ff8-f189-44a9-9767-da59f69398bf" providerId="ADAL" clId="{7A8111AC-5017-4CF1-AB1B-6A71CD7BFCD8}" dt="2022-05-01T14:51:45.390" v="2059" actId="478"/>
          <ac:spMkLst>
            <pc:docMk/>
            <pc:sldMk cId="508478025" sldId="280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0:44.461" v="590"/>
          <ac:spMkLst>
            <pc:docMk/>
            <pc:sldMk cId="508478025" sldId="280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7:55.698" v="3568" actId="20577"/>
          <ac:spMkLst>
            <pc:docMk/>
            <pc:sldMk cId="508478025" sldId="280"/>
            <ac:spMk id="6" creationId="{508E004A-EF2B-4DC0-BEE9-82D6E1BD7208}"/>
          </ac:spMkLst>
        </pc:spChg>
        <pc:spChg chg="add mod">
          <ac:chgData name="Miriam Schreiber" userId="5a452ff8-f189-44a9-9767-da59f69398bf" providerId="ADAL" clId="{7A8111AC-5017-4CF1-AB1B-6A71CD7BFCD8}" dt="2022-05-01T15:07:49.171" v="3561" actId="20577"/>
          <ac:spMkLst>
            <pc:docMk/>
            <pc:sldMk cId="508478025" sldId="280"/>
            <ac:spMk id="8" creationId="{C05B744C-1F3B-496A-9F47-7B392183CD02}"/>
          </ac:spMkLst>
        </pc:spChg>
        <pc:picChg chg="add mod">
          <ac:chgData name="Miriam Schreiber" userId="5a452ff8-f189-44a9-9767-da59f69398bf" providerId="ADAL" clId="{7A8111AC-5017-4CF1-AB1B-6A71CD7BFCD8}" dt="2022-05-01T14:51:49.342" v="2079" actId="1038"/>
          <ac:picMkLst>
            <pc:docMk/>
            <pc:sldMk cId="508478025" sldId="280"/>
            <ac:picMk id="5" creationId="{5D819495-A1F9-41A5-B44A-0370740F231F}"/>
          </ac:picMkLst>
        </pc:picChg>
        <pc:picChg chg="add mod">
          <ac:chgData name="Miriam Schreiber" userId="5a452ff8-f189-44a9-9767-da59f69398bf" providerId="ADAL" clId="{7A8111AC-5017-4CF1-AB1B-6A71CD7BFCD8}" dt="2022-05-01T14:51:44.317" v="2058" actId="1037"/>
          <ac:picMkLst>
            <pc:docMk/>
            <pc:sldMk cId="508478025" sldId="280"/>
            <ac:picMk id="7" creationId="{7DBBF80C-C0F6-499D-900E-3098133BB5E2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8:02.260" v="3570" actId="20577"/>
        <pc:sldMkLst>
          <pc:docMk/>
          <pc:sldMk cId="1041015941" sldId="281"/>
        </pc:sldMkLst>
        <pc:spChg chg="del">
          <ac:chgData name="Miriam Schreiber" userId="5a452ff8-f189-44a9-9767-da59f69398bf" providerId="ADAL" clId="{7A8111AC-5017-4CF1-AB1B-6A71CD7BFCD8}" dt="2022-05-01T14:51:33.068" v="2052" actId="478"/>
          <ac:spMkLst>
            <pc:docMk/>
            <pc:sldMk cId="1041015941" sldId="281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1:04.805" v="597"/>
          <ac:spMkLst>
            <pc:docMk/>
            <pc:sldMk cId="1041015941" sldId="281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8:02.260" v="3570" actId="20577"/>
          <ac:spMkLst>
            <pc:docMk/>
            <pc:sldMk cId="1041015941" sldId="281"/>
            <ac:spMk id="6" creationId="{5A7B7D13-5693-4F42-8663-C0D4C0026FF8}"/>
          </ac:spMkLst>
        </pc:spChg>
        <pc:spChg chg="add mod">
          <ac:chgData name="Miriam Schreiber" userId="5a452ff8-f189-44a9-9767-da59f69398bf" providerId="ADAL" clId="{7A8111AC-5017-4CF1-AB1B-6A71CD7BFCD8}" dt="2022-05-01T15:07:59.747" v="3569" actId="20577"/>
          <ac:spMkLst>
            <pc:docMk/>
            <pc:sldMk cId="1041015941" sldId="281"/>
            <ac:spMk id="8" creationId="{7521C334-F692-4D3C-8EB5-86B8FFF629F7}"/>
          </ac:spMkLst>
        </pc:spChg>
        <pc:picChg chg="add mod">
          <ac:chgData name="Miriam Schreiber" userId="5a452ff8-f189-44a9-9767-da59f69398bf" providerId="ADAL" clId="{7A8111AC-5017-4CF1-AB1B-6A71CD7BFCD8}" dt="2022-05-01T14:51:38.869" v="2054" actId="1076"/>
          <ac:picMkLst>
            <pc:docMk/>
            <pc:sldMk cId="1041015941" sldId="281"/>
            <ac:picMk id="5" creationId="{E25E4F12-BB81-435F-8FF6-8245C4B938DF}"/>
          </ac:picMkLst>
        </pc:picChg>
        <pc:picChg chg="add mod">
          <ac:chgData name="Miriam Schreiber" userId="5a452ff8-f189-44a9-9767-da59f69398bf" providerId="ADAL" clId="{7A8111AC-5017-4CF1-AB1B-6A71CD7BFCD8}" dt="2022-05-01T14:51:31.750" v="2051" actId="1037"/>
          <ac:picMkLst>
            <pc:docMk/>
            <pc:sldMk cId="1041015941" sldId="281"/>
            <ac:picMk id="7" creationId="{98CC59A3-AEBE-4908-B2E0-806C5B0788A8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8:17.810" v="3575" actId="20577"/>
        <pc:sldMkLst>
          <pc:docMk/>
          <pc:sldMk cId="3079572683" sldId="282"/>
        </pc:sldMkLst>
        <pc:spChg chg="del">
          <ac:chgData name="Miriam Schreiber" userId="5a452ff8-f189-44a9-9767-da59f69398bf" providerId="ADAL" clId="{7A8111AC-5017-4CF1-AB1B-6A71CD7BFCD8}" dt="2022-05-01T14:51:12.593" v="1992" actId="478"/>
          <ac:spMkLst>
            <pc:docMk/>
            <pc:sldMk cId="3079572683" sldId="282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1:14.745" v="604"/>
          <ac:spMkLst>
            <pc:docMk/>
            <pc:sldMk cId="3079572683" sldId="282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8:17.810" v="3575" actId="20577"/>
          <ac:spMkLst>
            <pc:docMk/>
            <pc:sldMk cId="3079572683" sldId="282"/>
            <ac:spMk id="6" creationId="{C2ABBA9E-5E78-4392-9620-B9C9CD81C30F}"/>
          </ac:spMkLst>
        </pc:spChg>
        <pc:spChg chg="add mod">
          <ac:chgData name="Miriam Schreiber" userId="5a452ff8-f189-44a9-9767-da59f69398bf" providerId="ADAL" clId="{7A8111AC-5017-4CF1-AB1B-6A71CD7BFCD8}" dt="2022-05-01T15:08:10.314" v="3571" actId="20577"/>
          <ac:spMkLst>
            <pc:docMk/>
            <pc:sldMk cId="3079572683" sldId="282"/>
            <ac:spMk id="8" creationId="{B8004C34-4A3E-4515-B374-561A441300D6}"/>
          </ac:spMkLst>
        </pc:spChg>
        <pc:picChg chg="add mod">
          <ac:chgData name="Miriam Schreiber" userId="5a452ff8-f189-44a9-9767-da59f69398bf" providerId="ADAL" clId="{7A8111AC-5017-4CF1-AB1B-6A71CD7BFCD8}" dt="2022-05-01T14:51:22.764" v="2002" actId="1038"/>
          <ac:picMkLst>
            <pc:docMk/>
            <pc:sldMk cId="3079572683" sldId="282"/>
            <ac:picMk id="5" creationId="{8C8148EF-51D0-451A-94C5-60AB6EFC3C02}"/>
          </ac:picMkLst>
        </pc:picChg>
        <pc:picChg chg="add mod">
          <ac:chgData name="Miriam Schreiber" userId="5a452ff8-f189-44a9-9767-da59f69398bf" providerId="ADAL" clId="{7A8111AC-5017-4CF1-AB1B-6A71CD7BFCD8}" dt="2022-05-01T14:51:11.141" v="1991" actId="1038"/>
          <ac:picMkLst>
            <pc:docMk/>
            <pc:sldMk cId="3079572683" sldId="282"/>
            <ac:picMk id="7" creationId="{98BD506A-C49B-40DA-8018-819047D73A18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8:26.345" v="3581" actId="20577"/>
        <pc:sldMkLst>
          <pc:docMk/>
          <pc:sldMk cId="403888727" sldId="283"/>
        </pc:sldMkLst>
        <pc:spChg chg="del">
          <ac:chgData name="Miriam Schreiber" userId="5a452ff8-f189-44a9-9767-da59f69398bf" providerId="ADAL" clId="{7A8111AC-5017-4CF1-AB1B-6A71CD7BFCD8}" dt="2022-05-01T14:50:50.013" v="1909" actId="478"/>
          <ac:spMkLst>
            <pc:docMk/>
            <pc:sldMk cId="403888727" sldId="283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1:23.653" v="611"/>
          <ac:spMkLst>
            <pc:docMk/>
            <pc:sldMk cId="403888727" sldId="283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8:26.345" v="3581" actId="20577"/>
          <ac:spMkLst>
            <pc:docMk/>
            <pc:sldMk cId="403888727" sldId="283"/>
            <ac:spMk id="6" creationId="{2E16B56B-25A7-4CAB-93B0-FD84BD9B04C9}"/>
          </ac:spMkLst>
        </pc:spChg>
        <pc:spChg chg="add mod">
          <ac:chgData name="Miriam Schreiber" userId="5a452ff8-f189-44a9-9767-da59f69398bf" providerId="ADAL" clId="{7A8111AC-5017-4CF1-AB1B-6A71CD7BFCD8}" dt="2022-05-01T15:08:22.867" v="3578" actId="20577"/>
          <ac:spMkLst>
            <pc:docMk/>
            <pc:sldMk cId="403888727" sldId="283"/>
            <ac:spMk id="8" creationId="{EDB6F7AD-EFB1-45D3-B2C2-A6004941CA75}"/>
          </ac:spMkLst>
        </pc:spChg>
        <pc:picChg chg="add mod">
          <ac:chgData name="Miriam Schreiber" userId="5a452ff8-f189-44a9-9767-da59f69398bf" providerId="ADAL" clId="{7A8111AC-5017-4CF1-AB1B-6A71CD7BFCD8}" dt="2022-05-01T14:51:00.909" v="1928" actId="1037"/>
          <ac:picMkLst>
            <pc:docMk/>
            <pc:sldMk cId="403888727" sldId="283"/>
            <ac:picMk id="5" creationId="{0B176498-8208-4664-BD64-0CA11B44AE2D}"/>
          </ac:picMkLst>
        </pc:picChg>
        <pc:picChg chg="add mod">
          <ac:chgData name="Miriam Schreiber" userId="5a452ff8-f189-44a9-9767-da59f69398bf" providerId="ADAL" clId="{7A8111AC-5017-4CF1-AB1B-6A71CD7BFCD8}" dt="2022-05-01T14:50:47.734" v="1908" actId="1037"/>
          <ac:picMkLst>
            <pc:docMk/>
            <pc:sldMk cId="403888727" sldId="283"/>
            <ac:picMk id="7" creationId="{26D0AB12-BB16-4040-805B-9C00BF57F443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8:35.821" v="3585" actId="20577"/>
        <pc:sldMkLst>
          <pc:docMk/>
          <pc:sldMk cId="380493374" sldId="284"/>
        </pc:sldMkLst>
        <pc:spChg chg="del">
          <ac:chgData name="Miriam Schreiber" userId="5a452ff8-f189-44a9-9767-da59f69398bf" providerId="ADAL" clId="{7A8111AC-5017-4CF1-AB1B-6A71CD7BFCD8}" dt="2022-05-01T14:50:28.782" v="1861" actId="478"/>
          <ac:spMkLst>
            <pc:docMk/>
            <pc:sldMk cId="380493374" sldId="284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1:34.005" v="619"/>
          <ac:spMkLst>
            <pc:docMk/>
            <pc:sldMk cId="380493374" sldId="284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8:35.821" v="3585" actId="20577"/>
          <ac:spMkLst>
            <pc:docMk/>
            <pc:sldMk cId="380493374" sldId="284"/>
            <ac:spMk id="6" creationId="{48A87CD9-7C3A-4B5B-AC44-B6541CEBE8C7}"/>
          </ac:spMkLst>
        </pc:spChg>
        <pc:spChg chg="add mod">
          <ac:chgData name="Miriam Schreiber" userId="5a452ff8-f189-44a9-9767-da59f69398bf" providerId="ADAL" clId="{7A8111AC-5017-4CF1-AB1B-6A71CD7BFCD8}" dt="2022-05-01T15:08:31.632" v="3582" actId="20577"/>
          <ac:spMkLst>
            <pc:docMk/>
            <pc:sldMk cId="380493374" sldId="284"/>
            <ac:spMk id="8" creationId="{F7825EB0-F84F-4CFE-81F2-8B4A4959CD9E}"/>
          </ac:spMkLst>
        </pc:spChg>
        <pc:picChg chg="add mod">
          <ac:chgData name="Miriam Schreiber" userId="5a452ff8-f189-44a9-9767-da59f69398bf" providerId="ADAL" clId="{7A8111AC-5017-4CF1-AB1B-6A71CD7BFCD8}" dt="2022-05-01T14:50:36.924" v="1871" actId="1035"/>
          <ac:picMkLst>
            <pc:docMk/>
            <pc:sldMk cId="380493374" sldId="284"/>
            <ac:picMk id="5" creationId="{F8625E30-3463-49EF-BA76-C55172A3633F}"/>
          </ac:picMkLst>
        </pc:picChg>
        <pc:picChg chg="add mod">
          <ac:chgData name="Miriam Schreiber" userId="5a452ff8-f189-44a9-9767-da59f69398bf" providerId="ADAL" clId="{7A8111AC-5017-4CF1-AB1B-6A71CD7BFCD8}" dt="2022-05-01T14:50:27.556" v="1860" actId="1037"/>
          <ac:picMkLst>
            <pc:docMk/>
            <pc:sldMk cId="380493374" sldId="284"/>
            <ac:picMk id="7" creationId="{FB2DB74D-274C-465F-9A94-51C9EC709621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8:49.234" v="3591" actId="20577"/>
        <pc:sldMkLst>
          <pc:docMk/>
          <pc:sldMk cId="1518853995" sldId="285"/>
        </pc:sldMkLst>
        <pc:spChg chg="del mod">
          <ac:chgData name="Miriam Schreiber" userId="5a452ff8-f189-44a9-9767-da59f69398bf" providerId="ADAL" clId="{7A8111AC-5017-4CF1-AB1B-6A71CD7BFCD8}" dt="2022-05-01T14:50:03.958" v="1781" actId="478"/>
          <ac:spMkLst>
            <pc:docMk/>
            <pc:sldMk cId="1518853995" sldId="285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1:40.271" v="623"/>
          <ac:spMkLst>
            <pc:docMk/>
            <pc:sldMk cId="1518853995" sldId="285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8:49.234" v="3591" actId="20577"/>
          <ac:spMkLst>
            <pc:docMk/>
            <pc:sldMk cId="1518853995" sldId="285"/>
            <ac:spMk id="6" creationId="{4D60637C-53D7-4E02-81B7-14B0C1308C2D}"/>
          </ac:spMkLst>
        </pc:spChg>
        <pc:spChg chg="add mod">
          <ac:chgData name="Miriam Schreiber" userId="5a452ff8-f189-44a9-9767-da59f69398bf" providerId="ADAL" clId="{7A8111AC-5017-4CF1-AB1B-6A71CD7BFCD8}" dt="2022-05-01T15:08:43.145" v="3588" actId="20577"/>
          <ac:spMkLst>
            <pc:docMk/>
            <pc:sldMk cId="1518853995" sldId="285"/>
            <ac:spMk id="8" creationId="{FD00B717-DE55-4C53-ACEA-46D8BA1C6656}"/>
          </ac:spMkLst>
        </pc:spChg>
        <pc:picChg chg="add mod">
          <ac:chgData name="Miriam Schreiber" userId="5a452ff8-f189-44a9-9767-da59f69398bf" providerId="ADAL" clId="{7A8111AC-5017-4CF1-AB1B-6A71CD7BFCD8}" dt="2022-05-01T14:50:17.220" v="1802" actId="1036"/>
          <ac:picMkLst>
            <pc:docMk/>
            <pc:sldMk cId="1518853995" sldId="285"/>
            <ac:picMk id="5" creationId="{A46F8D0B-CFBC-46FE-B586-3C16227D5BE2}"/>
          </ac:picMkLst>
        </pc:picChg>
        <pc:picChg chg="add mod">
          <ac:chgData name="Miriam Schreiber" userId="5a452ff8-f189-44a9-9767-da59f69398bf" providerId="ADAL" clId="{7A8111AC-5017-4CF1-AB1B-6A71CD7BFCD8}" dt="2022-05-01T14:50:08.076" v="1796" actId="1037"/>
          <ac:picMkLst>
            <pc:docMk/>
            <pc:sldMk cId="1518853995" sldId="285"/>
            <ac:picMk id="7" creationId="{ABC9FD2D-36F2-46D4-A9D7-3C222D6859E9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9:03.942" v="3596" actId="20577"/>
        <pc:sldMkLst>
          <pc:docMk/>
          <pc:sldMk cId="4210948899" sldId="286"/>
        </pc:sldMkLst>
        <pc:spChg chg="del">
          <ac:chgData name="Miriam Schreiber" userId="5a452ff8-f189-44a9-9767-da59f69398bf" providerId="ADAL" clId="{7A8111AC-5017-4CF1-AB1B-6A71CD7BFCD8}" dt="2022-05-01T14:49:48.406" v="1769" actId="478"/>
          <ac:spMkLst>
            <pc:docMk/>
            <pc:sldMk cId="4210948899" sldId="286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1:47.315" v="630"/>
          <ac:spMkLst>
            <pc:docMk/>
            <pc:sldMk cId="4210948899" sldId="286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09:03.942" v="3596" actId="20577"/>
          <ac:spMkLst>
            <pc:docMk/>
            <pc:sldMk cId="4210948899" sldId="286"/>
            <ac:spMk id="6" creationId="{5BB469A1-1C03-4F61-B510-A317EED09C2D}"/>
          </ac:spMkLst>
        </pc:spChg>
        <pc:spChg chg="add mod">
          <ac:chgData name="Miriam Schreiber" userId="5a452ff8-f189-44a9-9767-da59f69398bf" providerId="ADAL" clId="{7A8111AC-5017-4CF1-AB1B-6A71CD7BFCD8}" dt="2022-05-01T15:08:54.187" v="3594" actId="20577"/>
          <ac:spMkLst>
            <pc:docMk/>
            <pc:sldMk cId="4210948899" sldId="286"/>
            <ac:spMk id="8" creationId="{138202AF-DE71-488E-968D-A106D96143AA}"/>
          </ac:spMkLst>
        </pc:spChg>
        <pc:picChg chg="add mod">
          <ac:chgData name="Miriam Schreiber" userId="5a452ff8-f189-44a9-9767-da59f69398bf" providerId="ADAL" clId="{7A8111AC-5017-4CF1-AB1B-6A71CD7BFCD8}" dt="2022-05-01T14:49:57.701" v="1778" actId="1035"/>
          <ac:picMkLst>
            <pc:docMk/>
            <pc:sldMk cId="4210948899" sldId="286"/>
            <ac:picMk id="5" creationId="{4C22AE10-3E9E-491F-AC47-E4B7B02692F7}"/>
          </ac:picMkLst>
        </pc:picChg>
        <pc:picChg chg="add mod">
          <ac:chgData name="Miriam Schreiber" userId="5a452ff8-f189-44a9-9767-da59f69398bf" providerId="ADAL" clId="{7A8111AC-5017-4CF1-AB1B-6A71CD7BFCD8}" dt="2022-05-01T14:49:47.077" v="1768" actId="1037"/>
          <ac:picMkLst>
            <pc:docMk/>
            <pc:sldMk cId="4210948899" sldId="286"/>
            <ac:picMk id="7" creationId="{518C1B49-07FD-49D8-8E6E-4F26EB4AC387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9:22.970" v="3605" actId="20577"/>
        <pc:sldMkLst>
          <pc:docMk/>
          <pc:sldMk cId="931156729" sldId="287"/>
        </pc:sldMkLst>
        <pc:spChg chg="del">
          <ac:chgData name="Miriam Schreiber" userId="5a452ff8-f189-44a9-9767-da59f69398bf" providerId="ADAL" clId="{7A8111AC-5017-4CF1-AB1B-6A71CD7BFCD8}" dt="2022-05-01T14:49:29.973" v="1672" actId="478"/>
          <ac:spMkLst>
            <pc:docMk/>
            <pc:sldMk cId="931156729" sldId="287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1:53.189" v="636"/>
          <ac:spMkLst>
            <pc:docMk/>
            <pc:sldMk cId="931156729" sldId="287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09:22.970" v="3605" actId="20577"/>
          <ac:spMkLst>
            <pc:docMk/>
            <pc:sldMk cId="931156729" sldId="287"/>
            <ac:spMk id="6" creationId="{29551B27-21AC-4C8D-B0D4-A619BA82A16A}"/>
          </ac:spMkLst>
        </pc:spChg>
        <pc:spChg chg="add mod">
          <ac:chgData name="Miriam Schreiber" userId="5a452ff8-f189-44a9-9767-da59f69398bf" providerId="ADAL" clId="{7A8111AC-5017-4CF1-AB1B-6A71CD7BFCD8}" dt="2022-05-01T15:09:12.194" v="3599" actId="20577"/>
          <ac:spMkLst>
            <pc:docMk/>
            <pc:sldMk cId="931156729" sldId="287"/>
            <ac:spMk id="8" creationId="{829181EA-7717-44C2-8535-80ED0F41B6EF}"/>
          </ac:spMkLst>
        </pc:spChg>
        <pc:picChg chg="add mod">
          <ac:chgData name="Miriam Schreiber" userId="5a452ff8-f189-44a9-9767-da59f69398bf" providerId="ADAL" clId="{7A8111AC-5017-4CF1-AB1B-6A71CD7BFCD8}" dt="2022-05-01T14:49:35.102" v="1703" actId="1037"/>
          <ac:picMkLst>
            <pc:docMk/>
            <pc:sldMk cId="931156729" sldId="287"/>
            <ac:picMk id="5" creationId="{62008741-57C0-4B93-86A2-F69CAA088AA4}"/>
          </ac:picMkLst>
        </pc:picChg>
        <pc:picChg chg="add mod">
          <ac:chgData name="Miriam Schreiber" userId="5a452ff8-f189-44a9-9767-da59f69398bf" providerId="ADAL" clId="{7A8111AC-5017-4CF1-AB1B-6A71CD7BFCD8}" dt="2022-05-01T14:49:28.065" v="1671" actId="1037"/>
          <ac:picMkLst>
            <pc:docMk/>
            <pc:sldMk cId="931156729" sldId="287"/>
            <ac:picMk id="7" creationId="{6D1E2090-C932-4892-91C1-4DC1D2D7114D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09:48.047" v="3613" actId="20577"/>
        <pc:sldMkLst>
          <pc:docMk/>
          <pc:sldMk cId="539789028" sldId="288"/>
        </pc:sldMkLst>
        <pc:spChg chg="del">
          <ac:chgData name="Miriam Schreiber" userId="5a452ff8-f189-44a9-9767-da59f69398bf" providerId="ADAL" clId="{7A8111AC-5017-4CF1-AB1B-6A71CD7BFCD8}" dt="2022-05-01T14:48:43.133" v="1539" actId="478"/>
          <ac:spMkLst>
            <pc:docMk/>
            <pc:sldMk cId="539789028" sldId="288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2:12.281" v="652"/>
          <ac:spMkLst>
            <pc:docMk/>
            <pc:sldMk cId="539789028" sldId="288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09:48.047" v="3613" actId="20577"/>
          <ac:spMkLst>
            <pc:docMk/>
            <pc:sldMk cId="539789028" sldId="288"/>
            <ac:spMk id="6" creationId="{45DEC47C-E0EE-41D9-95D9-3F6B1D862F69}"/>
          </ac:spMkLst>
        </pc:spChg>
        <pc:spChg chg="add mod">
          <ac:chgData name="Miriam Schreiber" userId="5a452ff8-f189-44a9-9767-da59f69398bf" providerId="ADAL" clId="{7A8111AC-5017-4CF1-AB1B-6A71CD7BFCD8}" dt="2022-05-01T15:09:40.594" v="3611" actId="20577"/>
          <ac:spMkLst>
            <pc:docMk/>
            <pc:sldMk cId="539789028" sldId="288"/>
            <ac:spMk id="8" creationId="{9CBA7C0B-A56B-4C35-908D-47612426BE3F}"/>
          </ac:spMkLst>
        </pc:spChg>
        <pc:picChg chg="add mod">
          <ac:chgData name="Miriam Schreiber" userId="5a452ff8-f189-44a9-9767-da59f69398bf" providerId="ADAL" clId="{7A8111AC-5017-4CF1-AB1B-6A71CD7BFCD8}" dt="2022-05-01T14:48:57.468" v="1585" actId="1037"/>
          <ac:picMkLst>
            <pc:docMk/>
            <pc:sldMk cId="539789028" sldId="288"/>
            <ac:picMk id="5" creationId="{EE8FF4F8-02CB-464A-8391-F0857FC66669}"/>
          </ac:picMkLst>
        </pc:picChg>
        <pc:picChg chg="add mod">
          <ac:chgData name="Miriam Schreiber" userId="5a452ff8-f189-44a9-9767-da59f69398bf" providerId="ADAL" clId="{7A8111AC-5017-4CF1-AB1B-6A71CD7BFCD8}" dt="2022-05-01T14:48:48.710" v="1561" actId="1038"/>
          <ac:picMkLst>
            <pc:docMk/>
            <pc:sldMk cId="539789028" sldId="288"/>
            <ac:picMk id="7" creationId="{09C27904-0341-4F65-91A3-D07335C3DB7F}"/>
          </ac:picMkLst>
        </pc:picChg>
      </pc:sldChg>
      <pc:sldChg chg="addSp delSp modSp add mod ord">
        <pc:chgData name="Miriam Schreiber" userId="5a452ff8-f189-44a9-9767-da59f69398bf" providerId="ADAL" clId="{7A8111AC-5017-4CF1-AB1B-6A71CD7BFCD8}" dt="2022-05-01T15:09:35.428" v="3608" actId="20577"/>
        <pc:sldMkLst>
          <pc:docMk/>
          <pc:sldMk cId="1050678150" sldId="289"/>
        </pc:sldMkLst>
        <pc:spChg chg="del">
          <ac:chgData name="Miriam Schreiber" userId="5a452ff8-f189-44a9-9767-da59f69398bf" providerId="ADAL" clId="{7A8111AC-5017-4CF1-AB1B-6A71CD7BFCD8}" dt="2022-05-01T14:49:18.189" v="1655" actId="478"/>
          <ac:spMkLst>
            <pc:docMk/>
            <pc:sldMk cId="1050678150" sldId="289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2:01.747" v="644"/>
          <ac:spMkLst>
            <pc:docMk/>
            <pc:sldMk cId="1050678150" sldId="289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09:35.428" v="3608" actId="20577"/>
          <ac:spMkLst>
            <pc:docMk/>
            <pc:sldMk cId="1050678150" sldId="289"/>
            <ac:spMk id="6" creationId="{6BA0B57D-FB38-431E-A464-D415DFE34D74}"/>
          </ac:spMkLst>
        </pc:spChg>
        <pc:spChg chg="add mod">
          <ac:chgData name="Miriam Schreiber" userId="5a452ff8-f189-44a9-9767-da59f69398bf" providerId="ADAL" clId="{7A8111AC-5017-4CF1-AB1B-6A71CD7BFCD8}" dt="2022-05-01T15:09:29.335" v="3606" actId="20577"/>
          <ac:spMkLst>
            <pc:docMk/>
            <pc:sldMk cId="1050678150" sldId="289"/>
            <ac:spMk id="8" creationId="{581E3B7D-0F4E-49C9-A1E2-73FA796AD86C}"/>
          </ac:spMkLst>
        </pc:spChg>
        <pc:picChg chg="add mod">
          <ac:chgData name="Miriam Schreiber" userId="5a452ff8-f189-44a9-9767-da59f69398bf" providerId="ADAL" clId="{7A8111AC-5017-4CF1-AB1B-6A71CD7BFCD8}" dt="2022-05-01T14:49:15.853" v="1654" actId="1037"/>
          <ac:picMkLst>
            <pc:docMk/>
            <pc:sldMk cId="1050678150" sldId="289"/>
            <ac:picMk id="5" creationId="{7F3D82EC-2EDD-47B0-8DCC-0C9122F3E153}"/>
          </ac:picMkLst>
        </pc:picChg>
        <pc:picChg chg="add mod">
          <ac:chgData name="Miriam Schreiber" userId="5a452ff8-f189-44a9-9767-da59f69398bf" providerId="ADAL" clId="{7A8111AC-5017-4CF1-AB1B-6A71CD7BFCD8}" dt="2022-05-01T14:49:07.813" v="1639" actId="1037"/>
          <ac:picMkLst>
            <pc:docMk/>
            <pc:sldMk cId="1050678150" sldId="289"/>
            <ac:picMk id="7" creationId="{7EA0ADEB-1414-44B7-A3E2-137DA953A84E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00.210" v="3620" actId="20577"/>
        <pc:sldMkLst>
          <pc:docMk/>
          <pc:sldMk cId="3331911335" sldId="290"/>
        </pc:sldMkLst>
        <pc:spChg chg="del">
          <ac:chgData name="Miriam Schreiber" userId="5a452ff8-f189-44a9-9767-da59f69398bf" providerId="ADAL" clId="{7A8111AC-5017-4CF1-AB1B-6A71CD7BFCD8}" dt="2022-05-01T14:48:24.645" v="1507" actId="478"/>
          <ac:spMkLst>
            <pc:docMk/>
            <pc:sldMk cId="3331911335" sldId="290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2:19.724" v="659"/>
          <ac:spMkLst>
            <pc:docMk/>
            <pc:sldMk cId="3331911335" sldId="290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10:00.210" v="3620" actId="20577"/>
          <ac:spMkLst>
            <pc:docMk/>
            <pc:sldMk cId="3331911335" sldId="290"/>
            <ac:spMk id="6" creationId="{C3948DBD-C6BE-419C-9B95-12A5E92359EB}"/>
          </ac:spMkLst>
        </pc:spChg>
        <pc:spChg chg="add mod">
          <ac:chgData name="Miriam Schreiber" userId="5a452ff8-f189-44a9-9767-da59f69398bf" providerId="ADAL" clId="{7A8111AC-5017-4CF1-AB1B-6A71CD7BFCD8}" dt="2022-05-01T15:09:54.050" v="3617" actId="20577"/>
          <ac:spMkLst>
            <pc:docMk/>
            <pc:sldMk cId="3331911335" sldId="290"/>
            <ac:spMk id="8" creationId="{174ED430-0C08-4969-84B5-7909967EE0A7}"/>
          </ac:spMkLst>
        </pc:spChg>
        <pc:picChg chg="add mod">
          <ac:chgData name="Miriam Schreiber" userId="5a452ff8-f189-44a9-9767-da59f69398bf" providerId="ADAL" clId="{7A8111AC-5017-4CF1-AB1B-6A71CD7BFCD8}" dt="2022-05-01T14:48:39.773" v="1538" actId="1038"/>
          <ac:picMkLst>
            <pc:docMk/>
            <pc:sldMk cId="3331911335" sldId="290"/>
            <ac:picMk id="5" creationId="{A9ECAEBB-9CAE-4EF3-B3A7-C7B35C95CCF4}"/>
          </ac:picMkLst>
        </pc:picChg>
        <pc:picChg chg="add mod">
          <ac:chgData name="Miriam Schreiber" userId="5a452ff8-f189-44a9-9767-da59f69398bf" providerId="ADAL" clId="{7A8111AC-5017-4CF1-AB1B-6A71CD7BFCD8}" dt="2022-05-01T14:48:29.837" v="1524" actId="1037"/>
          <ac:picMkLst>
            <pc:docMk/>
            <pc:sldMk cId="3331911335" sldId="290"/>
            <ac:picMk id="7" creationId="{2590CF3B-1DEB-49D4-9B81-FACF20BD2AE7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14.029" v="3627" actId="20577"/>
        <pc:sldMkLst>
          <pc:docMk/>
          <pc:sldMk cId="73139265" sldId="291"/>
        </pc:sldMkLst>
        <pc:spChg chg="del">
          <ac:chgData name="Miriam Schreiber" userId="5a452ff8-f189-44a9-9767-da59f69398bf" providerId="ADAL" clId="{7A8111AC-5017-4CF1-AB1B-6A71CD7BFCD8}" dt="2022-05-01T14:48:20.758" v="1506" actId="478"/>
          <ac:spMkLst>
            <pc:docMk/>
            <pc:sldMk cId="73139265" sldId="291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2:29.890" v="663"/>
          <ac:spMkLst>
            <pc:docMk/>
            <pc:sldMk cId="73139265" sldId="291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10:11.421" v="3623" actId="20577"/>
          <ac:spMkLst>
            <pc:docMk/>
            <pc:sldMk cId="73139265" sldId="291"/>
            <ac:spMk id="6" creationId="{DC5F5444-229F-4DD8-A4D1-94AA5FA88350}"/>
          </ac:spMkLst>
        </pc:spChg>
        <pc:spChg chg="add mod">
          <ac:chgData name="Miriam Schreiber" userId="5a452ff8-f189-44a9-9767-da59f69398bf" providerId="ADAL" clId="{7A8111AC-5017-4CF1-AB1B-6A71CD7BFCD8}" dt="2022-05-01T15:10:14.029" v="3627" actId="20577"/>
          <ac:spMkLst>
            <pc:docMk/>
            <pc:sldMk cId="73139265" sldId="291"/>
            <ac:spMk id="8" creationId="{86CD6881-1771-49F8-9D0D-0C211E6BAE3B}"/>
          </ac:spMkLst>
        </pc:spChg>
        <pc:picChg chg="add mod">
          <ac:chgData name="Miriam Schreiber" userId="5a452ff8-f189-44a9-9767-da59f69398bf" providerId="ADAL" clId="{7A8111AC-5017-4CF1-AB1B-6A71CD7BFCD8}" dt="2022-05-01T14:48:19.229" v="1505" actId="1038"/>
          <ac:picMkLst>
            <pc:docMk/>
            <pc:sldMk cId="73139265" sldId="291"/>
            <ac:picMk id="5" creationId="{3A7A43EE-7BA5-4F80-9958-40A0158B03EE}"/>
          </ac:picMkLst>
        </pc:picChg>
        <pc:picChg chg="add mod">
          <ac:chgData name="Miriam Schreiber" userId="5a452ff8-f189-44a9-9767-da59f69398bf" providerId="ADAL" clId="{7A8111AC-5017-4CF1-AB1B-6A71CD7BFCD8}" dt="2022-05-01T14:48:07.676" v="1488" actId="1038"/>
          <ac:picMkLst>
            <pc:docMk/>
            <pc:sldMk cId="73139265" sldId="291"/>
            <ac:picMk id="7" creationId="{79A5852B-D29B-45CE-8173-D3ABDC43D56D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23.394" v="3634" actId="20577"/>
        <pc:sldMkLst>
          <pc:docMk/>
          <pc:sldMk cId="4231437813" sldId="292"/>
        </pc:sldMkLst>
        <pc:spChg chg="del">
          <ac:chgData name="Miriam Schreiber" userId="5a452ff8-f189-44a9-9767-da59f69398bf" providerId="ADAL" clId="{7A8111AC-5017-4CF1-AB1B-6A71CD7BFCD8}" dt="2022-05-01T14:47:58.071" v="1467" actId="478"/>
          <ac:spMkLst>
            <pc:docMk/>
            <pc:sldMk cId="4231437813" sldId="292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2:39.087" v="670"/>
          <ac:spMkLst>
            <pc:docMk/>
            <pc:sldMk cId="4231437813" sldId="292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10:23.394" v="3634" actId="20577"/>
          <ac:spMkLst>
            <pc:docMk/>
            <pc:sldMk cId="4231437813" sldId="292"/>
            <ac:spMk id="6" creationId="{198441B3-0507-4896-85DE-F9FC8FB1E198}"/>
          </ac:spMkLst>
        </pc:spChg>
        <pc:spChg chg="add mod">
          <ac:chgData name="Miriam Schreiber" userId="5a452ff8-f189-44a9-9767-da59f69398bf" providerId="ADAL" clId="{7A8111AC-5017-4CF1-AB1B-6A71CD7BFCD8}" dt="2022-05-01T15:10:18.178" v="3631" actId="20577"/>
          <ac:spMkLst>
            <pc:docMk/>
            <pc:sldMk cId="4231437813" sldId="292"/>
            <ac:spMk id="8" creationId="{C8A2660C-5B96-4CAF-A914-BECFA0BACBD0}"/>
          </ac:spMkLst>
        </pc:spChg>
        <pc:picChg chg="add mod">
          <ac:chgData name="Miriam Schreiber" userId="5a452ff8-f189-44a9-9767-da59f69398bf" providerId="ADAL" clId="{7A8111AC-5017-4CF1-AB1B-6A71CD7BFCD8}" dt="2022-05-01T14:48:00.181" v="1470" actId="1038"/>
          <ac:picMkLst>
            <pc:docMk/>
            <pc:sldMk cId="4231437813" sldId="292"/>
            <ac:picMk id="5" creationId="{B74659D6-D096-42FE-A980-D0B99F1104B2}"/>
          </ac:picMkLst>
        </pc:picChg>
        <pc:picChg chg="add mod">
          <ac:chgData name="Miriam Schreiber" userId="5a452ff8-f189-44a9-9767-da59f69398bf" providerId="ADAL" clId="{7A8111AC-5017-4CF1-AB1B-6A71CD7BFCD8}" dt="2022-05-01T14:47:46.776" v="1463" actId="1038"/>
          <ac:picMkLst>
            <pc:docMk/>
            <pc:sldMk cId="4231437813" sldId="292"/>
            <ac:picMk id="7" creationId="{2CE42881-07CB-4FF6-AEC0-27E850BB9D40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38.442" v="3638" actId="20577"/>
        <pc:sldMkLst>
          <pc:docMk/>
          <pc:sldMk cId="2713121485" sldId="293"/>
        </pc:sldMkLst>
        <pc:spChg chg="del">
          <ac:chgData name="Miriam Schreiber" userId="5a452ff8-f189-44a9-9767-da59f69398bf" providerId="ADAL" clId="{7A8111AC-5017-4CF1-AB1B-6A71CD7BFCD8}" dt="2022-05-01T14:47:25.919" v="1395" actId="478"/>
          <ac:spMkLst>
            <pc:docMk/>
            <pc:sldMk cId="2713121485" sldId="293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2:45.374" v="676"/>
          <ac:spMkLst>
            <pc:docMk/>
            <pc:sldMk cId="2713121485" sldId="293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10:34.842" v="3636" actId="20577"/>
          <ac:spMkLst>
            <pc:docMk/>
            <pc:sldMk cId="2713121485" sldId="293"/>
            <ac:spMk id="6" creationId="{0479FDC4-BCBE-43F0-808F-E583A72DA177}"/>
          </ac:spMkLst>
        </pc:spChg>
        <pc:spChg chg="add mod">
          <ac:chgData name="Miriam Schreiber" userId="5a452ff8-f189-44a9-9767-da59f69398bf" providerId="ADAL" clId="{7A8111AC-5017-4CF1-AB1B-6A71CD7BFCD8}" dt="2022-05-01T15:10:38.442" v="3638" actId="20577"/>
          <ac:spMkLst>
            <pc:docMk/>
            <pc:sldMk cId="2713121485" sldId="293"/>
            <ac:spMk id="8" creationId="{559C74AF-5874-4FEA-919A-4786155916D4}"/>
          </ac:spMkLst>
        </pc:spChg>
        <pc:picChg chg="add mod">
          <ac:chgData name="Miriam Schreiber" userId="5a452ff8-f189-44a9-9767-da59f69398bf" providerId="ADAL" clId="{7A8111AC-5017-4CF1-AB1B-6A71CD7BFCD8}" dt="2022-05-01T14:47:37.881" v="1433" actId="1038"/>
          <ac:picMkLst>
            <pc:docMk/>
            <pc:sldMk cId="2713121485" sldId="293"/>
            <ac:picMk id="5" creationId="{FABAC7E6-C8BD-49AE-8FB1-7CE42FA0F61C}"/>
          </ac:picMkLst>
        </pc:picChg>
        <pc:picChg chg="add mod">
          <ac:chgData name="Miriam Schreiber" userId="5a452ff8-f189-44a9-9767-da59f69398bf" providerId="ADAL" clId="{7A8111AC-5017-4CF1-AB1B-6A71CD7BFCD8}" dt="2022-05-01T14:47:31.213" v="1409" actId="1037"/>
          <ac:picMkLst>
            <pc:docMk/>
            <pc:sldMk cId="2713121485" sldId="293"/>
            <ac:picMk id="7" creationId="{7E4F9971-054C-4207-B244-0CCF2F68621D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50.186" v="3641" actId="20577"/>
        <pc:sldMkLst>
          <pc:docMk/>
          <pc:sldMk cId="506193483" sldId="294"/>
        </pc:sldMkLst>
        <pc:spChg chg="del">
          <ac:chgData name="Miriam Schreiber" userId="5a452ff8-f189-44a9-9767-da59f69398bf" providerId="ADAL" clId="{7A8111AC-5017-4CF1-AB1B-6A71CD7BFCD8}" dt="2022-05-01T14:47:17.882" v="1393" actId="478"/>
          <ac:spMkLst>
            <pc:docMk/>
            <pc:sldMk cId="506193483" sldId="294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2:51.691" v="682"/>
          <ac:spMkLst>
            <pc:docMk/>
            <pc:sldMk cId="506193483" sldId="294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10:50.186" v="3641" actId="20577"/>
          <ac:spMkLst>
            <pc:docMk/>
            <pc:sldMk cId="506193483" sldId="294"/>
            <ac:spMk id="6" creationId="{130C1B92-07D8-4073-A888-F89A491A587F}"/>
          </ac:spMkLst>
        </pc:spChg>
        <pc:spChg chg="add mod">
          <ac:chgData name="Miriam Schreiber" userId="5a452ff8-f189-44a9-9767-da59f69398bf" providerId="ADAL" clId="{7A8111AC-5017-4CF1-AB1B-6A71CD7BFCD8}" dt="2022-05-01T15:10:46.620" v="3640" actId="20577"/>
          <ac:spMkLst>
            <pc:docMk/>
            <pc:sldMk cId="506193483" sldId="294"/>
            <ac:spMk id="8" creationId="{72201A4A-C084-455E-A74F-5C36E9AF278B}"/>
          </ac:spMkLst>
        </pc:spChg>
        <pc:picChg chg="add mod">
          <ac:chgData name="Miriam Schreiber" userId="5a452ff8-f189-44a9-9767-da59f69398bf" providerId="ADAL" clId="{7A8111AC-5017-4CF1-AB1B-6A71CD7BFCD8}" dt="2022-05-01T14:47:15.141" v="1392" actId="1037"/>
          <ac:picMkLst>
            <pc:docMk/>
            <pc:sldMk cId="506193483" sldId="294"/>
            <ac:picMk id="5" creationId="{C8C87A24-A7E7-4D03-9059-58DBC9D9D616}"/>
          </ac:picMkLst>
        </pc:picChg>
        <pc:picChg chg="add mod">
          <ac:chgData name="Miriam Schreiber" userId="5a452ff8-f189-44a9-9767-da59f69398bf" providerId="ADAL" clId="{7A8111AC-5017-4CF1-AB1B-6A71CD7BFCD8}" dt="2022-05-01T14:47:04.765" v="1369" actId="1038"/>
          <ac:picMkLst>
            <pc:docMk/>
            <pc:sldMk cId="506193483" sldId="294"/>
            <ac:picMk id="7" creationId="{A0A0F009-F3B6-4811-9E54-C55637AEAE3F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0:58.457" v="3647" actId="20577"/>
        <pc:sldMkLst>
          <pc:docMk/>
          <pc:sldMk cId="2070099244" sldId="295"/>
        </pc:sldMkLst>
        <pc:spChg chg="del">
          <ac:chgData name="Miriam Schreiber" userId="5a452ff8-f189-44a9-9767-da59f69398bf" providerId="ADAL" clId="{7A8111AC-5017-4CF1-AB1B-6A71CD7BFCD8}" dt="2022-05-01T14:46:42.790" v="1332" actId="478"/>
          <ac:spMkLst>
            <pc:docMk/>
            <pc:sldMk cId="2070099244" sldId="295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2:59.672" v="690"/>
          <ac:spMkLst>
            <pc:docMk/>
            <pc:sldMk cId="2070099244" sldId="295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10:58.457" v="3647" actId="20577"/>
          <ac:spMkLst>
            <pc:docMk/>
            <pc:sldMk cId="2070099244" sldId="295"/>
            <ac:spMk id="6" creationId="{81F84FA5-4009-476C-83EF-30BBFAA615D4}"/>
          </ac:spMkLst>
        </pc:spChg>
        <pc:spChg chg="add mod">
          <ac:chgData name="Miriam Schreiber" userId="5a452ff8-f189-44a9-9767-da59f69398bf" providerId="ADAL" clId="{7A8111AC-5017-4CF1-AB1B-6A71CD7BFCD8}" dt="2022-05-01T15:10:54.091" v="3645" actId="20577"/>
          <ac:spMkLst>
            <pc:docMk/>
            <pc:sldMk cId="2070099244" sldId="295"/>
            <ac:spMk id="8" creationId="{3F23A82A-F844-440D-8CAA-A37C5B9114CF}"/>
          </ac:spMkLst>
        </pc:spChg>
        <pc:picChg chg="add mod">
          <ac:chgData name="Miriam Schreiber" userId="5a452ff8-f189-44a9-9767-da59f69398bf" providerId="ADAL" clId="{7A8111AC-5017-4CF1-AB1B-6A71CD7BFCD8}" dt="2022-05-01T14:46:57.573" v="1350" actId="1037"/>
          <ac:picMkLst>
            <pc:docMk/>
            <pc:sldMk cId="2070099244" sldId="295"/>
            <ac:picMk id="5" creationId="{D3FAE871-E304-49BB-88D3-C51087B47AA7}"/>
          </ac:picMkLst>
        </pc:picChg>
        <pc:picChg chg="add mod">
          <ac:chgData name="Miriam Schreiber" userId="5a452ff8-f189-44a9-9767-da59f69398bf" providerId="ADAL" clId="{7A8111AC-5017-4CF1-AB1B-6A71CD7BFCD8}" dt="2022-05-01T14:46:47.605" v="1345" actId="1037"/>
          <ac:picMkLst>
            <pc:docMk/>
            <pc:sldMk cId="2070099244" sldId="295"/>
            <ac:picMk id="7" creationId="{3B2E39F9-494A-41EA-9B71-0654C0210814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09.203" v="3653" actId="20577"/>
        <pc:sldMkLst>
          <pc:docMk/>
          <pc:sldMk cId="484755535" sldId="296"/>
        </pc:sldMkLst>
        <pc:spChg chg="del">
          <ac:chgData name="Miriam Schreiber" userId="5a452ff8-f189-44a9-9767-da59f69398bf" providerId="ADAL" clId="{7A8111AC-5017-4CF1-AB1B-6A71CD7BFCD8}" dt="2022-05-01T14:46:27.261" v="1328" actId="478"/>
          <ac:spMkLst>
            <pc:docMk/>
            <pc:sldMk cId="484755535" sldId="296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3:07.731" v="698"/>
          <ac:spMkLst>
            <pc:docMk/>
            <pc:sldMk cId="484755535" sldId="296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11:09.203" v="3653" actId="20577"/>
          <ac:spMkLst>
            <pc:docMk/>
            <pc:sldMk cId="484755535" sldId="296"/>
            <ac:spMk id="6" creationId="{3619BEF4-CDE0-44C7-BEB3-F61D38CD2286}"/>
          </ac:spMkLst>
        </pc:spChg>
        <pc:spChg chg="add mod">
          <ac:chgData name="Miriam Schreiber" userId="5a452ff8-f189-44a9-9767-da59f69398bf" providerId="ADAL" clId="{7A8111AC-5017-4CF1-AB1B-6A71CD7BFCD8}" dt="2022-05-01T15:11:04.722" v="3651" actId="20577"/>
          <ac:spMkLst>
            <pc:docMk/>
            <pc:sldMk cId="484755535" sldId="296"/>
            <ac:spMk id="8" creationId="{4F81F9BA-B04B-4BBA-A970-2D0652DC68AB}"/>
          </ac:spMkLst>
        </pc:spChg>
        <pc:picChg chg="add mod">
          <ac:chgData name="Miriam Schreiber" userId="5a452ff8-f189-44a9-9767-da59f69398bf" providerId="ADAL" clId="{7A8111AC-5017-4CF1-AB1B-6A71CD7BFCD8}" dt="2022-05-01T14:46:22.613" v="1327" actId="1038"/>
          <ac:picMkLst>
            <pc:docMk/>
            <pc:sldMk cId="484755535" sldId="296"/>
            <ac:picMk id="5" creationId="{8F64E3A6-6F81-4AC9-98DF-9E67D61C7D47}"/>
          </ac:picMkLst>
        </pc:picChg>
        <pc:picChg chg="add mod">
          <ac:chgData name="Miriam Schreiber" userId="5a452ff8-f189-44a9-9767-da59f69398bf" providerId="ADAL" clId="{7A8111AC-5017-4CF1-AB1B-6A71CD7BFCD8}" dt="2022-05-01T14:46:18.276" v="1310" actId="1037"/>
          <ac:picMkLst>
            <pc:docMk/>
            <pc:sldMk cId="484755535" sldId="296"/>
            <ac:picMk id="7" creationId="{2C6916FD-D73F-4D1B-A7A5-F5D115CF3535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17.554" v="3659" actId="20577"/>
        <pc:sldMkLst>
          <pc:docMk/>
          <pc:sldMk cId="3365079120" sldId="297"/>
        </pc:sldMkLst>
        <pc:spChg chg="del">
          <ac:chgData name="Miriam Schreiber" userId="5a452ff8-f189-44a9-9767-da59f69398bf" providerId="ADAL" clId="{7A8111AC-5017-4CF1-AB1B-6A71CD7BFCD8}" dt="2022-05-01T14:46:29.541" v="1329" actId="478"/>
          <ac:spMkLst>
            <pc:docMk/>
            <pc:sldMk cId="3365079120" sldId="297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3:16.754" v="706"/>
          <ac:spMkLst>
            <pc:docMk/>
            <pc:sldMk cId="3365079120" sldId="297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11:17.554" v="3659" actId="20577"/>
          <ac:spMkLst>
            <pc:docMk/>
            <pc:sldMk cId="3365079120" sldId="297"/>
            <ac:spMk id="6" creationId="{42490F92-4741-4B45-9D0B-B2FD910B793A}"/>
          </ac:spMkLst>
        </pc:spChg>
        <pc:spChg chg="add mod">
          <ac:chgData name="Miriam Schreiber" userId="5a452ff8-f189-44a9-9767-da59f69398bf" providerId="ADAL" clId="{7A8111AC-5017-4CF1-AB1B-6A71CD7BFCD8}" dt="2022-05-01T15:11:13.409" v="3657" actId="20577"/>
          <ac:spMkLst>
            <pc:docMk/>
            <pc:sldMk cId="3365079120" sldId="297"/>
            <ac:spMk id="8" creationId="{4A0B5E63-7198-4415-B05E-2B0CEF2ACCDE}"/>
          </ac:spMkLst>
        </pc:spChg>
        <pc:picChg chg="add mod">
          <ac:chgData name="Miriam Schreiber" userId="5a452ff8-f189-44a9-9767-da59f69398bf" providerId="ADAL" clId="{7A8111AC-5017-4CF1-AB1B-6A71CD7BFCD8}" dt="2022-05-01T14:46:03.877" v="1278" actId="1036"/>
          <ac:picMkLst>
            <pc:docMk/>
            <pc:sldMk cId="3365079120" sldId="297"/>
            <ac:picMk id="5" creationId="{A97C3906-392F-42CC-A2C6-DD2904556D03}"/>
          </ac:picMkLst>
        </pc:picChg>
        <pc:picChg chg="add mod">
          <ac:chgData name="Miriam Schreiber" userId="5a452ff8-f189-44a9-9767-da59f69398bf" providerId="ADAL" clId="{7A8111AC-5017-4CF1-AB1B-6A71CD7BFCD8}" dt="2022-05-01T14:45:54.996" v="1274" actId="1037"/>
          <ac:picMkLst>
            <pc:docMk/>
            <pc:sldMk cId="3365079120" sldId="297"/>
            <ac:picMk id="7" creationId="{0FE0FF17-6810-4A04-9CF7-21D1C460B4EE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26.722" v="3665" actId="20577"/>
        <pc:sldMkLst>
          <pc:docMk/>
          <pc:sldMk cId="280178470" sldId="298"/>
        </pc:sldMkLst>
        <pc:spChg chg="del">
          <ac:chgData name="Miriam Schreiber" userId="5a452ff8-f189-44a9-9767-da59f69398bf" providerId="ADAL" clId="{7A8111AC-5017-4CF1-AB1B-6A71CD7BFCD8}" dt="2022-05-01T14:46:31.693" v="1330" actId="478"/>
          <ac:spMkLst>
            <pc:docMk/>
            <pc:sldMk cId="280178470" sldId="298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3:22.556" v="712"/>
          <ac:spMkLst>
            <pc:docMk/>
            <pc:sldMk cId="280178470" sldId="298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11:26.722" v="3665" actId="20577"/>
          <ac:spMkLst>
            <pc:docMk/>
            <pc:sldMk cId="280178470" sldId="298"/>
            <ac:spMk id="6" creationId="{0BE2C3CA-D998-4693-893F-7AF02B152E7C}"/>
          </ac:spMkLst>
        </pc:spChg>
        <pc:spChg chg="add mod">
          <ac:chgData name="Miriam Schreiber" userId="5a452ff8-f189-44a9-9767-da59f69398bf" providerId="ADAL" clId="{7A8111AC-5017-4CF1-AB1B-6A71CD7BFCD8}" dt="2022-05-01T15:11:22.753" v="3663" actId="20577"/>
          <ac:spMkLst>
            <pc:docMk/>
            <pc:sldMk cId="280178470" sldId="298"/>
            <ac:spMk id="8" creationId="{DC2FDBE1-549E-4C15-B6A6-5588CBC919FA}"/>
          </ac:spMkLst>
        </pc:spChg>
        <pc:picChg chg="add mod">
          <ac:chgData name="Miriam Schreiber" userId="5a452ff8-f189-44a9-9767-da59f69398bf" providerId="ADAL" clId="{7A8111AC-5017-4CF1-AB1B-6A71CD7BFCD8}" dt="2022-05-01T14:45:47.724" v="1247" actId="1076"/>
          <ac:picMkLst>
            <pc:docMk/>
            <pc:sldMk cId="280178470" sldId="298"/>
            <ac:picMk id="5" creationId="{112A8FB1-3017-441A-A9AC-B82A966F1F8C}"/>
          </ac:picMkLst>
        </pc:picChg>
        <pc:picChg chg="add mod">
          <ac:chgData name="Miriam Schreiber" userId="5a452ff8-f189-44a9-9767-da59f69398bf" providerId="ADAL" clId="{7A8111AC-5017-4CF1-AB1B-6A71CD7BFCD8}" dt="2022-05-01T14:45:39.869" v="1245" actId="1037"/>
          <ac:picMkLst>
            <pc:docMk/>
            <pc:sldMk cId="280178470" sldId="298"/>
            <ac:picMk id="7" creationId="{1E81AB68-E8C3-44F5-A3B3-70E8866A8906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35.425" v="3669" actId="20577"/>
        <pc:sldMkLst>
          <pc:docMk/>
          <pc:sldMk cId="3142224386" sldId="299"/>
        </pc:sldMkLst>
        <pc:spChg chg="del">
          <ac:chgData name="Miriam Schreiber" userId="5a452ff8-f189-44a9-9767-da59f69398bf" providerId="ADAL" clId="{7A8111AC-5017-4CF1-AB1B-6A71CD7BFCD8}" dt="2022-05-01T14:45:22.609" v="1224" actId="478"/>
          <ac:spMkLst>
            <pc:docMk/>
            <pc:sldMk cId="3142224386" sldId="299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3:32.790" v="719"/>
          <ac:spMkLst>
            <pc:docMk/>
            <pc:sldMk cId="3142224386" sldId="299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5:11:35.425" v="3669" actId="20577"/>
          <ac:spMkLst>
            <pc:docMk/>
            <pc:sldMk cId="3142224386" sldId="299"/>
            <ac:spMk id="6" creationId="{5B5BE085-694D-40D2-8783-30083CDD095A}"/>
          </ac:spMkLst>
        </pc:spChg>
        <pc:spChg chg="add mod">
          <ac:chgData name="Miriam Schreiber" userId="5a452ff8-f189-44a9-9767-da59f69398bf" providerId="ADAL" clId="{7A8111AC-5017-4CF1-AB1B-6A71CD7BFCD8}" dt="2022-05-01T15:11:31.657" v="3667" actId="20577"/>
          <ac:spMkLst>
            <pc:docMk/>
            <pc:sldMk cId="3142224386" sldId="299"/>
            <ac:spMk id="8" creationId="{6BFB5BDA-E08F-4CB8-8730-E5B00893FFD9}"/>
          </ac:spMkLst>
        </pc:spChg>
        <pc:picChg chg="add mod">
          <ac:chgData name="Miriam Schreiber" userId="5a452ff8-f189-44a9-9767-da59f69398bf" providerId="ADAL" clId="{7A8111AC-5017-4CF1-AB1B-6A71CD7BFCD8}" dt="2022-05-01T14:45:16.181" v="1223" actId="1038"/>
          <ac:picMkLst>
            <pc:docMk/>
            <pc:sldMk cId="3142224386" sldId="299"/>
            <ac:picMk id="5" creationId="{5BD7A22B-4A0F-48DE-8D8B-92214A56A2D8}"/>
          </ac:picMkLst>
        </pc:picChg>
        <pc:picChg chg="add mod">
          <ac:chgData name="Miriam Schreiber" userId="5a452ff8-f189-44a9-9767-da59f69398bf" providerId="ADAL" clId="{7A8111AC-5017-4CF1-AB1B-6A71CD7BFCD8}" dt="2022-05-01T14:45:27.247" v="1228" actId="1037"/>
          <ac:picMkLst>
            <pc:docMk/>
            <pc:sldMk cId="3142224386" sldId="299"/>
            <ac:picMk id="7" creationId="{8BF00EF3-B9FC-49DA-99B0-46EAFE7F16D5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45.501" v="3672" actId="20577"/>
        <pc:sldMkLst>
          <pc:docMk/>
          <pc:sldMk cId="1459853529" sldId="300"/>
        </pc:sldMkLst>
        <pc:spChg chg="del">
          <ac:chgData name="Miriam Schreiber" userId="5a452ff8-f189-44a9-9767-da59f69398bf" providerId="ADAL" clId="{7A8111AC-5017-4CF1-AB1B-6A71CD7BFCD8}" dt="2022-04-29T15:39:34.096" v="1190" actId="478"/>
          <ac:spMkLst>
            <pc:docMk/>
            <pc:sldMk cId="1459853529" sldId="300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3:41.278" v="727"/>
          <ac:spMkLst>
            <pc:docMk/>
            <pc:sldMk cId="1459853529" sldId="300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5-01T15:11:45.501" v="3672" actId="20577"/>
          <ac:spMkLst>
            <pc:docMk/>
            <pc:sldMk cId="1459853529" sldId="300"/>
            <ac:spMk id="4" creationId="{8E35EAFF-1F7A-40BD-9AE3-064739B11890}"/>
          </ac:spMkLst>
        </pc:spChg>
        <pc:spChg chg="add mod">
          <ac:chgData name="Miriam Schreiber" userId="5a452ff8-f189-44a9-9767-da59f69398bf" providerId="ADAL" clId="{7A8111AC-5017-4CF1-AB1B-6A71CD7BFCD8}" dt="2022-05-01T15:11:41.245" v="3671" actId="20577"/>
          <ac:spMkLst>
            <pc:docMk/>
            <pc:sldMk cId="1459853529" sldId="300"/>
            <ac:spMk id="6" creationId="{E2378D7F-A470-4CB2-A3EC-57B850E3BB7E}"/>
          </ac:spMkLst>
        </pc:spChg>
        <pc:picChg chg="add mod">
          <ac:chgData name="Miriam Schreiber" userId="5a452ff8-f189-44a9-9767-da59f69398bf" providerId="ADAL" clId="{7A8111AC-5017-4CF1-AB1B-6A71CD7BFCD8}" dt="2022-04-29T15:39:31.097" v="1189" actId="14100"/>
          <ac:picMkLst>
            <pc:docMk/>
            <pc:sldMk cId="1459853529" sldId="300"/>
            <ac:picMk id="5" creationId="{FF01C058-2A62-43CB-B531-619A031BE7DD}"/>
          </ac:picMkLst>
        </pc:picChg>
        <pc:picChg chg="add mod">
          <ac:chgData name="Miriam Schreiber" userId="5a452ff8-f189-44a9-9767-da59f69398bf" providerId="ADAL" clId="{7A8111AC-5017-4CF1-AB1B-6A71CD7BFCD8}" dt="2022-04-29T15:39:20.238" v="1165" actId="1037"/>
          <ac:picMkLst>
            <pc:docMk/>
            <pc:sldMk cId="1459853529" sldId="300"/>
            <ac:picMk id="7" creationId="{76886D30-0EDE-4DED-BCC2-4914BD6A09DC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52.949" v="3676" actId="20577"/>
        <pc:sldMkLst>
          <pc:docMk/>
          <pc:sldMk cId="2366946141" sldId="301"/>
        </pc:sldMkLst>
        <pc:spChg chg="del">
          <ac:chgData name="Miriam Schreiber" userId="5a452ff8-f189-44a9-9767-da59f69398bf" providerId="ADAL" clId="{7A8111AC-5017-4CF1-AB1B-6A71CD7BFCD8}" dt="2022-04-29T15:38:51.610" v="1094" actId="478"/>
          <ac:spMkLst>
            <pc:docMk/>
            <pc:sldMk cId="2366946141" sldId="301"/>
            <ac:spMk id="2" creationId="{77D55D36-F826-44AE-9C7A-1EBAAD6539DC}"/>
          </ac:spMkLst>
        </pc:spChg>
        <pc:spChg chg="del">
          <ac:chgData name="Miriam Schreiber" userId="5a452ff8-f189-44a9-9767-da59f69398bf" providerId="ADAL" clId="{7A8111AC-5017-4CF1-AB1B-6A71CD7BFCD8}" dt="2022-04-29T15:33:48.090" v="734"/>
          <ac:spMkLst>
            <pc:docMk/>
            <pc:sldMk cId="2366946141" sldId="301"/>
            <ac:spMk id="3" creationId="{DF6353B8-8109-46FB-81BC-597DB452A415}"/>
          </ac:spMkLst>
        </pc:spChg>
        <pc:spChg chg="add mod">
          <ac:chgData name="Miriam Schreiber" userId="5a452ff8-f189-44a9-9767-da59f69398bf" providerId="ADAL" clId="{7A8111AC-5017-4CF1-AB1B-6A71CD7BFCD8}" dt="2022-05-01T15:11:49.263" v="3674" actId="20577"/>
          <ac:spMkLst>
            <pc:docMk/>
            <pc:sldMk cId="2366946141" sldId="301"/>
            <ac:spMk id="4" creationId="{C913E983-3A5B-4588-9231-7C0D46B5454C}"/>
          </ac:spMkLst>
        </pc:spChg>
        <pc:spChg chg="add mod">
          <ac:chgData name="Miriam Schreiber" userId="5a452ff8-f189-44a9-9767-da59f69398bf" providerId="ADAL" clId="{7A8111AC-5017-4CF1-AB1B-6A71CD7BFCD8}" dt="2022-05-01T15:11:52.949" v="3676" actId="20577"/>
          <ac:spMkLst>
            <pc:docMk/>
            <pc:sldMk cId="2366946141" sldId="301"/>
            <ac:spMk id="6" creationId="{5413F4E4-BAE6-4EED-81EB-36CF44E09120}"/>
          </ac:spMkLst>
        </pc:spChg>
        <pc:picChg chg="add mod">
          <ac:chgData name="Miriam Schreiber" userId="5a452ff8-f189-44a9-9767-da59f69398bf" providerId="ADAL" clId="{7A8111AC-5017-4CF1-AB1B-6A71CD7BFCD8}" dt="2022-04-29T15:39:01.870" v="1108" actId="1037"/>
          <ac:picMkLst>
            <pc:docMk/>
            <pc:sldMk cId="2366946141" sldId="301"/>
            <ac:picMk id="5" creationId="{D5760589-BECE-4745-B876-46DB4CB28D80}"/>
          </ac:picMkLst>
        </pc:picChg>
        <pc:picChg chg="add mod">
          <ac:chgData name="Miriam Schreiber" userId="5a452ff8-f189-44a9-9767-da59f69398bf" providerId="ADAL" clId="{7A8111AC-5017-4CF1-AB1B-6A71CD7BFCD8}" dt="2022-04-29T15:39:10.482" v="1142" actId="1037"/>
          <ac:picMkLst>
            <pc:docMk/>
            <pc:sldMk cId="2366946141" sldId="301"/>
            <ac:picMk id="7" creationId="{71E929D3-A6E8-44A5-9706-7F6044B3B3DA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1:59.361" v="3680" actId="20577"/>
        <pc:sldMkLst>
          <pc:docMk/>
          <pc:sldMk cId="1889800891" sldId="302"/>
        </pc:sldMkLst>
        <pc:spChg chg="del">
          <ac:chgData name="Miriam Schreiber" userId="5a452ff8-f189-44a9-9767-da59f69398bf" providerId="ADAL" clId="{7A8111AC-5017-4CF1-AB1B-6A71CD7BFCD8}" dt="2022-04-29T15:38:34.247" v="1068" actId="478"/>
          <ac:spMkLst>
            <pc:docMk/>
            <pc:sldMk cId="1889800891" sldId="302"/>
            <ac:spMk id="2" creationId="{8A3A9DF8-4E70-4A69-BB58-00243EDB87E4}"/>
          </ac:spMkLst>
        </pc:spChg>
        <pc:spChg chg="del">
          <ac:chgData name="Miriam Schreiber" userId="5a452ff8-f189-44a9-9767-da59f69398bf" providerId="ADAL" clId="{7A8111AC-5017-4CF1-AB1B-6A71CD7BFCD8}" dt="2022-04-29T15:33:56.844" v="742"/>
          <ac:spMkLst>
            <pc:docMk/>
            <pc:sldMk cId="1889800891" sldId="302"/>
            <ac:spMk id="3" creationId="{05E39C55-0737-4A4E-8181-01CC2BB7EDDD}"/>
          </ac:spMkLst>
        </pc:spChg>
        <pc:spChg chg="add mod">
          <ac:chgData name="Miriam Schreiber" userId="5a452ff8-f189-44a9-9767-da59f69398bf" providerId="ADAL" clId="{7A8111AC-5017-4CF1-AB1B-6A71CD7BFCD8}" dt="2022-05-01T15:11:59.361" v="3680" actId="20577"/>
          <ac:spMkLst>
            <pc:docMk/>
            <pc:sldMk cId="1889800891" sldId="302"/>
            <ac:spMk id="4" creationId="{47946B4A-CC15-4624-A58A-3DCA03F0E43A}"/>
          </ac:spMkLst>
        </pc:spChg>
        <pc:spChg chg="add mod">
          <ac:chgData name="Miriam Schreiber" userId="5a452ff8-f189-44a9-9767-da59f69398bf" providerId="ADAL" clId="{7A8111AC-5017-4CF1-AB1B-6A71CD7BFCD8}" dt="2022-05-01T15:11:55.884" v="3678" actId="20577"/>
          <ac:spMkLst>
            <pc:docMk/>
            <pc:sldMk cId="1889800891" sldId="302"/>
            <ac:spMk id="6" creationId="{9EA6E244-A1EB-4417-838F-9E6B9B4D42E1}"/>
          </ac:spMkLst>
        </pc:spChg>
        <pc:picChg chg="add mod">
          <ac:chgData name="Miriam Schreiber" userId="5a452ff8-f189-44a9-9767-da59f69398bf" providerId="ADAL" clId="{7A8111AC-5017-4CF1-AB1B-6A71CD7BFCD8}" dt="2022-04-29T15:38:41.232" v="1090" actId="1038"/>
          <ac:picMkLst>
            <pc:docMk/>
            <pc:sldMk cId="1889800891" sldId="302"/>
            <ac:picMk id="5" creationId="{B45AA4AF-60EF-4B6F-B780-4F9F86608CB0}"/>
          </ac:picMkLst>
        </pc:picChg>
        <pc:picChg chg="add mod">
          <ac:chgData name="Miriam Schreiber" userId="5a452ff8-f189-44a9-9767-da59f69398bf" providerId="ADAL" clId="{7A8111AC-5017-4CF1-AB1B-6A71CD7BFCD8}" dt="2022-04-29T15:38:44.803" v="1092" actId="1038"/>
          <ac:picMkLst>
            <pc:docMk/>
            <pc:sldMk cId="1889800891" sldId="302"/>
            <ac:picMk id="7" creationId="{5D8728C8-E5A2-42C4-88D8-82D58F05F06F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5-01T15:12:03.153" v="3682" actId="20577"/>
        <pc:sldMkLst>
          <pc:docMk/>
          <pc:sldMk cId="386663992" sldId="303"/>
        </pc:sldMkLst>
        <pc:spChg chg="del">
          <ac:chgData name="Miriam Schreiber" userId="5a452ff8-f189-44a9-9767-da59f69398bf" providerId="ADAL" clId="{7A8111AC-5017-4CF1-AB1B-6A71CD7BFCD8}" dt="2022-04-29T15:37:57.293" v="998" actId="478"/>
          <ac:spMkLst>
            <pc:docMk/>
            <pc:sldMk cId="386663992" sldId="303"/>
            <ac:spMk id="2" creationId="{EE7C35C4-A699-4A12-94F9-291A8CC9CE28}"/>
          </ac:spMkLst>
        </pc:spChg>
        <pc:spChg chg="del">
          <ac:chgData name="Miriam Schreiber" userId="5a452ff8-f189-44a9-9767-da59f69398bf" providerId="ADAL" clId="{7A8111AC-5017-4CF1-AB1B-6A71CD7BFCD8}" dt="2022-04-29T15:34:04.411" v="749"/>
          <ac:spMkLst>
            <pc:docMk/>
            <pc:sldMk cId="386663992" sldId="303"/>
            <ac:spMk id="3" creationId="{5CF50E22-C3D6-43C0-A4F8-C5C0C35158B7}"/>
          </ac:spMkLst>
        </pc:spChg>
        <pc:spChg chg="add mod">
          <ac:chgData name="Miriam Schreiber" userId="5a452ff8-f189-44a9-9767-da59f69398bf" providerId="ADAL" clId="{7A8111AC-5017-4CF1-AB1B-6A71CD7BFCD8}" dt="2022-05-01T14:57:25.355" v="3081"/>
          <ac:spMkLst>
            <pc:docMk/>
            <pc:sldMk cId="386663992" sldId="303"/>
            <ac:spMk id="4" creationId="{8CE0BCD6-3484-4113-9CA4-F18477475A33}"/>
          </ac:spMkLst>
        </pc:spChg>
        <pc:spChg chg="add mod">
          <ac:chgData name="Miriam Schreiber" userId="5a452ff8-f189-44a9-9767-da59f69398bf" providerId="ADAL" clId="{7A8111AC-5017-4CF1-AB1B-6A71CD7BFCD8}" dt="2022-05-01T15:12:03.153" v="3682" actId="20577"/>
          <ac:spMkLst>
            <pc:docMk/>
            <pc:sldMk cId="386663992" sldId="303"/>
            <ac:spMk id="6" creationId="{4E158652-29E0-41B7-B129-551B04344104}"/>
          </ac:spMkLst>
        </pc:spChg>
        <pc:picChg chg="add mod">
          <ac:chgData name="Miriam Schreiber" userId="5a452ff8-f189-44a9-9767-da59f69398bf" providerId="ADAL" clId="{7A8111AC-5017-4CF1-AB1B-6A71CD7BFCD8}" dt="2022-04-29T15:38:24.222" v="1066" actId="14100"/>
          <ac:picMkLst>
            <pc:docMk/>
            <pc:sldMk cId="386663992" sldId="303"/>
            <ac:picMk id="5" creationId="{77EE5078-2642-41D7-872F-09E403CB92E8}"/>
          </ac:picMkLst>
        </pc:picChg>
        <pc:picChg chg="add mod">
          <ac:chgData name="Miriam Schreiber" userId="5a452ff8-f189-44a9-9767-da59f69398bf" providerId="ADAL" clId="{7A8111AC-5017-4CF1-AB1B-6A71CD7BFCD8}" dt="2022-04-29T15:38:04.857" v="1024" actId="1036"/>
          <ac:picMkLst>
            <pc:docMk/>
            <pc:sldMk cId="386663992" sldId="303"/>
            <ac:picMk id="7" creationId="{C3DB4548-CC3B-475F-BC46-15DC53FBAAA0}"/>
          </ac:picMkLst>
        </pc:picChg>
      </pc:sldChg>
      <pc:sldChg chg="addSp delSp modSp add mod">
        <pc:chgData name="Miriam Schreiber" userId="5a452ff8-f189-44a9-9767-da59f69398bf" providerId="ADAL" clId="{7A8111AC-5017-4CF1-AB1B-6A71CD7BFCD8}" dt="2022-04-29T15:37:51.969" v="997" actId="20577"/>
        <pc:sldMkLst>
          <pc:docMk/>
          <pc:sldMk cId="427213959" sldId="304"/>
        </pc:sldMkLst>
        <pc:spChg chg="del mod">
          <ac:chgData name="Miriam Schreiber" userId="5a452ff8-f189-44a9-9767-da59f69398bf" providerId="ADAL" clId="{7A8111AC-5017-4CF1-AB1B-6A71CD7BFCD8}" dt="2022-04-29T15:37:48.097" v="994" actId="478"/>
          <ac:spMkLst>
            <pc:docMk/>
            <pc:sldMk cId="427213959" sldId="304"/>
            <ac:spMk id="2" creationId="{644F674B-D61F-4A32-BD1E-ACE1211498C6}"/>
          </ac:spMkLst>
        </pc:spChg>
        <pc:spChg chg="del">
          <ac:chgData name="Miriam Schreiber" userId="5a452ff8-f189-44a9-9767-da59f69398bf" providerId="ADAL" clId="{7A8111AC-5017-4CF1-AB1B-6A71CD7BFCD8}" dt="2022-04-29T15:34:11.589" v="756"/>
          <ac:spMkLst>
            <pc:docMk/>
            <pc:sldMk cId="427213959" sldId="304"/>
            <ac:spMk id="3" creationId="{AE234B4D-FEAB-4494-AD0A-31DEBC873A44}"/>
          </ac:spMkLst>
        </pc:spChg>
        <pc:spChg chg="add mod">
          <ac:chgData name="Miriam Schreiber" userId="5a452ff8-f189-44a9-9767-da59f69398bf" providerId="ADAL" clId="{7A8111AC-5017-4CF1-AB1B-6A71CD7BFCD8}" dt="2022-04-29T15:37:33.810" v="987" actId="20577"/>
          <ac:spMkLst>
            <pc:docMk/>
            <pc:sldMk cId="427213959" sldId="304"/>
            <ac:spMk id="8" creationId="{42617D10-8537-4EF9-BFCF-A18BA6062DC6}"/>
          </ac:spMkLst>
        </pc:spChg>
        <pc:spChg chg="add del mod">
          <ac:chgData name="Miriam Schreiber" userId="5a452ff8-f189-44a9-9767-da59f69398bf" providerId="ADAL" clId="{7A8111AC-5017-4CF1-AB1B-6A71CD7BFCD8}" dt="2022-04-29T15:37:45.953" v="993"/>
          <ac:spMkLst>
            <pc:docMk/>
            <pc:sldMk cId="427213959" sldId="304"/>
            <ac:spMk id="9" creationId="{1FA4411D-471B-4175-9EA4-502F676B0458}"/>
          </ac:spMkLst>
        </pc:spChg>
        <pc:spChg chg="add mod">
          <ac:chgData name="Miriam Schreiber" userId="5a452ff8-f189-44a9-9767-da59f69398bf" providerId="ADAL" clId="{7A8111AC-5017-4CF1-AB1B-6A71CD7BFCD8}" dt="2022-04-29T15:37:51.969" v="997" actId="20577"/>
          <ac:spMkLst>
            <pc:docMk/>
            <pc:sldMk cId="427213959" sldId="304"/>
            <ac:spMk id="10" creationId="{30069A99-8706-49DA-A8AB-DF607FC68DAC}"/>
          </ac:spMkLst>
        </pc:spChg>
        <pc:picChg chg="add mod">
          <ac:chgData name="Miriam Schreiber" userId="5a452ff8-f189-44a9-9767-da59f69398bf" providerId="ADAL" clId="{7A8111AC-5017-4CF1-AB1B-6A71CD7BFCD8}" dt="2022-04-29T15:37:27.902" v="986" actId="1037"/>
          <ac:picMkLst>
            <pc:docMk/>
            <pc:sldMk cId="427213959" sldId="304"/>
            <ac:picMk id="5" creationId="{0EB68083-7F5E-4A28-9765-CD730DF1179A}"/>
          </ac:picMkLst>
        </pc:picChg>
        <pc:picChg chg="add mod">
          <ac:chgData name="Miriam Schreiber" userId="5a452ff8-f189-44a9-9767-da59f69398bf" providerId="ADAL" clId="{7A8111AC-5017-4CF1-AB1B-6A71CD7BFCD8}" dt="2022-04-29T15:37:16.165" v="963" actId="1037"/>
          <ac:picMkLst>
            <pc:docMk/>
            <pc:sldMk cId="427213959" sldId="304"/>
            <ac:picMk id="7" creationId="{B992A635-C0F3-4919-8F2A-9A84521228F0}"/>
          </ac:picMkLst>
        </pc:picChg>
      </pc:sldChg>
      <pc:sldChg chg="addSp delSp modSp new mod">
        <pc:chgData name="Miriam Schreiber" userId="5a452ff8-f189-44a9-9767-da59f69398bf" providerId="ADAL" clId="{7A8111AC-5017-4CF1-AB1B-6A71CD7BFCD8}" dt="2022-04-29T15:37:00.260" v="933" actId="20577"/>
        <pc:sldMkLst>
          <pc:docMk/>
          <pc:sldMk cId="1375688946" sldId="305"/>
        </pc:sldMkLst>
        <pc:spChg chg="mod">
          <ac:chgData name="Miriam Schreiber" userId="5a452ff8-f189-44a9-9767-da59f69398bf" providerId="ADAL" clId="{7A8111AC-5017-4CF1-AB1B-6A71CD7BFCD8}" dt="2022-04-29T15:36:20.813" v="858" actId="20577"/>
          <ac:spMkLst>
            <pc:docMk/>
            <pc:sldMk cId="1375688946" sldId="305"/>
            <ac:spMk id="2" creationId="{F30194F0-059E-443D-9ACD-0EBF46A621A6}"/>
          </ac:spMkLst>
        </pc:spChg>
        <pc:spChg chg="del">
          <ac:chgData name="Miriam Schreiber" userId="5a452ff8-f189-44a9-9767-da59f69398bf" providerId="ADAL" clId="{7A8111AC-5017-4CF1-AB1B-6A71CD7BFCD8}" dt="2022-04-29T15:34:18.293" v="763"/>
          <ac:spMkLst>
            <pc:docMk/>
            <pc:sldMk cId="1375688946" sldId="305"/>
            <ac:spMk id="3" creationId="{B9FB92B8-DE0E-4D6F-B11B-0B97E57FF92B}"/>
          </ac:spMkLst>
        </pc:spChg>
        <pc:spChg chg="add mod">
          <ac:chgData name="Miriam Schreiber" userId="5a452ff8-f189-44a9-9767-da59f69398bf" providerId="ADAL" clId="{7A8111AC-5017-4CF1-AB1B-6A71CD7BFCD8}" dt="2022-04-29T15:37:00.260" v="933" actId="20577"/>
          <ac:spMkLst>
            <pc:docMk/>
            <pc:sldMk cId="1375688946" sldId="305"/>
            <ac:spMk id="8" creationId="{15FE1ED8-5A33-4EC1-96FA-F708FF405EA0}"/>
          </ac:spMkLst>
        </pc:spChg>
        <pc:picChg chg="add mod">
          <ac:chgData name="Miriam Schreiber" userId="5a452ff8-f189-44a9-9767-da59f69398bf" providerId="ADAL" clId="{7A8111AC-5017-4CF1-AB1B-6A71CD7BFCD8}" dt="2022-04-29T15:36:29.957" v="888" actId="1038"/>
          <ac:picMkLst>
            <pc:docMk/>
            <pc:sldMk cId="1375688946" sldId="305"/>
            <ac:picMk id="5" creationId="{9D2561CE-EC2B-45FF-BDDD-776EA8959909}"/>
          </ac:picMkLst>
        </pc:picChg>
        <pc:picChg chg="add mod">
          <ac:chgData name="Miriam Schreiber" userId="5a452ff8-f189-44a9-9767-da59f69398bf" providerId="ADAL" clId="{7A8111AC-5017-4CF1-AB1B-6A71CD7BFCD8}" dt="2022-04-29T15:36:36.827" v="926" actId="1038"/>
          <ac:picMkLst>
            <pc:docMk/>
            <pc:sldMk cId="1375688946" sldId="305"/>
            <ac:picMk id="7" creationId="{30C458B4-C8E9-49C9-8DE7-BC53780B2A5D}"/>
          </ac:picMkLst>
        </pc:picChg>
      </pc:sldChg>
      <pc:sldChg chg="modSp new mod">
        <pc:chgData name="Miriam Schreiber" userId="5a452ff8-f189-44a9-9767-da59f69398bf" providerId="ADAL" clId="{7A8111AC-5017-4CF1-AB1B-6A71CD7BFCD8}" dt="2022-05-01T15:12:30.139" v="3736" actId="20577"/>
        <pc:sldMkLst>
          <pc:docMk/>
          <pc:sldMk cId="1251862347" sldId="306"/>
        </pc:sldMkLst>
        <pc:spChg chg="mod">
          <ac:chgData name="Miriam Schreiber" userId="5a452ff8-f189-44a9-9767-da59f69398bf" providerId="ADAL" clId="{7A8111AC-5017-4CF1-AB1B-6A71CD7BFCD8}" dt="2022-05-01T15:12:30.139" v="3736" actId="20577"/>
          <ac:spMkLst>
            <pc:docMk/>
            <pc:sldMk cId="1251862347" sldId="306"/>
            <ac:spMk id="2" creationId="{6788BF9D-8D7A-44BE-9892-A00E38126BAE}"/>
          </ac:spMkLst>
        </pc:spChg>
      </pc:sldChg>
      <pc:sldChg chg="add del">
        <pc:chgData name="Miriam Schreiber" userId="5a452ff8-f189-44a9-9767-da59f69398bf" providerId="ADAL" clId="{7A8111AC-5017-4CF1-AB1B-6A71CD7BFCD8}" dt="2022-04-29T12:37:10.458" v="60"/>
        <pc:sldMkLst>
          <pc:docMk/>
          <pc:sldMk cId="1599000518" sldId="306"/>
        </pc:sldMkLst>
      </pc:sldChg>
      <pc:sldChg chg="addSp delSp modSp new del mod">
        <pc:chgData name="Miriam Schreiber" userId="5a452ff8-f189-44a9-9767-da59f69398bf" providerId="ADAL" clId="{7A8111AC-5017-4CF1-AB1B-6A71CD7BFCD8}" dt="2022-04-29T15:35:26.365" v="775" actId="47"/>
        <pc:sldMkLst>
          <pc:docMk/>
          <pc:sldMk cId="3944929729" sldId="306"/>
        </pc:sldMkLst>
        <pc:spChg chg="del mod">
          <ac:chgData name="Miriam Schreiber" userId="5a452ff8-f189-44a9-9767-da59f69398bf" providerId="ADAL" clId="{7A8111AC-5017-4CF1-AB1B-6A71CD7BFCD8}" dt="2022-04-29T15:35:22.864" v="773" actId="21"/>
          <ac:spMkLst>
            <pc:docMk/>
            <pc:sldMk cId="3944929729" sldId="306"/>
            <ac:spMk id="3" creationId="{46FE6BC2-B95A-4110-A0AC-5C5AACD0FF01}"/>
          </ac:spMkLst>
        </pc:spChg>
        <pc:spChg chg="add mod">
          <ac:chgData name="Miriam Schreiber" userId="5a452ff8-f189-44a9-9767-da59f69398bf" providerId="ADAL" clId="{7A8111AC-5017-4CF1-AB1B-6A71CD7BFCD8}" dt="2022-04-29T15:35:22.864" v="773" actId="21"/>
          <ac:spMkLst>
            <pc:docMk/>
            <pc:sldMk cId="3944929729" sldId="306"/>
            <ac:spMk id="5" creationId="{6CD25C49-F028-44C0-8D21-559FDE4A1363}"/>
          </ac:spMkLst>
        </pc:spChg>
      </pc:sldChg>
      <pc:sldChg chg="add del">
        <pc:chgData name="Miriam Schreiber" userId="5a452ff8-f189-44a9-9767-da59f69398bf" providerId="ADAL" clId="{7A8111AC-5017-4CF1-AB1B-6A71CD7BFCD8}" dt="2022-04-29T12:37:10.458" v="60"/>
        <pc:sldMkLst>
          <pc:docMk/>
          <pc:sldMk cId="1922728065" sldId="307"/>
        </pc:sldMkLst>
      </pc:sldChg>
      <pc:sldChg chg="add del">
        <pc:chgData name="Miriam Schreiber" userId="5a452ff8-f189-44a9-9767-da59f69398bf" providerId="ADAL" clId="{7A8111AC-5017-4CF1-AB1B-6A71CD7BFCD8}" dt="2022-04-29T12:37:10.458" v="60"/>
        <pc:sldMkLst>
          <pc:docMk/>
          <pc:sldMk cId="1871971838" sldId="308"/>
        </pc:sldMkLst>
      </pc:sldChg>
      <pc:sldChg chg="add del">
        <pc:chgData name="Miriam Schreiber" userId="5a452ff8-f189-44a9-9767-da59f69398bf" providerId="ADAL" clId="{7A8111AC-5017-4CF1-AB1B-6A71CD7BFCD8}" dt="2022-04-29T12:37:10.458" v="60"/>
        <pc:sldMkLst>
          <pc:docMk/>
          <pc:sldMk cId="3123497319" sldId="30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E8F3E-CF78-465C-A68E-0AAD6D20F4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11B86D-3EA1-4BAA-A38A-6B5F45CD36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5C2D61-8C82-4F86-A668-945B6980A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7ADE81-DB90-49A6-9A80-23B1D54EE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8642D5-EE4D-4281-A0AF-8CB9E1856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0225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15148-0B91-4D63-9FB5-D9CAE61222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81B1DF-E7D2-4C94-A4EB-EADD82B01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48A50-EE26-41B1-9E4A-DE10798A4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A471CE-95A7-4D70-BD3B-4F6B8A528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9884C-BAC7-4B4A-8708-424E27320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27880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833ED0-A722-4E17-B61C-399374FD59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79E183-B2B4-424F-B1C7-F1B2CDD87F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56B3CC-55FC-4BF0-B075-045DEF368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D05D9A-A74C-49D5-B0BC-9583460D5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2158AB-D568-4E3B-A143-01D778FF2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08677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2799F-FE68-40F6-A9F5-9EA4AE96F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1F1F9C-D479-4DCE-847F-1CC15D613E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96B26C-D1D8-40FA-8128-572E33AF7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2B97D-8E06-4938-874D-0144CF439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4CF21-6DC7-40C8-92E7-8C99E8E16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66140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C9FB1-1385-456B-866F-E89952293E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2EC08D-1BC8-4061-9D8E-8D3801FEBB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622D07-536A-4A08-A0A0-7E27169E2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C73106-EEE6-4FB8-839D-16D8D72AD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929068-BD88-4DC4-B9FA-3EC80A7EA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08191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48E93-99B0-442B-A9BD-D3AF61BDF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09F9E2-0393-45A5-BD8C-2C31608F7D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1F364D-9D40-4D5A-A8F3-AFE1F7FEAE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C5FD29-3954-4A05-AB3D-DB59BE5D3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584BA5-6A8A-42E0-90E6-4CF3A1131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C56D67-AE39-475D-A988-29E5DBC20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2867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D089A-856C-4C3A-BFEB-9357FE1781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3E9904-C2B0-4B39-B5EE-39CE3DE0EE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8E743F-535C-4268-B6A0-1BDEF80032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9D1189-A1E7-42DD-80F5-CAB5347A35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0F5F6E-C371-4854-8938-86065250F9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FF3070-0F92-48AD-87C4-7F0FF7934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D49903-3889-472B-B2C6-81A383451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9432E7-A0DD-40B5-8BF0-8D8BF4BD6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83615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FB922-8ABE-4BFA-BE86-2F0FE93F2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D669DD-A10B-4BA3-B994-C6896F026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9EEC93-7614-4E0A-95C3-804B76D18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E8A316-3439-4B6A-AC4B-5AF123DFE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3095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E7F0D8-E935-4B79-9408-AD88AA4FB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B7B3D0-FEC3-43C4-A79D-A855FC130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A333E5-3228-4394-99EC-EF24BDD18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35789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072F0-A0A8-494F-89C3-214F2E180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A00B5D-4B10-4407-B792-39C9DEE809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1A89F6-1BD7-438C-8A1C-D21008ADFA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C9C6EC-8AD9-4024-A1CB-FDA5F3CAD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C5B5D-E606-416E-A677-6A98212C7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F1310B-28BD-4F08-9FB1-4B31A65BC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9919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78277-5E90-4F9F-8C67-843CC75E6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42139B-1E02-45E5-9E7F-847D74B866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C9756C-DD0F-40C8-ADC3-1245E45DB2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C15371-EF96-44FC-9829-DF8DD9122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630BEC-6EC7-4589-997A-F2707A8C9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C6F5BE-805B-462C-81CB-DD5054916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81241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0F30B2-116F-48B0-A803-55478A9E6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054E82-27E1-4A01-BE61-06556B9F8C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E5F5B4-F9AE-45BF-AA98-A824D2C976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73407-BCDC-4B0F-A087-275991E9A5CD}" type="datetimeFigureOut">
              <a:rPr lang="en-GB" smtClean="0"/>
              <a:t>27/07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E0EC3-B63A-48C5-8FB1-16E879EAC0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545CD9-19B3-4774-A279-1AD37F5567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66802-D2E9-45C4-8D04-C92D81BB0C8A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5332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2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iff"/><Relationship Id="rId2" Type="http://schemas.openxmlformats.org/officeDocument/2006/relationships/image" Target="../media/image4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1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tiff"/><Relationship Id="rId2" Type="http://schemas.openxmlformats.org/officeDocument/2006/relationships/image" Target="../media/image5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4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f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tiff"/><Relationship Id="rId2" Type="http://schemas.openxmlformats.org/officeDocument/2006/relationships/image" Target="../media/image5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0.tif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tiff"/><Relationship Id="rId2" Type="http://schemas.openxmlformats.org/officeDocument/2006/relationships/image" Target="../media/image6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3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tiff"/><Relationship Id="rId2" Type="http://schemas.openxmlformats.org/officeDocument/2006/relationships/image" Target="../media/image6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6.tif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tiff"/><Relationship Id="rId2" Type="http://schemas.openxmlformats.org/officeDocument/2006/relationships/image" Target="../media/image6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9.tif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tiff"/><Relationship Id="rId2" Type="http://schemas.openxmlformats.org/officeDocument/2006/relationships/image" Target="../media/image7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2.tif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tiff"/><Relationship Id="rId2" Type="http://schemas.openxmlformats.org/officeDocument/2006/relationships/image" Target="../media/image7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5.tif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tiff"/><Relationship Id="rId2" Type="http://schemas.openxmlformats.org/officeDocument/2006/relationships/image" Target="../media/image7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8.tif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tiff"/><Relationship Id="rId2" Type="http://schemas.openxmlformats.org/officeDocument/2006/relationships/image" Target="../media/image7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1.tif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tiff"/><Relationship Id="rId2" Type="http://schemas.openxmlformats.org/officeDocument/2006/relationships/image" Target="../media/image8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4.tif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tiff"/><Relationship Id="rId2" Type="http://schemas.openxmlformats.org/officeDocument/2006/relationships/image" Target="../media/image8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tiff"/><Relationship Id="rId2" Type="http://schemas.openxmlformats.org/officeDocument/2006/relationships/image" Target="../media/image8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0.tif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tiff"/><Relationship Id="rId2" Type="http://schemas.openxmlformats.org/officeDocument/2006/relationships/image" Target="../media/image9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3.tiff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tiff"/><Relationship Id="rId2" Type="http://schemas.openxmlformats.org/officeDocument/2006/relationships/image" Target="../media/image9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6.tiff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tiff"/><Relationship Id="rId2" Type="http://schemas.openxmlformats.org/officeDocument/2006/relationships/image" Target="../media/image9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9.tiff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tiff"/><Relationship Id="rId2" Type="http://schemas.openxmlformats.org/officeDocument/2006/relationships/image" Target="../media/image10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2.tiff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tiff"/><Relationship Id="rId2" Type="http://schemas.openxmlformats.org/officeDocument/2006/relationships/image" Target="../media/image10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5.tiff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tiff"/><Relationship Id="rId2" Type="http://schemas.openxmlformats.org/officeDocument/2006/relationships/image" Target="../media/image10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8.tif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tiff"/><Relationship Id="rId2" Type="http://schemas.openxmlformats.org/officeDocument/2006/relationships/image" Target="../media/image10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1.tiff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tiff"/><Relationship Id="rId2" Type="http://schemas.openxmlformats.org/officeDocument/2006/relationships/image" Target="../media/image11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4.tiff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tiff"/><Relationship Id="rId2" Type="http://schemas.openxmlformats.org/officeDocument/2006/relationships/image" Target="../media/image11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tiff"/><Relationship Id="rId2" Type="http://schemas.openxmlformats.org/officeDocument/2006/relationships/image" Target="../media/image11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0.tif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tiff"/><Relationship Id="rId2" Type="http://schemas.openxmlformats.org/officeDocument/2006/relationships/image" Target="../media/image12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3.tiff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tiff"/><Relationship Id="rId2" Type="http://schemas.openxmlformats.org/officeDocument/2006/relationships/image" Target="../media/image12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6.tiff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tiff"/><Relationship Id="rId2" Type="http://schemas.openxmlformats.org/officeDocument/2006/relationships/image" Target="../media/image12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9.tiff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tiff"/><Relationship Id="rId2" Type="http://schemas.openxmlformats.org/officeDocument/2006/relationships/image" Target="../media/image13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2.tiff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4.tiff"/><Relationship Id="rId2" Type="http://schemas.openxmlformats.org/officeDocument/2006/relationships/image" Target="../media/image13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5.tiff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7.tiff"/><Relationship Id="rId2" Type="http://schemas.openxmlformats.org/officeDocument/2006/relationships/image" Target="../media/image13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8.tiff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0.tiff"/><Relationship Id="rId2" Type="http://schemas.openxmlformats.org/officeDocument/2006/relationships/image" Target="../media/image13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2.tiff"/><Relationship Id="rId4" Type="http://schemas.openxmlformats.org/officeDocument/2006/relationships/image" Target="../media/image141.tiff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4.tiff"/><Relationship Id="rId2" Type="http://schemas.openxmlformats.org/officeDocument/2006/relationships/image" Target="../media/image14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5.tiff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7.tiff"/><Relationship Id="rId2" Type="http://schemas.openxmlformats.org/officeDocument/2006/relationships/image" Target="../media/image14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f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0.tiff"/><Relationship Id="rId2" Type="http://schemas.openxmlformats.org/officeDocument/2006/relationships/image" Target="../media/image14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1.tiff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3.tiff"/><Relationship Id="rId2" Type="http://schemas.openxmlformats.org/officeDocument/2006/relationships/image" Target="../media/image15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4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8BF9D-8D7A-44BE-9892-A00E38126B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3412" y="2791012"/>
            <a:ext cx="11385176" cy="2387600"/>
          </a:xfrm>
        </p:spPr>
        <p:txBody>
          <a:bodyPr>
            <a:normAutofit fontScale="90000"/>
          </a:bodyPr>
          <a:lstStyle/>
          <a:p>
            <a:pPr algn="l"/>
            <a:r>
              <a:rPr lang="en-GB" sz="4000" dirty="0"/>
              <a:t>Supplemental Material 1: </a:t>
            </a:r>
            <a:br>
              <a:rPr lang="en-GB" sz="4000" dirty="0"/>
            </a:br>
            <a:r>
              <a:rPr lang="en-GB" sz="4000" dirty="0"/>
              <a:t>Plotted variant calling for all 50 individuals. The first plot shows the raw counts results. The second plot displays the results after adjusting with the sliding window approach (see Figure 3 in main manuscript).</a:t>
            </a:r>
            <a:br>
              <a:rPr lang="en-GB" sz="4000" dirty="0"/>
            </a:br>
            <a:r>
              <a:rPr lang="en-GB" sz="4000" dirty="0"/>
              <a:t>The third plot highlights the counted CO positions in red).</a:t>
            </a:r>
            <a:br>
              <a:rPr lang="en-GB" sz="4000" dirty="0"/>
            </a:br>
            <a:r>
              <a:rPr lang="en-GB" sz="4000" dirty="0"/>
              <a:t>For certain regions a close-up example are shown.</a:t>
            </a:r>
          </a:p>
        </p:txBody>
      </p:sp>
    </p:spTree>
    <p:extLst>
      <p:ext uri="{BB962C8B-B14F-4D97-AF65-F5344CB8AC3E}">
        <p14:creationId xmlns:p14="http://schemas.microsoft.com/office/powerpoint/2010/main" val="12518623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67C9A00-8ADF-4ACC-A0AC-A18BD9FB106A}"/>
              </a:ext>
            </a:extLst>
          </p:cNvPr>
          <p:cNvSpPr txBox="1">
            <a:spLocks/>
          </p:cNvSpPr>
          <p:nvPr/>
        </p:nvSpPr>
        <p:spPr>
          <a:xfrm>
            <a:off x="847436" y="1058210"/>
            <a:ext cx="11023599" cy="102232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2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6078E955-ECDB-49A9-8307-88ADBECF2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9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7FC4585-CBCA-CD86-22BE-5B65EE85D4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6286" y="2353332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6DB5E4E4-1F89-0E87-08CB-013AF8E3B95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851" y="2353332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F24FC46-AE4D-B458-5C87-8431F7110A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52" y="235333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4947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7E67B85-8AFE-49ED-AFB1-205A848DFEF3}"/>
              </a:ext>
            </a:extLst>
          </p:cNvPr>
          <p:cNvSpPr txBox="1">
            <a:spLocks/>
          </p:cNvSpPr>
          <p:nvPr/>
        </p:nvSpPr>
        <p:spPr>
          <a:xfrm>
            <a:off x="847725" y="1064468"/>
            <a:ext cx="11023599" cy="989044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0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41B74A1D-04CE-46D7-B1FB-216F04B1D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0</a:t>
            </a:r>
          </a:p>
        </p:txBody>
      </p:sp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29E8DF7-51FD-96CF-A0E6-084E017A00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588" y="2353849"/>
            <a:ext cx="3514096" cy="4392000"/>
          </a:xfrm>
          <a:prstGeom prst="rect">
            <a:avLst/>
          </a:prstGeom>
        </p:spPr>
      </p:pic>
      <p:pic>
        <p:nvPicPr>
          <p:cNvPr id="13" name="Picture 1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6254F0A5-3782-185D-9F59-D17B5C3D1A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610" y="2353849"/>
            <a:ext cx="3514096" cy="4392000"/>
          </a:xfrm>
          <a:prstGeom prst="rect">
            <a:avLst/>
          </a:prstGeom>
        </p:spPr>
      </p:pic>
      <p:pic>
        <p:nvPicPr>
          <p:cNvPr id="5" name="Picture 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2D513A0-AF9A-1D55-A387-2AAC184519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6567" y="2354791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91430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136EF18-8B7E-44E9-BA63-04110F999032}"/>
              </a:ext>
            </a:extLst>
          </p:cNvPr>
          <p:cNvSpPr txBox="1">
            <a:spLocks/>
          </p:cNvSpPr>
          <p:nvPr/>
        </p:nvSpPr>
        <p:spPr>
          <a:xfrm>
            <a:off x="847436" y="1063691"/>
            <a:ext cx="11023599" cy="107302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2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EA11709F-110E-47B6-AF2A-EBBB03506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1</a:t>
            </a:r>
          </a:p>
        </p:txBody>
      </p:sp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DE2DA0F-1935-00C6-4807-B2826682EA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652" y="2350207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42CAEF77-C24F-9556-89D4-8BA3C5FD48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12" y="2350332"/>
            <a:ext cx="3514096" cy="4392000"/>
          </a:xfrm>
          <a:prstGeom prst="rect">
            <a:avLst/>
          </a:prstGeom>
        </p:spPr>
      </p:pic>
      <p:pic>
        <p:nvPicPr>
          <p:cNvPr id="7" name="Picture 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BBD782F9-33EC-C24A-092B-24F2A65B84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392" y="235148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53014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FDD467F-C7C1-4EF4-91AD-144B5D8BDA1C}"/>
              </a:ext>
            </a:extLst>
          </p:cNvPr>
          <p:cNvSpPr txBox="1">
            <a:spLocks/>
          </p:cNvSpPr>
          <p:nvPr/>
        </p:nvSpPr>
        <p:spPr>
          <a:xfrm>
            <a:off x="847436" y="1063370"/>
            <a:ext cx="11023599" cy="119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5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AB4372E7-8724-48FB-A29D-531CA0B36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2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7E8E3AF-B9AB-9699-B9B6-6AEF0AAF2C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0048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C1D56F29-85D7-80F8-4C67-10A1497286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21" y="235005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C45A2DA-276C-00D1-AFA2-8757384C7F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662" y="235004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7675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964CA16-FFDA-4C42-BA5E-F0E1143F3494}"/>
              </a:ext>
            </a:extLst>
          </p:cNvPr>
          <p:cNvSpPr txBox="1">
            <a:spLocks/>
          </p:cNvSpPr>
          <p:nvPr/>
        </p:nvSpPr>
        <p:spPr>
          <a:xfrm>
            <a:off x="847436" y="1062650"/>
            <a:ext cx="11023599" cy="111034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6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439EDA30-8425-4901-802E-90207EE97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3</a:t>
            </a:r>
          </a:p>
        </p:txBody>
      </p:sp>
      <p:pic>
        <p:nvPicPr>
          <p:cNvPr id="9" name="Picture 8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889B3A18-D439-F070-2CCD-239476FE1A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762" y="2349912"/>
            <a:ext cx="3514096" cy="4392000"/>
          </a:xfrm>
          <a:prstGeom prst="rect">
            <a:avLst/>
          </a:prstGeom>
        </p:spPr>
      </p:pic>
      <p:pic>
        <p:nvPicPr>
          <p:cNvPr id="13" name="Picture 1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54C1BE7-7C63-C7A6-13D5-8CDEDC85D9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31" y="2349911"/>
            <a:ext cx="3514096" cy="4392000"/>
          </a:xfrm>
          <a:prstGeom prst="rect">
            <a:avLst/>
          </a:prstGeom>
        </p:spPr>
      </p:pic>
      <p:pic>
        <p:nvPicPr>
          <p:cNvPr id="15" name="Picture 1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9247245-3B40-6F99-18F4-D496D258B5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196" y="234862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699198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9C79450-6BD3-4489-93FC-DB1217F398AB}"/>
              </a:ext>
            </a:extLst>
          </p:cNvPr>
          <p:cNvSpPr txBox="1">
            <a:spLocks/>
          </p:cNvSpPr>
          <p:nvPr/>
        </p:nvSpPr>
        <p:spPr>
          <a:xfrm>
            <a:off x="847436" y="1063311"/>
            <a:ext cx="11023599" cy="989044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9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FD0D2ADE-633D-4322-A6FB-4C5F50CF18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4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FF4045E-17F5-FE64-0BD7-9356AB8068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2245" y="2351951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E11DB744-274D-413B-8D3B-25A7FF5A58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354" y="2351953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A07E126-EB13-346B-47E8-3523305F11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799" y="2351951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7412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E7D0881-5A91-43C3-B747-B953909A7062}"/>
              </a:ext>
            </a:extLst>
          </p:cNvPr>
          <p:cNvSpPr txBox="1">
            <a:spLocks/>
          </p:cNvSpPr>
          <p:nvPr/>
        </p:nvSpPr>
        <p:spPr>
          <a:xfrm>
            <a:off x="847436" y="1062840"/>
            <a:ext cx="11023599" cy="11569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7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5E74E256-A11E-4CA5-A6CE-F839DB2138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5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B6BB453B-F42B-DCDB-0DED-31F04DE60F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552" y="2349144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83641E18-856D-7896-EF2D-14717A7193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057" y="2349144"/>
            <a:ext cx="3514096" cy="4392000"/>
          </a:xfrm>
          <a:prstGeom prst="rect">
            <a:avLst/>
          </a:prstGeom>
        </p:spPr>
      </p:pic>
      <p:pic>
        <p:nvPicPr>
          <p:cNvPr id="13" name="Picture 1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95451E3D-662F-9BC8-CA81-1D7D33E8CF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63" y="235025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0474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8C13013-5966-4872-A46E-E18762FC371F}"/>
              </a:ext>
            </a:extLst>
          </p:cNvPr>
          <p:cNvSpPr txBox="1">
            <a:spLocks/>
          </p:cNvSpPr>
          <p:nvPr/>
        </p:nvSpPr>
        <p:spPr>
          <a:xfrm>
            <a:off x="847436" y="1062650"/>
            <a:ext cx="11023599" cy="12316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2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791DA3DB-C4B1-4723-9410-876441A38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6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0FC078B-1BB0-F128-A097-CFA9248108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961" y="2349707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DB6EEDF0-8209-50DD-0C52-39A048916A0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154" y="234971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ECA856D-4CB6-FF68-32B3-08CC477BCF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057" y="2349707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453896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7FB7F16-D884-4E3B-8711-96937AF5D979}"/>
              </a:ext>
            </a:extLst>
          </p:cNvPr>
          <p:cNvSpPr txBox="1">
            <a:spLocks/>
          </p:cNvSpPr>
          <p:nvPr/>
        </p:nvSpPr>
        <p:spPr>
          <a:xfrm>
            <a:off x="844550" y="1063122"/>
            <a:ext cx="11023599" cy="101703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24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E23B6DDF-311E-4821-917B-F5F725876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7</a:t>
            </a:r>
          </a:p>
        </p:txBody>
      </p:sp>
      <p:pic>
        <p:nvPicPr>
          <p:cNvPr id="3" name="Picture 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D69588AB-C0EC-30F8-737F-58CA70D415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953" y="2351290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FFDF61E-35C8-7A09-FE41-5410E8065A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52" y="2351290"/>
            <a:ext cx="3514096" cy="4392000"/>
          </a:xfrm>
          <a:prstGeom prst="rect">
            <a:avLst/>
          </a:prstGeom>
        </p:spPr>
      </p:pic>
      <p:pic>
        <p:nvPicPr>
          <p:cNvPr id="13" name="Picture 12" descr="Application&#10;&#10;Description automatically generated with low confidence">
            <a:extLst>
              <a:ext uri="{FF2B5EF4-FFF2-40B4-BE49-F238E27FC236}">
                <a16:creationId xmlns:a16="http://schemas.microsoft.com/office/drawing/2014/main" id="{104A28DA-BA72-57EE-DF97-E7B8B92C33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270" y="2351290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6095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B0EB6B2B-7B86-4777-8711-BEC1086FAE6C}"/>
              </a:ext>
            </a:extLst>
          </p:cNvPr>
          <p:cNvSpPr txBox="1">
            <a:spLocks/>
          </p:cNvSpPr>
          <p:nvPr/>
        </p:nvSpPr>
        <p:spPr>
          <a:xfrm>
            <a:off x="847436" y="1063029"/>
            <a:ext cx="11023599" cy="11476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8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EFAA2DB3-AB89-4C34-B823-EAFE222081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8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1752317-FAC6-FE57-22A7-46FA48673C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903" y="2349763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6FADA0A-4FAD-4D61-12C6-0C8A45AEEB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90" y="234976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7E9F08D-448A-7A09-7EFF-02D729A1F4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096" y="234976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9478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4D194A9A-FA82-4B66-899B-251F60ACC329}"/>
              </a:ext>
            </a:extLst>
          </p:cNvPr>
          <p:cNvSpPr txBox="1">
            <a:spLocks/>
          </p:cNvSpPr>
          <p:nvPr/>
        </p:nvSpPr>
        <p:spPr>
          <a:xfrm>
            <a:off x="847436" y="1061488"/>
            <a:ext cx="6769896" cy="1039789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3 cross over</a:t>
            </a:r>
          </a:p>
          <a:p>
            <a:endParaRPr lang="en-GB" dirty="0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81A037DC-49A4-4C4A-9F61-C2B5B97CAE93}"/>
              </a:ext>
            </a:extLst>
          </p:cNvPr>
          <p:cNvSpPr txBox="1">
            <a:spLocks/>
          </p:cNvSpPr>
          <p:nvPr/>
        </p:nvSpPr>
        <p:spPr>
          <a:xfrm>
            <a:off x="838200" y="420541"/>
            <a:ext cx="10515600" cy="52188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4000" dirty="0"/>
              <a:t>Bowman_EMS_M3_1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AD292AC-1304-C761-3809-8153F8067C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2139" y="2353107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63DF66E-63FE-0C0C-712D-C030E5B468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058" y="2353107"/>
            <a:ext cx="3514096" cy="4392000"/>
          </a:xfrm>
          <a:prstGeom prst="rect">
            <a:avLst/>
          </a:prstGeom>
        </p:spPr>
      </p:pic>
      <p:pic>
        <p:nvPicPr>
          <p:cNvPr id="13" name="Picture 1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E8CE7C86-8F6F-7521-AD30-9C69ABC026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78" y="2353107"/>
            <a:ext cx="3514096" cy="4392000"/>
          </a:xfrm>
          <a:prstGeom prst="rect">
            <a:avLst/>
          </a:prstGeom>
        </p:spPr>
      </p:pic>
      <p:pic>
        <p:nvPicPr>
          <p:cNvPr id="7" name="Picture 6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EEAEA06E-9BB1-3136-D8CD-F7735D0D698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5489" y="61074"/>
            <a:ext cx="3378708" cy="2250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476170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048B1DF-517F-4412-8748-313CCB03431C}"/>
              </a:ext>
            </a:extLst>
          </p:cNvPr>
          <p:cNvSpPr txBox="1">
            <a:spLocks/>
          </p:cNvSpPr>
          <p:nvPr/>
        </p:nvSpPr>
        <p:spPr>
          <a:xfrm>
            <a:off x="847438" y="1059010"/>
            <a:ext cx="11023599" cy="11577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7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03C7374D-F934-4597-BAF9-6212B4655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19</a:t>
            </a:r>
          </a:p>
        </p:txBody>
      </p:sp>
      <p:pic>
        <p:nvPicPr>
          <p:cNvPr id="15" name="Picture 14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1B686652-C541-9E8D-EA80-7D4772084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67" y="2349246"/>
            <a:ext cx="3514096" cy="4392000"/>
          </a:xfrm>
          <a:prstGeom prst="rect">
            <a:avLst/>
          </a:prstGeom>
        </p:spPr>
      </p:pic>
      <p:pic>
        <p:nvPicPr>
          <p:cNvPr id="17" name="Picture 1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603634C-1822-370F-F8CB-77815EB386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6567" y="2352888"/>
            <a:ext cx="3514096" cy="4392000"/>
          </a:xfrm>
          <a:prstGeom prst="rect">
            <a:avLst/>
          </a:prstGeom>
        </p:spPr>
      </p:pic>
      <p:pic>
        <p:nvPicPr>
          <p:cNvPr id="19" name="Picture 18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9AF4BCC5-7A96-F6ED-D668-6ACB68FC28A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067" y="2349246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736477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BF33752-3FC7-4788-A089-A4082ADAD222}"/>
              </a:ext>
            </a:extLst>
          </p:cNvPr>
          <p:cNvSpPr txBox="1">
            <a:spLocks/>
          </p:cNvSpPr>
          <p:nvPr/>
        </p:nvSpPr>
        <p:spPr>
          <a:xfrm>
            <a:off x="847436" y="1063122"/>
            <a:ext cx="11023599" cy="101703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6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A047869D-F5AC-4947-993E-2960A3D15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0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7DCD99F-CD84-DB21-36E1-6F8F866471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2095" y="2354985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7B8F844-A7EC-7BCD-D579-9113D0E4F8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714" y="2348628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33BC61E8-D422-757C-50D2-72860B48034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34" y="235498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721057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AB776A6-BAB2-44B8-9E57-E586B4F32EB3}"/>
              </a:ext>
            </a:extLst>
          </p:cNvPr>
          <p:cNvSpPr txBox="1">
            <a:spLocks/>
          </p:cNvSpPr>
          <p:nvPr/>
        </p:nvSpPr>
        <p:spPr>
          <a:xfrm>
            <a:off x="847436" y="1063218"/>
            <a:ext cx="11023599" cy="11756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0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D2EF0569-450E-4B60-975D-CBB7B9F41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1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82D12CD-E58F-E683-00C0-AE12DF8EBC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0426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8C402857-DDE6-F039-89ED-590ED1FDBF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50426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0DFBDCD-F6DD-9847-AC61-DD090FAA647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50426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001861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93C06FC-B407-407F-A0B9-1CD61D6F0CF0}"/>
              </a:ext>
            </a:extLst>
          </p:cNvPr>
          <p:cNvSpPr txBox="1">
            <a:spLocks/>
          </p:cNvSpPr>
          <p:nvPr/>
        </p:nvSpPr>
        <p:spPr>
          <a:xfrm>
            <a:off x="847436" y="1063029"/>
            <a:ext cx="11023599" cy="101703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7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03F66D35-B6B1-4D90-AAEB-BBAF59B63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2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9413B36-AC8B-843F-AF86-B9C3BAFA79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400" y="2352295"/>
            <a:ext cx="3514096" cy="4392000"/>
          </a:xfrm>
          <a:prstGeom prst="rect">
            <a:avLst/>
          </a:prstGeom>
        </p:spPr>
      </p:pic>
      <p:pic>
        <p:nvPicPr>
          <p:cNvPr id="11" name="Picture 10" descr="Application&#10;&#10;Description automatically generated with low confidence">
            <a:extLst>
              <a:ext uri="{FF2B5EF4-FFF2-40B4-BE49-F238E27FC236}">
                <a16:creationId xmlns:a16="http://schemas.microsoft.com/office/drawing/2014/main" id="{4B6C7BBC-0AF0-D18D-4F1A-BB9ED77E29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732" y="2352293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1ECE49B-0EBE-54D5-ABA4-D1362144632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5066" y="234844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666278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62B0B4D-BAF2-4325-B915-0CF714CEF515}"/>
              </a:ext>
            </a:extLst>
          </p:cNvPr>
          <p:cNvSpPr txBox="1">
            <a:spLocks/>
          </p:cNvSpPr>
          <p:nvPr/>
        </p:nvSpPr>
        <p:spPr>
          <a:xfrm>
            <a:off x="847436" y="1063122"/>
            <a:ext cx="11023599" cy="12036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3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C5F0D989-FC28-40B3-8A97-B2021A992C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3</a:t>
            </a:r>
          </a:p>
        </p:txBody>
      </p:sp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793F53A3-C01C-CF60-785F-13355A4981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9899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11DF3466-15C9-10D2-E29B-A8C5A99145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89" y="234990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256F431-1C5C-24D2-CCD0-C72E6DC43B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946" y="234989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306976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50CACA9-9C0D-49E2-A76D-AB5821A41F77}"/>
              </a:ext>
            </a:extLst>
          </p:cNvPr>
          <p:cNvSpPr txBox="1">
            <a:spLocks/>
          </p:cNvSpPr>
          <p:nvPr/>
        </p:nvSpPr>
        <p:spPr>
          <a:xfrm>
            <a:off x="847436" y="1063785"/>
            <a:ext cx="11023599" cy="125030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7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9547C9F9-2ECC-4332-8A1F-6B0D24064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4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B765045-44DB-CCF3-0EA4-BC60992AEE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5362" y="2351031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249B5C50-D198-36D5-5A31-F33F027C19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76" y="235103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96B33EE-CA13-EC94-8DBA-1971BA0518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69" y="2351031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430764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08E004A-EF2B-4DC0-BEE9-82D6E1BD7208}"/>
              </a:ext>
            </a:extLst>
          </p:cNvPr>
          <p:cNvSpPr txBox="1">
            <a:spLocks/>
          </p:cNvSpPr>
          <p:nvPr/>
        </p:nvSpPr>
        <p:spPr>
          <a:xfrm>
            <a:off x="847436" y="1062650"/>
            <a:ext cx="11023599" cy="11476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0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C05B744C-1F3B-496A-9F47-7B392183C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5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C391552-699E-E504-0D78-D10CD76132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9009"/>
            <a:ext cx="3514096" cy="4392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91F06FE-1114-3127-117D-CD5C2E1DB2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84" y="2349010"/>
            <a:ext cx="3514096" cy="4392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67225FB-91DB-E7F0-75BF-C1E22842AF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993" y="2348857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847802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A7B7D13-5693-4F42-8663-C0D4C0026FF8}"/>
              </a:ext>
            </a:extLst>
          </p:cNvPr>
          <p:cNvSpPr txBox="1">
            <a:spLocks/>
          </p:cNvSpPr>
          <p:nvPr/>
        </p:nvSpPr>
        <p:spPr>
          <a:xfrm>
            <a:off x="847436" y="1062838"/>
            <a:ext cx="11023599" cy="11476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7521C334-F692-4D3C-8EB5-86B8FFF629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A2CCA40-0F01-05CB-85C1-AC6FB6BD78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4312" y="2351839"/>
            <a:ext cx="3514096" cy="4392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F1E0B43-7420-87E4-2C1C-7DCE38BE52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32" y="2351839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0F27FC6-091E-2884-F4BD-71137645FD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2" y="2351839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101594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2ABBA9E-5E78-4392-9620-B9C9CD81C30F}"/>
              </a:ext>
            </a:extLst>
          </p:cNvPr>
          <p:cNvSpPr txBox="1">
            <a:spLocks/>
          </p:cNvSpPr>
          <p:nvPr/>
        </p:nvSpPr>
        <p:spPr>
          <a:xfrm>
            <a:off x="847436" y="1063122"/>
            <a:ext cx="11023599" cy="1000584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14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B8004C34-4A3E-4515-B374-561A441300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</a:t>
            </a:r>
          </a:p>
        </p:txBody>
      </p:sp>
      <p:pic>
        <p:nvPicPr>
          <p:cNvPr id="3" name="Picture 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9DD5A558-87E4-165E-E039-5B8F317D1B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9214" y="2350252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3329143-95BA-FD01-E019-A04B1543C8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830" y="235065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8DE479A-F289-FD1E-2479-D16C3564C9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446" y="235025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957268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E16B56B-25A7-4CAB-93B0-FD84BD9B04C9}"/>
              </a:ext>
            </a:extLst>
          </p:cNvPr>
          <p:cNvSpPr txBox="1">
            <a:spLocks/>
          </p:cNvSpPr>
          <p:nvPr/>
        </p:nvSpPr>
        <p:spPr>
          <a:xfrm>
            <a:off x="847436" y="1063501"/>
            <a:ext cx="11023599" cy="108235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4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EDB6F7AD-EFB1-45D3-B2C2-A6004941CA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3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A392C40-9051-5948-2DDE-B2132E6D75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925" y="2350047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8BD41570-4DE9-48B4-BFBE-35BBE9EAEC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253" y="2350047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B56B987-CCBA-771B-11E8-A2D804B2039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089" y="2350047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88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9660C4D-04F0-4B70-98AD-637D01BD6EBA}"/>
              </a:ext>
            </a:extLst>
          </p:cNvPr>
          <p:cNvSpPr txBox="1">
            <a:spLocks/>
          </p:cNvSpPr>
          <p:nvPr/>
        </p:nvSpPr>
        <p:spPr>
          <a:xfrm>
            <a:off x="847436" y="1063520"/>
            <a:ext cx="11023599" cy="1045028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3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C5709267-CBE0-48CD-B55E-E4927E1AE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2</a:t>
            </a:r>
          </a:p>
        </p:txBody>
      </p:sp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479F336C-4868-56AC-922D-33071CF2D7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171" y="235633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3E23A1C-B00F-3B08-EBC3-4D1FF76094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937" y="2354619"/>
            <a:ext cx="3514096" cy="4392000"/>
          </a:xfrm>
          <a:prstGeom prst="rect">
            <a:avLst/>
          </a:prstGeom>
        </p:spPr>
      </p:pic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4CB3325-C02C-23E9-32F4-C2A62C3F067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9246"/>
            <a:ext cx="3514096" cy="439200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E6B4F072-91DD-7E3A-F378-F673B3F8F6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2734" y="59604"/>
            <a:ext cx="3377384" cy="225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145544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8A87CD9-7C3A-4B5B-AC44-B6541CEBE8C7}"/>
              </a:ext>
            </a:extLst>
          </p:cNvPr>
          <p:cNvSpPr txBox="1">
            <a:spLocks/>
          </p:cNvSpPr>
          <p:nvPr/>
        </p:nvSpPr>
        <p:spPr>
          <a:xfrm>
            <a:off x="847436" y="1062744"/>
            <a:ext cx="11023599" cy="111967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6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F7825EB0-F84F-4CFE-81F2-8B4A4959CD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4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55650E7-BF8C-301D-DBF4-582861C384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6703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D49192AA-0617-1C99-FA75-1C8073FE40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46703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E28B52C-AF09-BD47-464E-B0248A6EE5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4866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49337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D60637C-53D7-4E02-81B7-14B0C1308C2D}"/>
              </a:ext>
            </a:extLst>
          </p:cNvPr>
          <p:cNvSpPr txBox="1">
            <a:spLocks/>
          </p:cNvSpPr>
          <p:nvPr/>
        </p:nvSpPr>
        <p:spPr>
          <a:xfrm>
            <a:off x="847436" y="1063406"/>
            <a:ext cx="11023599" cy="102636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10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FD00B717-DE55-4C53-ACEA-46D8BA1C6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5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C817AE6-1A33-CFF0-BA2E-29DD21CEB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4497" y="2349291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4AC688B-AEBF-421C-2CB3-E797C533F7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44" y="2349292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523A676-DF6F-958F-7E05-38B5C940C7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4929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885399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BB469A1-1C03-4F61-B510-A317EED09C2D}"/>
              </a:ext>
            </a:extLst>
          </p:cNvPr>
          <p:cNvSpPr txBox="1">
            <a:spLocks/>
          </p:cNvSpPr>
          <p:nvPr/>
        </p:nvSpPr>
        <p:spPr>
          <a:xfrm>
            <a:off x="847436" y="1063501"/>
            <a:ext cx="11023599" cy="11476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6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138202AF-DE71-488E-968D-A106D9614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6</a:t>
            </a:r>
          </a:p>
        </p:txBody>
      </p:sp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469A01C-F6F0-066F-EEE7-F2CB47553A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974" y="2354619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7B9EE34-19DB-8481-0B5D-0B69B72CA9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5838" y="2348525"/>
            <a:ext cx="3514096" cy="4392000"/>
          </a:xfrm>
          <a:prstGeom prst="rect">
            <a:avLst/>
          </a:prstGeom>
        </p:spPr>
      </p:pic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F310ED0-D1E9-E7F2-BFF3-DF48330711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852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94889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29551B27-21AC-4C8D-B0D4-A619BA82A16A}"/>
              </a:ext>
            </a:extLst>
          </p:cNvPr>
          <p:cNvSpPr txBox="1">
            <a:spLocks/>
          </p:cNvSpPr>
          <p:nvPr/>
        </p:nvSpPr>
        <p:spPr>
          <a:xfrm>
            <a:off x="847436" y="1063690"/>
            <a:ext cx="11023599" cy="106369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3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829181EA-7717-44C2-8535-80ED0F41B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7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B0D25DF-44E1-1455-3173-ED1902FC70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552" y="2350236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A124806D-CAAB-3FD4-CBE3-A5637F0BD1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875" y="2350236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DAECFDB-B7F5-11E4-795C-A81C952D74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213" y="2350236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15672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BA0B57D-FB38-431E-A464-D415DFE34D74}"/>
              </a:ext>
            </a:extLst>
          </p:cNvPr>
          <p:cNvSpPr txBox="1">
            <a:spLocks/>
          </p:cNvSpPr>
          <p:nvPr/>
        </p:nvSpPr>
        <p:spPr>
          <a:xfrm>
            <a:off x="847436" y="1062838"/>
            <a:ext cx="11023599" cy="108235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581E3B7D-0F4E-49C9-A1E2-73FA796AD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8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A443AB4-BA2A-CAEF-A31F-BA8ACB0FDF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3768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FB39B434-4408-DFD0-7CD1-87D6D411C4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82" y="234872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89019D0A-5298-E7E8-24DB-994F25FC9F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992" y="235376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067815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5DEC47C-E0EE-41D9-95D9-3F6B1D862F69}"/>
              </a:ext>
            </a:extLst>
          </p:cNvPr>
          <p:cNvSpPr txBox="1">
            <a:spLocks/>
          </p:cNvSpPr>
          <p:nvPr/>
        </p:nvSpPr>
        <p:spPr>
          <a:xfrm>
            <a:off x="847436" y="1063975"/>
            <a:ext cx="11023599" cy="11569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8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9CBA7C0B-A56B-4C35-908D-47612426BE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9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7540FC1-1DD0-6DCF-579E-5143D1C038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5035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CB70B0BA-9B1B-A7CE-25E6-5344C7963C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5503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F39DC2B-1B81-C96D-53A3-F9DD454760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5027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9789028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3948DBD-C6BE-419C-9B95-12A5E92359EB}"/>
              </a:ext>
            </a:extLst>
          </p:cNvPr>
          <p:cNvSpPr txBox="1">
            <a:spLocks/>
          </p:cNvSpPr>
          <p:nvPr/>
        </p:nvSpPr>
        <p:spPr>
          <a:xfrm>
            <a:off x="847436" y="1063880"/>
            <a:ext cx="11023599" cy="1018524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11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174ED430-0C08-4969-84B5-7909967EE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0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6F0C0E1-A2FD-466F-119F-91AFE23FCA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9115" y="2354910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2C67E49F-AA63-3E88-F1EB-C28E4A4859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518" y="235491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158E23F-877F-A98A-FEA0-AAEA032172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816" y="2354910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191133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DC5F5444-229F-4DD8-A4D1-94AA5FA88350}"/>
              </a:ext>
            </a:extLst>
          </p:cNvPr>
          <p:cNvSpPr txBox="1">
            <a:spLocks/>
          </p:cNvSpPr>
          <p:nvPr/>
        </p:nvSpPr>
        <p:spPr>
          <a:xfrm>
            <a:off x="847436" y="1063690"/>
            <a:ext cx="11023599" cy="111967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3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86CD6881-1771-49F8-9D0D-0C211E6BA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1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811EC6E-51E6-244F-48F1-C812B5B64E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2722" y="2352955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86717E59-8D22-1C10-C4BA-01F6E75C63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02" y="2354486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D8576EA-5C9E-0335-F17A-CCA326D899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062" y="235448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13926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98441B3-0507-4896-85DE-F9FC8FB1E198}"/>
              </a:ext>
            </a:extLst>
          </p:cNvPr>
          <p:cNvSpPr txBox="1">
            <a:spLocks/>
          </p:cNvSpPr>
          <p:nvPr/>
        </p:nvSpPr>
        <p:spPr>
          <a:xfrm>
            <a:off x="847436" y="1063028"/>
            <a:ext cx="11023599" cy="103569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17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C8A2660C-5B96-4CAF-A914-BECFA0BACB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2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7F4201E-1D0E-2C52-B2A3-769DCBE158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4311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44589BCF-186C-89C6-80FB-10BF2987AA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13" y="235431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FAB859D-8BE8-C325-DCD9-969C8DA712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758" y="2348627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143781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479FDC4-BCBE-43F0-808F-E583A72DA177}"/>
              </a:ext>
            </a:extLst>
          </p:cNvPr>
          <p:cNvSpPr txBox="1">
            <a:spLocks/>
          </p:cNvSpPr>
          <p:nvPr/>
        </p:nvSpPr>
        <p:spPr>
          <a:xfrm>
            <a:off x="847436" y="1063028"/>
            <a:ext cx="11023599" cy="110249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559C74AF-5874-4FEA-919A-478615591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3</a:t>
            </a:r>
          </a:p>
        </p:txBody>
      </p:sp>
      <p:pic>
        <p:nvPicPr>
          <p:cNvPr id="3" name="Picture 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B8711312-0060-7D9C-9626-89C25F1F90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141" y="2354846"/>
            <a:ext cx="3514096" cy="4392000"/>
          </a:xfrm>
          <a:prstGeom prst="rect">
            <a:avLst/>
          </a:prstGeom>
        </p:spPr>
      </p:pic>
      <p:pic>
        <p:nvPicPr>
          <p:cNvPr id="11" name="Picture 10" descr="Application&#10;&#10;Description automatically generated with medium confidence">
            <a:extLst>
              <a:ext uri="{FF2B5EF4-FFF2-40B4-BE49-F238E27FC236}">
                <a16:creationId xmlns:a16="http://schemas.microsoft.com/office/drawing/2014/main" id="{C141B540-1C74-3A33-7EF5-6EB04234AB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98" y="235018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1D18916-5F43-D07C-4B94-ACD8D96EF53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69" y="2350181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3121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717718C-ADA6-41D1-B66A-614BFD5ACEE9}"/>
              </a:ext>
            </a:extLst>
          </p:cNvPr>
          <p:cNvSpPr txBox="1">
            <a:spLocks/>
          </p:cNvSpPr>
          <p:nvPr/>
        </p:nvSpPr>
        <p:spPr>
          <a:xfrm>
            <a:off x="847436" y="1063974"/>
            <a:ext cx="11023599" cy="998375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19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B87B7B73-EE22-4910-A47E-D9DE96BBA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3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83899FB-EBCD-4B03-92B5-F03CA18FE6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6472" y="2350141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3607D3A-971D-640A-F13E-8B0D6FF63C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399" y="2350141"/>
            <a:ext cx="3514096" cy="4392000"/>
          </a:xfrm>
          <a:prstGeom prst="rect">
            <a:avLst/>
          </a:prstGeom>
        </p:spPr>
      </p:pic>
      <p:pic>
        <p:nvPicPr>
          <p:cNvPr id="13" name="Picture 1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37BDC7D9-15DA-7E9B-94E3-B4DDEF9B8F3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324" y="2350141"/>
            <a:ext cx="3514098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869533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30C1B92-07D8-4073-A888-F89A491A587F}"/>
              </a:ext>
            </a:extLst>
          </p:cNvPr>
          <p:cNvSpPr txBox="1">
            <a:spLocks/>
          </p:cNvSpPr>
          <p:nvPr/>
        </p:nvSpPr>
        <p:spPr>
          <a:xfrm>
            <a:off x="847436" y="1063122"/>
            <a:ext cx="11023599" cy="12036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8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72201A4A-C084-455E-A74F-5C36E9AF2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4</a:t>
            </a:r>
          </a:p>
        </p:txBody>
      </p:sp>
      <p:pic>
        <p:nvPicPr>
          <p:cNvPr id="9" name="Picture 8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5C2598B-45AF-3C2A-D417-4A357413EA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791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C50CF2E4-E2DC-E1B1-8316-390F45B451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1" y="2347915"/>
            <a:ext cx="3514096" cy="4392000"/>
          </a:xfrm>
          <a:prstGeom prst="rect">
            <a:avLst/>
          </a:prstGeom>
        </p:spPr>
      </p:pic>
      <p:pic>
        <p:nvPicPr>
          <p:cNvPr id="15" name="Picture 1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6FF2302-1540-7DEC-9CB3-0E1A3A6F16D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652" y="234791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193483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81F84FA5-4009-476C-83EF-30BBFAA615D4}"/>
              </a:ext>
            </a:extLst>
          </p:cNvPr>
          <p:cNvSpPr txBox="1">
            <a:spLocks/>
          </p:cNvSpPr>
          <p:nvPr/>
        </p:nvSpPr>
        <p:spPr>
          <a:xfrm>
            <a:off x="847436" y="1063217"/>
            <a:ext cx="11023599" cy="11756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2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3F23A82A-F844-440D-8CAA-A37C5B911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5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8AB0D35-1670-28FF-6F36-68394AE676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3069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C4CC8DFE-8DF4-EC54-F7C5-3B7E973CFB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81" y="235307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AC541A9-7BA6-C956-5C88-0426242A6E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992" y="2353069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0099244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3619BEF4-CDE0-44C7-BEB3-F61D38CD2286}"/>
              </a:ext>
            </a:extLst>
          </p:cNvPr>
          <p:cNvSpPr txBox="1">
            <a:spLocks/>
          </p:cNvSpPr>
          <p:nvPr/>
        </p:nvSpPr>
        <p:spPr>
          <a:xfrm>
            <a:off x="847436" y="1062744"/>
            <a:ext cx="11023599" cy="109168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1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4F81F9BA-B04B-4BBA-A970-2D0652DC6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6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95713251-D3E7-C265-B630-BA54A9F4B0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8633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4D5CF86-7531-6EAB-0F29-DF190F2851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48383"/>
            <a:ext cx="3514096" cy="4392000"/>
          </a:xfrm>
          <a:prstGeom prst="rect">
            <a:avLst/>
          </a:prstGeom>
        </p:spPr>
      </p:pic>
      <p:pic>
        <p:nvPicPr>
          <p:cNvPr id="13" name="Picture 1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BCA7E36-685A-D9F7-2C20-A478C694D8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8" y="234863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75553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2490F92-4741-4B45-9D0B-B2FD910B793A}"/>
              </a:ext>
            </a:extLst>
          </p:cNvPr>
          <p:cNvSpPr txBox="1">
            <a:spLocks/>
          </p:cNvSpPr>
          <p:nvPr/>
        </p:nvSpPr>
        <p:spPr>
          <a:xfrm>
            <a:off x="847436" y="1062933"/>
            <a:ext cx="11023599" cy="1045028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3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4A0B5E63-7198-4415-B05E-2B0CEF2AC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7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A3AC009-0BB8-6EF1-F295-0B63895993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459" y="2347034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58C44D1C-2C8B-5073-F345-30D7C1515C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73" y="2347032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B11695D-949B-26D1-05FF-64DEBA9C73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966" y="234853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507912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BE2C3CA-D998-4693-893F-7AF02B152E7C}"/>
              </a:ext>
            </a:extLst>
          </p:cNvPr>
          <p:cNvSpPr txBox="1">
            <a:spLocks/>
          </p:cNvSpPr>
          <p:nvPr/>
        </p:nvSpPr>
        <p:spPr>
          <a:xfrm>
            <a:off x="847436" y="1062744"/>
            <a:ext cx="11023599" cy="111967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0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DC2FDBE1-549E-4C15-B6A6-5588CBC91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8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1DA001C-354F-1D3E-69F0-9ACA5C1862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9858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F2DD855-5BF3-7AC1-B7A2-869961F85B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246" y="2349859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EFC7E3C-56D5-79ED-EAC9-A655782F8B1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474" y="234985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78470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B5BE085-694D-40D2-8783-30083CDD095A}"/>
              </a:ext>
            </a:extLst>
          </p:cNvPr>
          <p:cNvSpPr txBox="1">
            <a:spLocks/>
          </p:cNvSpPr>
          <p:nvPr/>
        </p:nvSpPr>
        <p:spPr>
          <a:xfrm>
            <a:off x="847436" y="1062934"/>
            <a:ext cx="11023599" cy="989044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0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6BFB5BDA-E08F-4CB8-8730-E5B00893F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19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C5C9FB0-4B17-52E6-7081-3EAEF13CA8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865" y="2354795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00BDF3AE-9387-8ACC-463F-A4906D5C66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421" y="235479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D70947F-A684-99FE-F74A-EDE9EB8AEA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52" y="235479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224386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8E35EAFF-1F7A-40BD-9AE3-064739B11890}"/>
              </a:ext>
            </a:extLst>
          </p:cNvPr>
          <p:cNvSpPr txBox="1">
            <a:spLocks/>
          </p:cNvSpPr>
          <p:nvPr/>
        </p:nvSpPr>
        <p:spPr>
          <a:xfrm>
            <a:off x="847436" y="1062935"/>
            <a:ext cx="11023599" cy="108235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6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E2378D7F-A470-4CB2-A3EC-57B850E3B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0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33F1B87-2741-52E3-8D43-F83561C3E5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388" y="2348913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5CD3EBDB-2A4B-412B-46E6-7131AC1678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852" y="234891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671CF16-8C15-3B03-3464-460B935FA0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0620" y="2348483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853529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C913E983-3A5B-4588-9231-7C0D46B5454C}"/>
              </a:ext>
            </a:extLst>
          </p:cNvPr>
          <p:cNvSpPr txBox="1">
            <a:spLocks/>
          </p:cNvSpPr>
          <p:nvPr/>
        </p:nvSpPr>
        <p:spPr>
          <a:xfrm>
            <a:off x="847436" y="1065084"/>
            <a:ext cx="11023599" cy="108197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6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5413F4E4-BAE6-4EED-81EB-36CF44E09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1</a:t>
            </a:r>
          </a:p>
        </p:txBody>
      </p:sp>
      <p:pic>
        <p:nvPicPr>
          <p:cNvPr id="15" name="Picture 1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B5CEFBC-38D2-CCDC-A433-E308FBDCC0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1" y="2352836"/>
            <a:ext cx="3514096" cy="4392000"/>
          </a:xfrm>
          <a:prstGeom prst="rect">
            <a:avLst/>
          </a:prstGeom>
        </p:spPr>
      </p:pic>
      <p:pic>
        <p:nvPicPr>
          <p:cNvPr id="17" name="Picture 16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B059A20C-5A1F-13B8-600F-6D1C15FA03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396" y="2352836"/>
            <a:ext cx="3514096" cy="4392000"/>
          </a:xfrm>
          <a:prstGeom prst="rect">
            <a:avLst/>
          </a:prstGeom>
        </p:spPr>
      </p:pic>
      <p:pic>
        <p:nvPicPr>
          <p:cNvPr id="5" name="Picture 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47D7C18-F1AC-7666-4B4B-91FCE7C9E4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513" y="2352836"/>
            <a:ext cx="3514096" cy="4392000"/>
          </a:xfrm>
          <a:prstGeom prst="rect">
            <a:avLst/>
          </a:prstGeom>
        </p:spPr>
      </p:pic>
      <p:pic>
        <p:nvPicPr>
          <p:cNvPr id="8" name="Picture 7" descr="Chart&#10;&#10;Description automatically generated with medium confidence">
            <a:extLst>
              <a:ext uri="{FF2B5EF4-FFF2-40B4-BE49-F238E27FC236}">
                <a16:creationId xmlns:a16="http://schemas.microsoft.com/office/drawing/2014/main" id="{D9084593-8D7C-CE3B-C614-085B0F1C347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8803" y="55371"/>
            <a:ext cx="3377385" cy="225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946141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47946B4A-CC15-4624-A58A-3DCA03F0E43A}"/>
              </a:ext>
            </a:extLst>
          </p:cNvPr>
          <p:cNvSpPr txBox="1">
            <a:spLocks/>
          </p:cNvSpPr>
          <p:nvPr/>
        </p:nvSpPr>
        <p:spPr>
          <a:xfrm>
            <a:off x="849060" y="1063113"/>
            <a:ext cx="11023599" cy="1010193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1 cross over</a:t>
            </a:r>
          </a:p>
          <a:p>
            <a:endParaRPr lang="en-GB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9EA6E244-A1EB-4417-838F-9E6B9B4D4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2</a:t>
            </a:r>
          </a:p>
        </p:txBody>
      </p:sp>
      <p:pic>
        <p:nvPicPr>
          <p:cNvPr id="9" name="Picture 8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A3D9B4F-C3E5-F0E7-1B7E-414C7251E7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9946" y="2345466"/>
            <a:ext cx="3514096" cy="4392000"/>
          </a:xfrm>
          <a:prstGeom prst="rect">
            <a:avLst/>
          </a:prstGeom>
        </p:spPr>
      </p:pic>
      <p:pic>
        <p:nvPicPr>
          <p:cNvPr id="13" name="Picture 1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EB562AB5-D748-6DD0-D72D-0563BAACF3D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70" y="2345464"/>
            <a:ext cx="3514096" cy="4392000"/>
          </a:xfrm>
          <a:prstGeom prst="rect">
            <a:avLst/>
          </a:prstGeom>
        </p:spPr>
      </p:pic>
      <p:pic>
        <p:nvPicPr>
          <p:cNvPr id="15" name="Picture 1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65F64EF-AEF7-D3DE-6BC0-45D4D831A8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52" y="2349888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980089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8CE0BCD6-3484-4113-9CA4-F18477475A33}"/>
              </a:ext>
            </a:extLst>
          </p:cNvPr>
          <p:cNvSpPr txBox="1">
            <a:spLocks/>
          </p:cNvSpPr>
          <p:nvPr/>
        </p:nvSpPr>
        <p:spPr>
          <a:xfrm>
            <a:off x="847436" y="1059011"/>
            <a:ext cx="11023599" cy="11843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4E158652-29E0-41B7-B129-551B04344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3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5C6AB75-25DE-FB1A-5BFC-AD2A780C52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50722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C32823F1-0899-52BE-E99D-4B50548CC14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11" y="235190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A956D70-BD22-3483-5E46-E017BDE25EC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707" y="2350722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6639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05C5AF2-E057-4892-AB31-3103FF06E14D}"/>
              </a:ext>
            </a:extLst>
          </p:cNvPr>
          <p:cNvSpPr txBox="1">
            <a:spLocks/>
          </p:cNvSpPr>
          <p:nvPr/>
        </p:nvSpPr>
        <p:spPr>
          <a:xfrm>
            <a:off x="847436" y="1063879"/>
            <a:ext cx="11227317" cy="1045029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2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AA743670-2322-45AB-BB47-5EB7A72AF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4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75C0ED7-A61E-E56F-854D-15A54DE1AA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613" y="2350425"/>
            <a:ext cx="3514096" cy="4392000"/>
          </a:xfrm>
          <a:prstGeom prst="rect">
            <a:avLst/>
          </a:prstGeom>
        </p:spPr>
      </p:pic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2E48AA15-FB91-578D-EB49-45D1C456BC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248" y="2354523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937D33C-1BC2-87E1-41DB-DE01D9EB27D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1430" y="235042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0225767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42617D10-8537-4EF9-BFCF-A18BA6062DC6}"/>
              </a:ext>
            </a:extLst>
          </p:cNvPr>
          <p:cNvSpPr txBox="1">
            <a:spLocks/>
          </p:cNvSpPr>
          <p:nvPr/>
        </p:nvSpPr>
        <p:spPr>
          <a:xfrm>
            <a:off x="847436" y="1059011"/>
            <a:ext cx="11023599" cy="107115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W230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4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30069A99-8706-49DA-A8AB-DF607FC68D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4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17553FA-69BF-D68B-BD8D-545F0DD14E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8995"/>
            <a:ext cx="3514096" cy="4392000"/>
          </a:xfrm>
          <a:prstGeom prst="rect">
            <a:avLst/>
          </a:prstGeom>
        </p:spPr>
      </p:pic>
      <p:pic>
        <p:nvPicPr>
          <p:cNvPr id="11" name="Picture 10" descr="Table&#10;&#10;Description automatically generated with low confidence">
            <a:extLst>
              <a:ext uri="{FF2B5EF4-FFF2-40B4-BE49-F238E27FC236}">
                <a16:creationId xmlns:a16="http://schemas.microsoft.com/office/drawing/2014/main" id="{7FE8B90D-38C2-7040-E73E-2C32834DE2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48999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EB6A0CA-77B2-CDC0-C7D1-C2A2B435177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48344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21395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194F0-059E-443D-9ACD-0EBF46A62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W230_EMS_M3_25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15FE1ED8-5A33-4EC1-96FA-F708FF405EA0}"/>
              </a:ext>
            </a:extLst>
          </p:cNvPr>
          <p:cNvSpPr txBox="1">
            <a:spLocks/>
          </p:cNvSpPr>
          <p:nvPr/>
        </p:nvSpPr>
        <p:spPr>
          <a:xfrm>
            <a:off x="847436" y="1059540"/>
            <a:ext cx="11023599" cy="102489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W230 M3</a:t>
            </a:r>
          </a:p>
          <a:p>
            <a:r>
              <a:rPr lang="en-GB" dirty="0"/>
              <a:t>4x coverage</a:t>
            </a:r>
          </a:p>
          <a:p>
            <a:r>
              <a:rPr lang="en-GB" dirty="0"/>
              <a:t>10 cross over</a:t>
            </a:r>
          </a:p>
          <a:p>
            <a:endParaRPr lang="en-GB" dirty="0"/>
          </a:p>
        </p:txBody>
      </p:sp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3F6E4D5-78B4-8431-696A-586045994E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716" y="2346002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360566B-F9C1-5CD1-270D-59B76816AE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237" y="2349324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C0B6DAFF-81C8-D5FE-D38D-1B996772D22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758" y="2348861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56889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20FC7E7-BB26-418C-84D0-E1E4F725C995}"/>
              </a:ext>
            </a:extLst>
          </p:cNvPr>
          <p:cNvSpPr txBox="1">
            <a:spLocks/>
          </p:cNvSpPr>
          <p:nvPr/>
        </p:nvSpPr>
        <p:spPr>
          <a:xfrm>
            <a:off x="847436" y="1063690"/>
            <a:ext cx="11023599" cy="108235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5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7E53E133-1C5B-4A01-A10E-28C17B808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5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0E2FF2D-D485-569D-B0BE-701128A5FA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03" y="2349236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20E4815-1BE5-832D-9AAD-585F8D7A86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3570" y="2350425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A3CC3509-C4EC-D37F-0496-F6264F3B9F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49243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34314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830B0E41-FD67-4C9B-9ACB-95DDFD5DDF74}"/>
              </a:ext>
            </a:extLst>
          </p:cNvPr>
          <p:cNvSpPr txBox="1">
            <a:spLocks/>
          </p:cNvSpPr>
          <p:nvPr/>
        </p:nvSpPr>
        <p:spPr>
          <a:xfrm>
            <a:off x="847436" y="1063028"/>
            <a:ext cx="11023599" cy="110249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9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F0F786A3-DA6E-475D-8F99-12073F0A9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6</a:t>
            </a:r>
          </a:p>
        </p:txBody>
      </p:sp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3A6F7AD-3910-38F8-7274-61F2142702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52" y="2350251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074BE98A-079A-CDF2-A3E5-000BADE92D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7" y="2350251"/>
            <a:ext cx="3514096" cy="4392000"/>
          </a:xfrm>
          <a:prstGeom prst="rect">
            <a:avLst/>
          </a:prstGeom>
        </p:spPr>
      </p:pic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54F9BB4-B31E-2AEB-588F-B7465E4C88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0852" y="2350251"/>
            <a:ext cx="3514096" cy="439200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D7B39163-E19E-88DE-9B0A-37A3B676DD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1342" y="52626"/>
            <a:ext cx="3377383" cy="225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06638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D51C715-249D-4DBC-91A3-68ED7BC4969A}"/>
              </a:ext>
            </a:extLst>
          </p:cNvPr>
          <p:cNvSpPr txBox="1">
            <a:spLocks/>
          </p:cNvSpPr>
          <p:nvPr/>
        </p:nvSpPr>
        <p:spPr>
          <a:xfrm>
            <a:off x="847725" y="1064662"/>
            <a:ext cx="11023599" cy="998375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Bowman M3</a:t>
            </a:r>
          </a:p>
          <a:p>
            <a:r>
              <a:rPr lang="en-GB" dirty="0"/>
              <a:t>2x coverage</a:t>
            </a:r>
          </a:p>
          <a:p>
            <a:r>
              <a:rPr lang="en-GB" dirty="0"/>
              <a:t>22 cross over</a:t>
            </a:r>
          </a:p>
          <a:p>
            <a:endParaRPr lang="en-GB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B4A066CC-ADFA-477C-A16B-D4A40A0E3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7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B0B89AD-C9C8-E23B-0FA4-755E2461A3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325" y="2353796"/>
            <a:ext cx="3514096" cy="4392000"/>
          </a:xfrm>
          <a:prstGeom prst="rect">
            <a:avLst/>
          </a:prstGeom>
        </p:spPr>
      </p:pic>
      <p:pic>
        <p:nvPicPr>
          <p:cNvPr id="11" name="Picture 1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A30E51E-F78B-A884-E3A1-EBA9EAC34A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1770" y="2345930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DBD1D215-1CFC-B861-3CCC-0B4491C917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16" y="2353796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45420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D74AA698-6A4D-4193-BAFB-9C7736439DE1}"/>
              </a:ext>
            </a:extLst>
          </p:cNvPr>
          <p:cNvSpPr txBox="1">
            <a:spLocks/>
          </p:cNvSpPr>
          <p:nvPr/>
        </p:nvSpPr>
        <p:spPr>
          <a:xfrm>
            <a:off x="847436" y="1063218"/>
            <a:ext cx="11023599" cy="104808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70000"/>
              </a:lnSpc>
            </a:pPr>
            <a:r>
              <a:rPr lang="en-GB" sz="2000" dirty="0"/>
              <a:t>Bowman M3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2x coverage</a:t>
            </a:r>
          </a:p>
          <a:p>
            <a:pPr>
              <a:lnSpc>
                <a:spcPct val="70000"/>
              </a:lnSpc>
            </a:pPr>
            <a:r>
              <a:rPr lang="en-GB" sz="2000" dirty="0"/>
              <a:t>15 cross over</a:t>
            </a:r>
          </a:p>
          <a:p>
            <a:pPr>
              <a:lnSpc>
                <a:spcPct val="70000"/>
              </a:lnSpc>
            </a:pPr>
            <a:endParaRPr lang="en-GB" sz="20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7032BDE9-425B-4307-BA1C-ADC85EFE9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889"/>
          </a:xfrm>
        </p:spPr>
        <p:txBody>
          <a:bodyPr>
            <a:normAutofit fontScale="90000"/>
          </a:bodyPr>
          <a:lstStyle/>
          <a:p>
            <a:r>
              <a:rPr lang="en-GB" dirty="0"/>
              <a:t>Bowman_EMS_M3_8</a:t>
            </a: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FADCA1D8-6D90-9ACC-85FF-13613F1285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975" y="2351439"/>
            <a:ext cx="3514096" cy="4392000"/>
          </a:xfrm>
          <a:prstGeom prst="rect">
            <a:avLst/>
          </a:prstGeom>
        </p:spPr>
      </p:pic>
      <p:pic>
        <p:nvPicPr>
          <p:cNvPr id="11" name="Picture 10" descr="Table&#10;&#10;Description automatically generated">
            <a:extLst>
              <a:ext uri="{FF2B5EF4-FFF2-40B4-BE49-F238E27FC236}">
                <a16:creationId xmlns:a16="http://schemas.microsoft.com/office/drawing/2014/main" id="{3B24A02C-9EE4-6EE9-77F3-D20484AE5F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93" y="2351439"/>
            <a:ext cx="3514096" cy="4392000"/>
          </a:xfrm>
          <a:prstGeom prst="rect">
            <a:avLst/>
          </a:prstGeom>
        </p:spPr>
      </p:pic>
      <p:pic>
        <p:nvPicPr>
          <p:cNvPr id="13" name="Picture 1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6D393FDE-70AD-DD94-2CED-C057FB9E89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334" y="2352155"/>
            <a:ext cx="3514096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8169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9</TotalTime>
  <Words>665</Words>
  <Application>Microsoft Office PowerPoint</Application>
  <PresentationFormat>Widescreen</PresentationFormat>
  <Paragraphs>201</Paragraphs>
  <Slides>5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1</vt:i4>
      </vt:variant>
    </vt:vector>
  </HeadingPairs>
  <TitlesOfParts>
    <vt:vector size="55" baseType="lpstr">
      <vt:lpstr>Arial</vt:lpstr>
      <vt:lpstr>Calibri</vt:lpstr>
      <vt:lpstr>Calibri Light</vt:lpstr>
      <vt:lpstr>Office Theme</vt:lpstr>
      <vt:lpstr>Supplemental Material 1:  Plotted variant calling for all 50 individuals. The first plot shows the raw counts results. The second plot displays the results after adjusting with the sliding window approach (see Figure 3 in main manuscript). The third plot highlights the counted CO positions in red). For certain regions a close-up example are shown.</vt:lpstr>
      <vt:lpstr>PowerPoint Presentation</vt:lpstr>
      <vt:lpstr>Bowman_EMS_M3_2</vt:lpstr>
      <vt:lpstr>Bowman_EMS_M3_3</vt:lpstr>
      <vt:lpstr>Bowman_EMS_M3_4</vt:lpstr>
      <vt:lpstr>Bowman_EMS_M3_5</vt:lpstr>
      <vt:lpstr>Bowman_EMS_M3_6</vt:lpstr>
      <vt:lpstr>Bowman_EMS_M3_7</vt:lpstr>
      <vt:lpstr>Bowman_EMS_M3_8</vt:lpstr>
      <vt:lpstr>Bowman_EMS_M3_9</vt:lpstr>
      <vt:lpstr>Bowman_EMS_M3_10</vt:lpstr>
      <vt:lpstr>Bowman_EMS_M3_11</vt:lpstr>
      <vt:lpstr>Bowman_EMS_M3_12</vt:lpstr>
      <vt:lpstr>Bowman_EMS_M3_13</vt:lpstr>
      <vt:lpstr>Bowman_EMS_M3_14</vt:lpstr>
      <vt:lpstr>Bowman_EMS_M3_15</vt:lpstr>
      <vt:lpstr>Bowman_EMS_M3_16</vt:lpstr>
      <vt:lpstr>Bowman_EMS_M3_17</vt:lpstr>
      <vt:lpstr>Bowman_EMS_M3_18</vt:lpstr>
      <vt:lpstr>Bowman_EMS_M3_19</vt:lpstr>
      <vt:lpstr>Bowman_EMS_M3_20</vt:lpstr>
      <vt:lpstr>Bowman_EMS_M3_21</vt:lpstr>
      <vt:lpstr>Bowman_EMS_M3_22</vt:lpstr>
      <vt:lpstr>Bowman_EMS_M3_23</vt:lpstr>
      <vt:lpstr>Bowman_EMS_M3_24</vt:lpstr>
      <vt:lpstr>Bowman_EMS_M3_25</vt:lpstr>
      <vt:lpstr>BW230_EMS_M3_1</vt:lpstr>
      <vt:lpstr>BW230_EMS_M3_2</vt:lpstr>
      <vt:lpstr>BW230_EMS_M3_3</vt:lpstr>
      <vt:lpstr>BW230_EMS_M3_4</vt:lpstr>
      <vt:lpstr>BW230_EMS_M3_5</vt:lpstr>
      <vt:lpstr>BW230_EMS_M3_6</vt:lpstr>
      <vt:lpstr>BW230_EMS_M3_7</vt:lpstr>
      <vt:lpstr>BW230_EMS_M3_8</vt:lpstr>
      <vt:lpstr>BW230_EMS_M3_9</vt:lpstr>
      <vt:lpstr>BW230_EMS_M3_10</vt:lpstr>
      <vt:lpstr>BW230_EMS_M3_11</vt:lpstr>
      <vt:lpstr>BW230_EMS_M3_12</vt:lpstr>
      <vt:lpstr>BW230_EMS_M3_13</vt:lpstr>
      <vt:lpstr>BW230_EMS_M3_14</vt:lpstr>
      <vt:lpstr>BW230_EMS_M3_15</vt:lpstr>
      <vt:lpstr>BW230_EMS_M3_16</vt:lpstr>
      <vt:lpstr>BW230_EMS_M3_17</vt:lpstr>
      <vt:lpstr>BW230_EMS_M3_18</vt:lpstr>
      <vt:lpstr>BW230_EMS_M3_19</vt:lpstr>
      <vt:lpstr>BW230_EMS_M3_20</vt:lpstr>
      <vt:lpstr>BW230_EMS_M3_21</vt:lpstr>
      <vt:lpstr>BW230_EMS_M3_22</vt:lpstr>
      <vt:lpstr>BW230_EMS_M3_23</vt:lpstr>
      <vt:lpstr>BW230_EMS_M3_24</vt:lpstr>
      <vt:lpstr>BW230_EMS_M3_25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iam Schreiber</dc:creator>
  <cp:lastModifiedBy>Miriam Schreiber</cp:lastModifiedBy>
  <cp:revision>23</cp:revision>
  <dcterms:created xsi:type="dcterms:W3CDTF">2022-04-29T12:34:05Z</dcterms:created>
  <dcterms:modified xsi:type="dcterms:W3CDTF">2022-07-27T10:33:08Z</dcterms:modified>
</cp:coreProperties>
</file>